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6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F2C50D-C49D-4BEA-A599-4BA810DF5E88}" v="1" dt="2023-08-10T13:21:05.06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>
      <p:cViewPr varScale="1">
        <p:scale>
          <a:sx n="86" d="100"/>
          <a:sy n="86" d="100"/>
        </p:scale>
        <p:origin x="24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nghe Meng" userId="8ec5781b-3938-43df-a84f-730d81e9a524" providerId="ADAL" clId="{28B8E620-2A74-45DD-9AF1-E710F37014A6}"/>
    <pc:docChg chg="undo redo custSel addSld delSld modSld">
      <pc:chgData name="Qinghe Meng" userId="8ec5781b-3938-43df-a84f-730d81e9a524" providerId="ADAL" clId="{28B8E620-2A74-45DD-9AF1-E710F37014A6}" dt="2023-03-17T18:58:53.479" v="1089" actId="1076"/>
      <pc:docMkLst>
        <pc:docMk/>
      </pc:docMkLst>
      <pc:sldChg chg="addSp delSp modSp mod">
        <pc:chgData name="Qinghe Meng" userId="8ec5781b-3938-43df-a84f-730d81e9a524" providerId="ADAL" clId="{28B8E620-2A74-45DD-9AF1-E710F37014A6}" dt="2023-03-17T18:40:09.842" v="1019" actId="478"/>
        <pc:sldMkLst>
          <pc:docMk/>
          <pc:sldMk cId="1416481732" sldId="256"/>
        </pc:sldMkLst>
        <pc:spChg chg="add mod">
          <ac:chgData name="Qinghe Meng" userId="8ec5781b-3938-43df-a84f-730d81e9a524" providerId="ADAL" clId="{28B8E620-2A74-45DD-9AF1-E710F37014A6}" dt="2023-03-07T21:50:38.785" v="555" actId="6549"/>
          <ac:spMkLst>
            <pc:docMk/>
            <pc:sldMk cId="1416481732" sldId="256"/>
            <ac:spMk id="6" creationId="{5F43ACBE-7784-620B-7DE9-28F3500AA41B}"/>
          </ac:spMkLst>
        </pc:spChg>
        <pc:spChg chg="add mod">
          <ac:chgData name="Qinghe Meng" userId="8ec5781b-3938-43df-a84f-730d81e9a524" providerId="ADAL" clId="{28B8E620-2A74-45DD-9AF1-E710F37014A6}" dt="2023-03-07T21:16:23.566" v="87" actId="1076"/>
          <ac:spMkLst>
            <pc:docMk/>
            <pc:sldMk cId="1416481732" sldId="256"/>
            <ac:spMk id="7" creationId="{AEC2A375-824A-82AA-A2B5-93C1259A1AA2}"/>
          </ac:spMkLst>
        </pc:spChg>
        <pc:spChg chg="add mod">
          <ac:chgData name="Qinghe Meng" userId="8ec5781b-3938-43df-a84f-730d81e9a524" providerId="ADAL" clId="{28B8E620-2A74-45DD-9AF1-E710F37014A6}" dt="2023-03-07T21:14:47.747" v="71" actId="1076"/>
          <ac:spMkLst>
            <pc:docMk/>
            <pc:sldMk cId="1416481732" sldId="256"/>
            <ac:spMk id="8" creationId="{56C7C46D-26B3-8966-23B4-73F80ABBF7EE}"/>
          </ac:spMkLst>
        </pc:spChg>
        <pc:spChg chg="add mod">
          <ac:chgData name="Qinghe Meng" userId="8ec5781b-3938-43df-a84f-730d81e9a524" providerId="ADAL" clId="{28B8E620-2A74-45DD-9AF1-E710F37014A6}" dt="2023-03-07T21:17:30.932" v="103" actId="6549"/>
          <ac:spMkLst>
            <pc:docMk/>
            <pc:sldMk cId="1416481732" sldId="256"/>
            <ac:spMk id="9" creationId="{575D03C4-8917-71CF-8B44-80EA7D788907}"/>
          </ac:spMkLst>
        </pc:spChg>
        <pc:spChg chg="add mod">
          <ac:chgData name="Qinghe Meng" userId="8ec5781b-3938-43df-a84f-730d81e9a524" providerId="ADAL" clId="{28B8E620-2A74-45DD-9AF1-E710F37014A6}" dt="2023-03-07T21:17:39.008" v="104" actId="1076"/>
          <ac:spMkLst>
            <pc:docMk/>
            <pc:sldMk cId="1416481732" sldId="256"/>
            <ac:spMk id="10" creationId="{7B5338E7-FFA2-7C90-12F2-82E06A82E6FB}"/>
          </ac:spMkLst>
        </pc:spChg>
        <pc:spChg chg="add mod">
          <ac:chgData name="Qinghe Meng" userId="8ec5781b-3938-43df-a84f-730d81e9a524" providerId="ADAL" clId="{28B8E620-2A74-45DD-9AF1-E710F37014A6}" dt="2023-03-07T21:17:50.198" v="108" actId="1076"/>
          <ac:spMkLst>
            <pc:docMk/>
            <pc:sldMk cId="1416481732" sldId="256"/>
            <ac:spMk id="11" creationId="{D921206A-231E-0020-D196-92FEE916AAE8}"/>
          </ac:spMkLst>
        </pc:spChg>
        <pc:spChg chg="add mod">
          <ac:chgData name="Qinghe Meng" userId="8ec5781b-3938-43df-a84f-730d81e9a524" providerId="ADAL" clId="{28B8E620-2A74-45DD-9AF1-E710F37014A6}" dt="2023-03-07T21:18:29.187" v="115" actId="20577"/>
          <ac:spMkLst>
            <pc:docMk/>
            <pc:sldMk cId="1416481732" sldId="256"/>
            <ac:spMk id="12" creationId="{679078DA-C4F6-5441-4EE1-B814696B77EC}"/>
          </ac:spMkLst>
        </pc:spChg>
        <pc:spChg chg="add mod">
          <ac:chgData name="Qinghe Meng" userId="8ec5781b-3938-43df-a84f-730d81e9a524" providerId="ADAL" clId="{28B8E620-2A74-45DD-9AF1-E710F37014A6}" dt="2023-03-07T21:21:08.400" v="182" actId="1076"/>
          <ac:spMkLst>
            <pc:docMk/>
            <pc:sldMk cId="1416481732" sldId="256"/>
            <ac:spMk id="16" creationId="{C261C758-AAB1-EF69-A00E-56FF272F3C57}"/>
          </ac:spMkLst>
        </pc:spChg>
        <pc:spChg chg="add mod">
          <ac:chgData name="Qinghe Meng" userId="8ec5781b-3938-43df-a84f-730d81e9a524" providerId="ADAL" clId="{28B8E620-2A74-45DD-9AF1-E710F37014A6}" dt="2023-03-07T21:21:03.395" v="181" actId="1076"/>
          <ac:spMkLst>
            <pc:docMk/>
            <pc:sldMk cId="1416481732" sldId="256"/>
            <ac:spMk id="17" creationId="{5D795073-D149-A961-A859-74CE8F1E8897}"/>
          </ac:spMkLst>
        </pc:spChg>
        <pc:spChg chg="add del mod">
          <ac:chgData name="Qinghe Meng" userId="8ec5781b-3938-43df-a84f-730d81e9a524" providerId="ADAL" clId="{28B8E620-2A74-45DD-9AF1-E710F37014A6}" dt="2023-03-17T18:40:08.242" v="1018" actId="478"/>
          <ac:spMkLst>
            <pc:docMk/>
            <pc:sldMk cId="1416481732" sldId="256"/>
            <ac:spMk id="20" creationId="{BB95646B-F7F1-1FB2-AE4C-B7F636A1EC85}"/>
          </ac:spMkLst>
        </pc:spChg>
        <pc:spChg chg="add del mod">
          <ac:chgData name="Qinghe Meng" userId="8ec5781b-3938-43df-a84f-730d81e9a524" providerId="ADAL" clId="{28B8E620-2A74-45DD-9AF1-E710F37014A6}" dt="2023-03-17T18:40:05.362" v="1015" actId="478"/>
          <ac:spMkLst>
            <pc:docMk/>
            <pc:sldMk cId="1416481732" sldId="256"/>
            <ac:spMk id="21" creationId="{1F358F03-70D5-E781-849B-2CE930AC8D08}"/>
          </ac:spMkLst>
        </pc:spChg>
        <pc:spChg chg="add mod">
          <ac:chgData name="Qinghe Meng" userId="8ec5781b-3938-43df-a84f-730d81e9a524" providerId="ADAL" clId="{28B8E620-2A74-45DD-9AF1-E710F37014A6}" dt="2023-03-07T21:24:25.826" v="217" actId="121"/>
          <ac:spMkLst>
            <pc:docMk/>
            <pc:sldMk cId="1416481732" sldId="256"/>
            <ac:spMk id="25" creationId="{829434CD-0AE8-3366-307C-AFBDF1DE142E}"/>
          </ac:spMkLst>
        </pc:spChg>
        <pc:spChg chg="add mod">
          <ac:chgData name="Qinghe Meng" userId="8ec5781b-3938-43df-a84f-730d81e9a524" providerId="ADAL" clId="{28B8E620-2A74-45DD-9AF1-E710F37014A6}" dt="2023-03-17T18:39:13.604" v="999" actId="1076"/>
          <ac:spMkLst>
            <pc:docMk/>
            <pc:sldMk cId="1416481732" sldId="256"/>
            <ac:spMk id="26" creationId="{18FE7233-27CA-C363-B032-A7A08378566D}"/>
          </ac:spMkLst>
        </pc:spChg>
        <pc:spChg chg="add mod">
          <ac:chgData name="Qinghe Meng" userId="8ec5781b-3938-43df-a84f-730d81e9a524" providerId="ADAL" clId="{28B8E620-2A74-45DD-9AF1-E710F37014A6}" dt="2023-03-07T21:40:54.581" v="442" actId="1076"/>
          <ac:spMkLst>
            <pc:docMk/>
            <pc:sldMk cId="1416481732" sldId="256"/>
            <ac:spMk id="28" creationId="{6AB42F7E-5822-5CDB-934F-95E06CB22D28}"/>
          </ac:spMkLst>
        </pc:spChg>
        <pc:spChg chg="add mod">
          <ac:chgData name="Qinghe Meng" userId="8ec5781b-3938-43df-a84f-730d81e9a524" providerId="ADAL" clId="{28B8E620-2A74-45DD-9AF1-E710F37014A6}" dt="2023-03-17T18:39:54.418" v="1012" actId="1076"/>
          <ac:spMkLst>
            <pc:docMk/>
            <pc:sldMk cId="1416481732" sldId="256"/>
            <ac:spMk id="31" creationId="{F5C4E1DF-0D94-BBD4-D931-B5E010483901}"/>
          </ac:spMkLst>
        </pc:spChg>
        <pc:spChg chg="add mod">
          <ac:chgData name="Qinghe Meng" userId="8ec5781b-3938-43df-a84f-730d81e9a524" providerId="ADAL" clId="{28B8E620-2A74-45DD-9AF1-E710F37014A6}" dt="2023-03-17T18:40:03.286" v="1014" actId="1076"/>
          <ac:spMkLst>
            <pc:docMk/>
            <pc:sldMk cId="1416481732" sldId="256"/>
            <ac:spMk id="32" creationId="{76D2B03B-B09F-2E64-0C4D-EA3EBEAD5E27}"/>
          </ac:spMkLst>
        </pc:spChg>
        <pc:picChg chg="add del mod">
          <ac:chgData name="Qinghe Meng" userId="8ec5781b-3938-43df-a84f-730d81e9a524" providerId="ADAL" clId="{28B8E620-2A74-45DD-9AF1-E710F37014A6}" dt="2023-03-17T18:38:16.870" v="988" actId="478"/>
          <ac:picMkLst>
            <pc:docMk/>
            <pc:sldMk cId="1416481732" sldId="256"/>
            <ac:picMk id="3" creationId="{499AB86A-9DA5-1274-1477-4F351861FBD7}"/>
          </ac:picMkLst>
        </pc:picChg>
        <pc:picChg chg="add mod">
          <ac:chgData name="Qinghe Meng" userId="8ec5781b-3938-43df-a84f-730d81e9a524" providerId="ADAL" clId="{28B8E620-2A74-45DD-9AF1-E710F37014A6}" dt="2023-03-17T18:39:02.390" v="997" actId="1076"/>
          <ac:picMkLst>
            <pc:docMk/>
            <pc:sldMk cId="1416481732" sldId="256"/>
            <ac:picMk id="4" creationId="{9D092A4F-57C3-5FFE-C05E-2E71691DC42E}"/>
          </ac:picMkLst>
        </pc:picChg>
        <pc:picChg chg="add mod">
          <ac:chgData name="Qinghe Meng" userId="8ec5781b-3938-43df-a84f-730d81e9a524" providerId="ADAL" clId="{28B8E620-2A74-45DD-9AF1-E710F37014A6}" dt="2023-03-07T21:18:01.506" v="111" actId="1076"/>
          <ac:picMkLst>
            <pc:docMk/>
            <pc:sldMk cId="1416481732" sldId="256"/>
            <ac:picMk id="5" creationId="{D82EFDB1-9CFD-85D8-4F2D-A78971F310C4}"/>
          </ac:picMkLst>
        </pc:picChg>
        <pc:cxnChg chg="add mod">
          <ac:chgData name="Qinghe Meng" userId="8ec5781b-3938-43df-a84f-730d81e9a524" providerId="ADAL" clId="{28B8E620-2A74-45DD-9AF1-E710F37014A6}" dt="2023-03-17T18:39:39.177" v="1008" actId="1076"/>
          <ac:cxnSpMkLst>
            <pc:docMk/>
            <pc:sldMk cId="1416481732" sldId="256"/>
            <ac:cxnSpMk id="13" creationId="{5D8F648D-FE8D-6396-DB7A-EC383330835D}"/>
          </ac:cxnSpMkLst>
        </pc:cxnChg>
        <pc:cxnChg chg="add">
          <ac:chgData name="Qinghe Meng" userId="8ec5781b-3938-43df-a84f-730d81e9a524" providerId="ADAL" clId="{28B8E620-2A74-45DD-9AF1-E710F37014A6}" dt="2023-03-07T21:20:11.244" v="153" actId="11529"/>
          <ac:cxnSpMkLst>
            <pc:docMk/>
            <pc:sldMk cId="1416481732" sldId="256"/>
            <ac:cxnSpMk id="14" creationId="{74A49646-5AEB-3C94-B330-49C665D9EAC5}"/>
          </ac:cxnSpMkLst>
        </pc:cxnChg>
        <pc:cxnChg chg="add mod">
          <ac:chgData name="Qinghe Meng" userId="8ec5781b-3938-43df-a84f-730d81e9a524" providerId="ADAL" clId="{28B8E620-2A74-45DD-9AF1-E710F37014A6}" dt="2023-03-07T21:20:22.497" v="155" actId="1076"/>
          <ac:cxnSpMkLst>
            <pc:docMk/>
            <pc:sldMk cId="1416481732" sldId="256"/>
            <ac:cxnSpMk id="15" creationId="{EFE61159-CFC4-C829-6024-68A8ACFD011A}"/>
          </ac:cxnSpMkLst>
        </pc:cxnChg>
        <pc:cxnChg chg="add del mod">
          <ac:chgData name="Qinghe Meng" userId="8ec5781b-3938-43df-a84f-730d81e9a524" providerId="ADAL" clId="{28B8E620-2A74-45DD-9AF1-E710F37014A6}" dt="2023-03-17T18:40:09.842" v="1019" actId="478"/>
          <ac:cxnSpMkLst>
            <pc:docMk/>
            <pc:sldMk cId="1416481732" sldId="256"/>
            <ac:cxnSpMk id="18" creationId="{AE370231-9172-B84A-CE25-1EE5B9B79F2A}"/>
          </ac:cxnSpMkLst>
        </pc:cxnChg>
        <pc:cxnChg chg="add del mod">
          <ac:chgData name="Qinghe Meng" userId="8ec5781b-3938-43df-a84f-730d81e9a524" providerId="ADAL" clId="{28B8E620-2A74-45DD-9AF1-E710F37014A6}" dt="2023-03-17T18:40:06.401" v="1016" actId="478"/>
          <ac:cxnSpMkLst>
            <pc:docMk/>
            <pc:sldMk cId="1416481732" sldId="256"/>
            <ac:cxnSpMk id="19" creationId="{2D5E50A7-769A-AF60-6AA8-B5D035623D38}"/>
          </ac:cxnSpMkLst>
        </pc:cxnChg>
        <pc:cxnChg chg="add mod">
          <ac:chgData name="Qinghe Meng" userId="8ec5781b-3938-43df-a84f-730d81e9a524" providerId="ADAL" clId="{28B8E620-2A74-45DD-9AF1-E710F37014A6}" dt="2023-03-07T21:23:28.699" v="199" actId="1076"/>
          <ac:cxnSpMkLst>
            <pc:docMk/>
            <pc:sldMk cId="1416481732" sldId="256"/>
            <ac:cxnSpMk id="23" creationId="{3B6BBA58-A299-2A37-5CEC-978EB9B70228}"/>
          </ac:cxnSpMkLst>
        </pc:cxnChg>
        <pc:cxnChg chg="add mod">
          <ac:chgData name="Qinghe Meng" userId="8ec5781b-3938-43df-a84f-730d81e9a524" providerId="ADAL" clId="{28B8E620-2A74-45DD-9AF1-E710F37014A6}" dt="2023-03-17T18:39:08.950" v="998" actId="1076"/>
          <ac:cxnSpMkLst>
            <pc:docMk/>
            <pc:sldMk cId="1416481732" sldId="256"/>
            <ac:cxnSpMk id="24" creationId="{A8A22D10-C564-EA86-568A-81788AE878D1}"/>
          </ac:cxnSpMkLst>
        </pc:cxnChg>
        <pc:cxnChg chg="add mod">
          <ac:chgData name="Qinghe Meng" userId="8ec5781b-3938-43df-a84f-730d81e9a524" providerId="ADAL" clId="{28B8E620-2A74-45DD-9AF1-E710F37014A6}" dt="2023-03-17T18:39:46.344" v="1010" actId="1076"/>
          <ac:cxnSpMkLst>
            <pc:docMk/>
            <pc:sldMk cId="1416481732" sldId="256"/>
            <ac:cxnSpMk id="30" creationId="{1F6EB24D-0CF5-B5CC-6EFA-065D60F7DBD2}"/>
          </ac:cxnSpMkLst>
        </pc:cxnChg>
      </pc:sldChg>
      <pc:sldChg chg="delSp new del mod">
        <pc:chgData name="Qinghe Meng" userId="8ec5781b-3938-43df-a84f-730d81e9a524" providerId="ADAL" clId="{28B8E620-2A74-45DD-9AF1-E710F37014A6}" dt="2023-03-08T13:34:07.384" v="889" actId="2696"/>
        <pc:sldMkLst>
          <pc:docMk/>
          <pc:sldMk cId="4206760328" sldId="257"/>
        </pc:sldMkLst>
        <pc:spChg chg="del">
          <ac:chgData name="Qinghe Meng" userId="8ec5781b-3938-43df-a84f-730d81e9a524" providerId="ADAL" clId="{28B8E620-2A74-45DD-9AF1-E710F37014A6}" dt="2023-03-07T21:18:36.502" v="117" actId="478"/>
          <ac:spMkLst>
            <pc:docMk/>
            <pc:sldMk cId="4206760328" sldId="257"/>
            <ac:spMk id="2" creationId="{1C49C42C-7844-BC4A-1E5A-D7935F308639}"/>
          </ac:spMkLst>
        </pc:spChg>
        <pc:spChg chg="del">
          <ac:chgData name="Qinghe Meng" userId="8ec5781b-3938-43df-a84f-730d81e9a524" providerId="ADAL" clId="{28B8E620-2A74-45DD-9AF1-E710F37014A6}" dt="2023-03-07T21:18:39.122" v="118" actId="478"/>
          <ac:spMkLst>
            <pc:docMk/>
            <pc:sldMk cId="4206760328" sldId="257"/>
            <ac:spMk id="3" creationId="{888A5D8B-D55E-B7A6-F576-72E14CFA00C4}"/>
          </ac:spMkLst>
        </pc:spChg>
      </pc:sldChg>
      <pc:sldChg chg="addSp delSp modSp add mod">
        <pc:chgData name="Qinghe Meng" userId="8ec5781b-3938-43df-a84f-730d81e9a524" providerId="ADAL" clId="{28B8E620-2A74-45DD-9AF1-E710F37014A6}" dt="2023-03-17T18:45:41.425" v="1054" actId="1076"/>
        <pc:sldMkLst>
          <pc:docMk/>
          <pc:sldMk cId="1879692957" sldId="258"/>
        </pc:sldMkLst>
        <pc:spChg chg="mod">
          <ac:chgData name="Qinghe Meng" userId="8ec5781b-3938-43df-a84f-730d81e9a524" providerId="ADAL" clId="{28B8E620-2A74-45DD-9AF1-E710F37014A6}" dt="2023-03-07T21:50:42.017" v="557" actId="6549"/>
          <ac:spMkLst>
            <pc:docMk/>
            <pc:sldMk cId="1879692957" sldId="258"/>
            <ac:spMk id="6" creationId="{5F43ACBE-7784-620B-7DE9-28F3500AA41B}"/>
          </ac:spMkLst>
        </pc:spChg>
        <pc:spChg chg="del mod">
          <ac:chgData name="Qinghe Meng" userId="8ec5781b-3938-43df-a84f-730d81e9a524" providerId="ADAL" clId="{28B8E620-2A74-45DD-9AF1-E710F37014A6}" dt="2023-03-07T21:27:54.189" v="273" actId="478"/>
          <ac:spMkLst>
            <pc:docMk/>
            <pc:sldMk cId="1879692957" sldId="258"/>
            <ac:spMk id="7" creationId="{AEC2A375-824A-82AA-A2B5-93C1259A1AA2}"/>
          </ac:spMkLst>
        </pc:spChg>
        <pc:spChg chg="mod">
          <ac:chgData name="Qinghe Meng" userId="8ec5781b-3938-43df-a84f-730d81e9a524" providerId="ADAL" clId="{28B8E620-2A74-45DD-9AF1-E710F37014A6}" dt="2023-03-07T21:27:25.759" v="262" actId="1076"/>
          <ac:spMkLst>
            <pc:docMk/>
            <pc:sldMk cId="1879692957" sldId="258"/>
            <ac:spMk id="8" creationId="{56C7C46D-26B3-8966-23B4-73F80ABBF7EE}"/>
          </ac:spMkLst>
        </pc:spChg>
        <pc:spChg chg="mod">
          <ac:chgData name="Qinghe Meng" userId="8ec5781b-3938-43df-a84f-730d81e9a524" providerId="ADAL" clId="{28B8E620-2A74-45DD-9AF1-E710F37014A6}" dt="2023-03-07T21:23:12.370" v="197" actId="1076"/>
          <ac:spMkLst>
            <pc:docMk/>
            <pc:sldMk cId="1879692957" sldId="258"/>
            <ac:spMk id="9" creationId="{575D03C4-8917-71CF-8B44-80EA7D788907}"/>
          </ac:spMkLst>
        </pc:spChg>
        <pc:spChg chg="mod">
          <ac:chgData name="Qinghe Meng" userId="8ec5781b-3938-43df-a84f-730d81e9a524" providerId="ADAL" clId="{28B8E620-2A74-45DD-9AF1-E710F37014A6}" dt="2023-03-07T21:21:51.122" v="190" actId="1076"/>
          <ac:spMkLst>
            <pc:docMk/>
            <pc:sldMk cId="1879692957" sldId="258"/>
            <ac:spMk id="10" creationId="{7B5338E7-FFA2-7C90-12F2-82E06A82E6FB}"/>
          </ac:spMkLst>
        </pc:spChg>
        <pc:spChg chg="mod">
          <ac:chgData name="Qinghe Meng" userId="8ec5781b-3938-43df-a84f-730d81e9a524" providerId="ADAL" clId="{28B8E620-2A74-45DD-9AF1-E710F37014A6}" dt="2023-03-07T21:27:23.011" v="261" actId="1076"/>
          <ac:spMkLst>
            <pc:docMk/>
            <pc:sldMk cId="1879692957" sldId="258"/>
            <ac:spMk id="11" creationId="{D921206A-231E-0020-D196-92FEE916AAE8}"/>
          </ac:spMkLst>
        </pc:spChg>
        <pc:spChg chg="mod">
          <ac:chgData name="Qinghe Meng" userId="8ec5781b-3938-43df-a84f-730d81e9a524" providerId="ADAL" clId="{28B8E620-2A74-45DD-9AF1-E710F37014A6}" dt="2023-03-07T21:27:19.174" v="260" actId="1076"/>
          <ac:spMkLst>
            <pc:docMk/>
            <pc:sldMk cId="1879692957" sldId="258"/>
            <ac:spMk id="12" creationId="{679078DA-C4F6-5441-4EE1-B814696B77EC}"/>
          </ac:spMkLst>
        </pc:spChg>
        <pc:spChg chg="add mod">
          <ac:chgData name="Qinghe Meng" userId="8ec5781b-3938-43df-a84f-730d81e9a524" providerId="ADAL" clId="{28B8E620-2A74-45DD-9AF1-E710F37014A6}" dt="2023-03-07T21:24:47.647" v="223" actId="6549"/>
          <ac:spMkLst>
            <pc:docMk/>
            <pc:sldMk cId="1879692957" sldId="258"/>
            <ac:spMk id="14" creationId="{776D6728-CC56-DB82-2A93-611FBE4B20B0}"/>
          </ac:spMkLst>
        </pc:spChg>
        <pc:spChg chg="add del mod">
          <ac:chgData name="Qinghe Meng" userId="8ec5781b-3938-43df-a84f-730d81e9a524" providerId="ADAL" clId="{28B8E620-2A74-45DD-9AF1-E710F37014A6}" dt="2023-03-17T18:44:11.162" v="1032"/>
          <ac:spMkLst>
            <pc:docMk/>
            <pc:sldMk cId="1879692957" sldId="258"/>
            <ac:spMk id="16" creationId="{DCFD1358-C107-F716-CC82-739B6DEBAD2E}"/>
          </ac:spMkLst>
        </pc:spChg>
        <pc:spChg chg="add del mod">
          <ac:chgData name="Qinghe Meng" userId="8ec5781b-3938-43df-a84f-730d81e9a524" providerId="ADAL" clId="{28B8E620-2A74-45DD-9AF1-E710F37014A6}" dt="2023-03-17T18:44:17.210" v="1033" actId="21"/>
          <ac:spMkLst>
            <pc:docMk/>
            <pc:sldMk cId="1879692957" sldId="258"/>
            <ac:spMk id="22" creationId="{6456644C-CED1-066B-4530-032B436F51C6}"/>
          </ac:spMkLst>
        </pc:spChg>
        <pc:spChg chg="add mod">
          <ac:chgData name="Qinghe Meng" userId="8ec5781b-3938-43df-a84f-730d81e9a524" providerId="ADAL" clId="{28B8E620-2A74-45DD-9AF1-E710F37014A6}" dt="2023-03-07T21:34:18.689" v="382" actId="1076"/>
          <ac:spMkLst>
            <pc:docMk/>
            <pc:sldMk cId="1879692957" sldId="258"/>
            <ac:spMk id="28" creationId="{C747683A-689F-0F96-9700-5FABFD48B3CF}"/>
          </ac:spMkLst>
        </pc:spChg>
        <pc:spChg chg="add mod">
          <ac:chgData name="Qinghe Meng" userId="8ec5781b-3938-43df-a84f-730d81e9a524" providerId="ADAL" clId="{28B8E620-2A74-45DD-9AF1-E710F37014A6}" dt="2023-03-07T21:33:58.847" v="379" actId="1076"/>
          <ac:spMkLst>
            <pc:docMk/>
            <pc:sldMk cId="1879692957" sldId="258"/>
            <ac:spMk id="29" creationId="{E19AA7D2-2BA4-520B-AFB9-5E6F3911F823}"/>
          </ac:spMkLst>
        </pc:spChg>
        <pc:spChg chg="add mod">
          <ac:chgData name="Qinghe Meng" userId="8ec5781b-3938-43df-a84f-730d81e9a524" providerId="ADAL" clId="{28B8E620-2A74-45DD-9AF1-E710F37014A6}" dt="2023-03-07T21:34:13.469" v="381" actId="1076"/>
          <ac:spMkLst>
            <pc:docMk/>
            <pc:sldMk cId="1879692957" sldId="258"/>
            <ac:spMk id="30" creationId="{441CDDB2-3358-AD71-F39C-E2E1E4203F9A}"/>
          </ac:spMkLst>
        </pc:spChg>
        <pc:spChg chg="add mod">
          <ac:chgData name="Qinghe Meng" userId="8ec5781b-3938-43df-a84f-730d81e9a524" providerId="ADAL" clId="{28B8E620-2A74-45DD-9AF1-E710F37014A6}" dt="2023-03-07T21:34:13.469" v="381" actId="1076"/>
          <ac:spMkLst>
            <pc:docMk/>
            <pc:sldMk cId="1879692957" sldId="258"/>
            <ac:spMk id="31" creationId="{171CF9DD-36D3-8917-495C-EADB749F8F67}"/>
          </ac:spMkLst>
        </pc:spChg>
        <pc:spChg chg="add del mod">
          <ac:chgData name="Qinghe Meng" userId="8ec5781b-3938-43df-a84f-730d81e9a524" providerId="ADAL" clId="{28B8E620-2A74-45DD-9AF1-E710F37014A6}" dt="2023-03-17T18:44:17.210" v="1033" actId="21"/>
          <ac:spMkLst>
            <pc:docMk/>
            <pc:sldMk cId="1879692957" sldId="258"/>
            <ac:spMk id="36" creationId="{34DC0155-29E0-CD23-24B2-22995884F323}"/>
          </ac:spMkLst>
        </pc:spChg>
        <pc:spChg chg="add del mod">
          <ac:chgData name="Qinghe Meng" userId="8ec5781b-3938-43df-a84f-730d81e9a524" providerId="ADAL" clId="{28B8E620-2A74-45DD-9AF1-E710F37014A6}" dt="2023-03-17T18:44:17.210" v="1033" actId="21"/>
          <ac:spMkLst>
            <pc:docMk/>
            <pc:sldMk cId="1879692957" sldId="258"/>
            <ac:spMk id="37" creationId="{D9734BC3-2D7E-CA20-E4D3-23F333D0F542}"/>
          </ac:spMkLst>
        </pc:spChg>
        <pc:spChg chg="add del mod">
          <ac:chgData name="Qinghe Meng" userId="8ec5781b-3938-43df-a84f-730d81e9a524" providerId="ADAL" clId="{28B8E620-2A74-45DD-9AF1-E710F37014A6}" dt="2023-03-17T18:44:17.210" v="1033" actId="21"/>
          <ac:spMkLst>
            <pc:docMk/>
            <pc:sldMk cId="1879692957" sldId="258"/>
            <ac:spMk id="38" creationId="{D2E936F3-FF4C-42CD-E06B-3B5C18B3B3C9}"/>
          </ac:spMkLst>
        </pc:spChg>
        <pc:spChg chg="add del mod">
          <ac:chgData name="Qinghe Meng" userId="8ec5781b-3938-43df-a84f-730d81e9a524" providerId="ADAL" clId="{28B8E620-2A74-45DD-9AF1-E710F37014A6}" dt="2023-03-17T18:44:17.210" v="1033" actId="21"/>
          <ac:spMkLst>
            <pc:docMk/>
            <pc:sldMk cId="1879692957" sldId="258"/>
            <ac:spMk id="39" creationId="{1E92A60B-5BBC-CA8C-BA8D-77C9882FBE41}"/>
          </ac:spMkLst>
        </pc:spChg>
        <pc:spChg chg="add del mod">
          <ac:chgData name="Qinghe Meng" userId="8ec5781b-3938-43df-a84f-730d81e9a524" providerId="ADAL" clId="{28B8E620-2A74-45DD-9AF1-E710F37014A6}" dt="2023-03-17T18:44:11.162" v="1032"/>
          <ac:spMkLst>
            <pc:docMk/>
            <pc:sldMk cId="1879692957" sldId="258"/>
            <ac:spMk id="40" creationId="{94F22418-C955-0EE8-8F64-4E2AC1A914A4}"/>
          </ac:spMkLst>
        </pc:spChg>
        <pc:spChg chg="add del mod">
          <ac:chgData name="Qinghe Meng" userId="8ec5781b-3938-43df-a84f-730d81e9a524" providerId="ADAL" clId="{28B8E620-2A74-45DD-9AF1-E710F37014A6}" dt="2023-03-17T18:44:11.162" v="1032"/>
          <ac:spMkLst>
            <pc:docMk/>
            <pc:sldMk cId="1879692957" sldId="258"/>
            <ac:spMk id="41" creationId="{BEB84199-42CF-A69B-6F37-4A7CBD75961C}"/>
          </ac:spMkLst>
        </pc:spChg>
        <pc:spChg chg="add del mod">
          <ac:chgData name="Qinghe Meng" userId="8ec5781b-3938-43df-a84f-730d81e9a524" providerId="ADAL" clId="{28B8E620-2A74-45DD-9AF1-E710F37014A6}" dt="2023-03-17T18:44:11.162" v="1032"/>
          <ac:spMkLst>
            <pc:docMk/>
            <pc:sldMk cId="1879692957" sldId="258"/>
            <ac:spMk id="42" creationId="{EBF1BE61-26DE-15DB-548F-69BBD2B6365A}"/>
          </ac:spMkLst>
        </pc:spChg>
        <pc:spChg chg="add del mod">
          <ac:chgData name="Qinghe Meng" userId="8ec5781b-3938-43df-a84f-730d81e9a524" providerId="ADAL" clId="{28B8E620-2A74-45DD-9AF1-E710F37014A6}" dt="2023-03-17T18:44:11.162" v="1032"/>
          <ac:spMkLst>
            <pc:docMk/>
            <pc:sldMk cId="1879692957" sldId="258"/>
            <ac:spMk id="43" creationId="{9D0398D3-C0D8-AD0C-1688-92613BF62672}"/>
          </ac:spMkLst>
        </pc:spChg>
        <pc:spChg chg="add mod">
          <ac:chgData name="Qinghe Meng" userId="8ec5781b-3938-43df-a84f-730d81e9a524" providerId="ADAL" clId="{28B8E620-2A74-45DD-9AF1-E710F37014A6}" dt="2023-03-17T18:45:02.671" v="1043" actId="1076"/>
          <ac:spMkLst>
            <pc:docMk/>
            <pc:sldMk cId="1879692957" sldId="258"/>
            <ac:spMk id="45" creationId="{3C426102-65C7-55A3-0BE7-F595D9A3959C}"/>
          </ac:spMkLst>
        </pc:spChg>
        <pc:spChg chg="add mod">
          <ac:chgData name="Qinghe Meng" userId="8ec5781b-3938-43df-a84f-730d81e9a524" providerId="ADAL" clId="{28B8E620-2A74-45DD-9AF1-E710F37014A6}" dt="2023-03-07T21:41:00.059" v="444" actId="1076"/>
          <ac:spMkLst>
            <pc:docMk/>
            <pc:sldMk cId="1879692957" sldId="258"/>
            <ac:spMk id="48" creationId="{DBC978A5-E982-59D9-800A-A97A14FCE6B3}"/>
          </ac:spMkLst>
        </pc:spChg>
        <pc:spChg chg="add mod">
          <ac:chgData name="Qinghe Meng" userId="8ec5781b-3938-43df-a84f-730d81e9a524" providerId="ADAL" clId="{28B8E620-2A74-45DD-9AF1-E710F37014A6}" dt="2023-03-17T18:45:23.850" v="1048" actId="1076"/>
          <ac:spMkLst>
            <pc:docMk/>
            <pc:sldMk cId="1879692957" sldId="258"/>
            <ac:spMk id="51" creationId="{3EE0CF30-2E58-E55C-8EB0-ECEE53D0DB0E}"/>
          </ac:spMkLst>
        </pc:spChg>
        <pc:spChg chg="add mod">
          <ac:chgData name="Qinghe Meng" userId="8ec5781b-3938-43df-a84f-730d81e9a524" providerId="ADAL" clId="{28B8E620-2A74-45DD-9AF1-E710F37014A6}" dt="2023-03-17T18:45:29.161" v="1050" actId="1076"/>
          <ac:spMkLst>
            <pc:docMk/>
            <pc:sldMk cId="1879692957" sldId="258"/>
            <ac:spMk id="52" creationId="{D52638C7-823F-2352-FAA7-82DBF63DF197}"/>
          </ac:spMkLst>
        </pc:spChg>
        <pc:spChg chg="add mod">
          <ac:chgData name="Qinghe Meng" userId="8ec5781b-3938-43df-a84f-730d81e9a524" providerId="ADAL" clId="{28B8E620-2A74-45DD-9AF1-E710F37014A6}" dt="2023-03-17T18:45:35.592" v="1052" actId="1076"/>
          <ac:spMkLst>
            <pc:docMk/>
            <pc:sldMk cId="1879692957" sldId="258"/>
            <ac:spMk id="53" creationId="{56287F4A-18DD-1C0D-E31D-A88428900EE7}"/>
          </ac:spMkLst>
        </pc:spChg>
        <pc:spChg chg="add mod">
          <ac:chgData name="Qinghe Meng" userId="8ec5781b-3938-43df-a84f-730d81e9a524" providerId="ADAL" clId="{28B8E620-2A74-45DD-9AF1-E710F37014A6}" dt="2023-03-17T18:45:41.425" v="1054" actId="1076"/>
          <ac:spMkLst>
            <pc:docMk/>
            <pc:sldMk cId="1879692957" sldId="258"/>
            <ac:spMk id="54" creationId="{DCDB8A4F-6BFF-702B-7B9F-95BF1376C9F5}"/>
          </ac:spMkLst>
        </pc:spChg>
        <pc:picChg chg="del mod">
          <ac:chgData name="Qinghe Meng" userId="8ec5781b-3938-43df-a84f-730d81e9a524" providerId="ADAL" clId="{28B8E620-2A74-45DD-9AF1-E710F37014A6}" dt="2023-03-07T21:19:38.177" v="148" actId="478"/>
          <ac:picMkLst>
            <pc:docMk/>
            <pc:sldMk cId="1879692957" sldId="258"/>
            <ac:picMk id="3" creationId="{499AB86A-9DA5-1274-1477-4F351861FBD7}"/>
          </ac:picMkLst>
        </pc:picChg>
        <pc:picChg chg="add del mod">
          <ac:chgData name="Qinghe Meng" userId="8ec5781b-3938-43df-a84f-730d81e9a524" providerId="ADAL" clId="{28B8E620-2A74-45DD-9AF1-E710F37014A6}" dt="2023-03-17T18:43:28.912" v="1023" actId="478"/>
          <ac:picMkLst>
            <pc:docMk/>
            <pc:sldMk cId="1879692957" sldId="258"/>
            <ac:picMk id="3" creationId="{98D041EF-0505-4C46-C6E7-23EB310DA361}"/>
          </ac:picMkLst>
        </pc:picChg>
        <pc:picChg chg="add mod">
          <ac:chgData name="Qinghe Meng" userId="8ec5781b-3938-43df-a84f-730d81e9a524" providerId="ADAL" clId="{28B8E620-2A74-45DD-9AF1-E710F37014A6}" dt="2023-03-07T21:22:38.128" v="192" actId="1076"/>
          <ac:picMkLst>
            <pc:docMk/>
            <pc:sldMk cId="1879692957" sldId="258"/>
            <ac:picMk id="4" creationId="{662A7EC4-4997-BF7B-A30E-28B6B78ABC13}"/>
          </ac:picMkLst>
        </pc:picChg>
        <pc:picChg chg="del">
          <ac:chgData name="Qinghe Meng" userId="8ec5781b-3938-43df-a84f-730d81e9a524" providerId="ADAL" clId="{28B8E620-2A74-45DD-9AF1-E710F37014A6}" dt="2023-03-07T21:19:21.153" v="143" actId="478"/>
          <ac:picMkLst>
            <pc:docMk/>
            <pc:sldMk cId="1879692957" sldId="258"/>
            <ac:picMk id="5" creationId="{D82EFDB1-9CFD-85D8-4F2D-A78971F310C4}"/>
          </ac:picMkLst>
        </pc:picChg>
        <pc:picChg chg="add mod">
          <ac:chgData name="Qinghe Meng" userId="8ec5781b-3938-43df-a84f-730d81e9a524" providerId="ADAL" clId="{28B8E620-2A74-45DD-9AF1-E710F37014A6}" dt="2023-03-17T18:45:09.030" v="1045" actId="1076"/>
          <ac:picMkLst>
            <pc:docMk/>
            <pc:sldMk cId="1879692957" sldId="258"/>
            <ac:picMk id="7" creationId="{31DE233C-4F0C-22B9-ADBF-F1EECFC34B6C}"/>
          </ac:picMkLst>
        </pc:picChg>
        <pc:picChg chg="add del mod">
          <ac:chgData name="Qinghe Meng" userId="8ec5781b-3938-43df-a84f-730d81e9a524" providerId="ADAL" clId="{28B8E620-2A74-45DD-9AF1-E710F37014A6}" dt="2023-03-07T21:25:50.494" v="230" actId="478"/>
          <ac:picMkLst>
            <pc:docMk/>
            <pc:sldMk cId="1879692957" sldId="258"/>
            <ac:picMk id="16" creationId="{AA6F74B8-1C5C-5DAD-C202-2347A5DC0559}"/>
          </ac:picMkLst>
        </pc:picChg>
        <pc:picChg chg="add del mod">
          <ac:chgData name="Qinghe Meng" userId="8ec5781b-3938-43df-a84f-730d81e9a524" providerId="ADAL" clId="{28B8E620-2A74-45DD-9AF1-E710F37014A6}" dt="2023-03-07T21:26:05.422" v="238" actId="478"/>
          <ac:picMkLst>
            <pc:docMk/>
            <pc:sldMk cId="1879692957" sldId="258"/>
            <ac:picMk id="18" creationId="{5089B7F9-0765-ABD7-D2D3-052BFCE6D678}"/>
          </ac:picMkLst>
        </pc:picChg>
        <pc:picChg chg="add del mod">
          <ac:chgData name="Qinghe Meng" userId="8ec5781b-3938-43df-a84f-730d81e9a524" providerId="ADAL" clId="{28B8E620-2A74-45DD-9AF1-E710F37014A6}" dt="2023-03-17T18:43:40.575" v="1028" actId="478"/>
          <ac:picMkLst>
            <pc:docMk/>
            <pc:sldMk cId="1879692957" sldId="258"/>
            <ac:picMk id="20" creationId="{BB81B00E-3771-F15B-975A-FCE9BA60F8B7}"/>
          </ac:picMkLst>
        </pc:picChg>
        <pc:cxnChg chg="add mod">
          <ac:chgData name="Qinghe Meng" userId="8ec5781b-3938-43df-a84f-730d81e9a524" providerId="ADAL" clId="{28B8E620-2A74-45DD-9AF1-E710F37014A6}" dt="2023-03-07T21:24:43.200" v="219" actId="1076"/>
          <ac:cxnSpMkLst>
            <pc:docMk/>
            <pc:sldMk cId="1879692957" sldId="258"/>
            <ac:cxnSpMk id="13" creationId="{D514497C-A6DE-45A8-E40B-F3A3FEB0958E}"/>
          </ac:cxnSpMkLst>
        </pc:cxnChg>
        <pc:cxnChg chg="add del mod">
          <ac:chgData name="Qinghe Meng" userId="8ec5781b-3938-43df-a84f-730d81e9a524" providerId="ADAL" clId="{28B8E620-2A74-45DD-9AF1-E710F37014A6}" dt="2023-03-17T18:44:11.162" v="1032"/>
          <ac:cxnSpMkLst>
            <pc:docMk/>
            <pc:sldMk cId="1879692957" sldId="258"/>
            <ac:cxnSpMk id="15" creationId="{F5CE598D-5B00-C679-274B-E9E997213950}"/>
          </ac:cxnSpMkLst>
        </pc:cxnChg>
        <pc:cxnChg chg="add del mod">
          <ac:chgData name="Qinghe Meng" userId="8ec5781b-3938-43df-a84f-730d81e9a524" providerId="ADAL" clId="{28B8E620-2A74-45DD-9AF1-E710F37014A6}" dt="2023-03-17T18:44:11.162" v="1032"/>
          <ac:cxnSpMkLst>
            <pc:docMk/>
            <pc:sldMk cId="1879692957" sldId="258"/>
            <ac:cxnSpMk id="17" creationId="{B5559ECA-4E1D-FD8D-7816-CC9994A65A36}"/>
          </ac:cxnSpMkLst>
        </pc:cxnChg>
        <pc:cxnChg chg="add del mod">
          <ac:chgData name="Qinghe Meng" userId="8ec5781b-3938-43df-a84f-730d81e9a524" providerId="ADAL" clId="{28B8E620-2A74-45DD-9AF1-E710F37014A6}" dt="2023-03-17T18:44:11.162" v="1032"/>
          <ac:cxnSpMkLst>
            <pc:docMk/>
            <pc:sldMk cId="1879692957" sldId="258"/>
            <ac:cxnSpMk id="18" creationId="{94662656-047A-192F-709A-6DE701498E94}"/>
          </ac:cxnSpMkLst>
        </pc:cxnChg>
        <pc:cxnChg chg="add del mod">
          <ac:chgData name="Qinghe Meng" userId="8ec5781b-3938-43df-a84f-730d81e9a524" providerId="ADAL" clId="{28B8E620-2A74-45DD-9AF1-E710F37014A6}" dt="2023-03-17T18:44:11.162" v="1032"/>
          <ac:cxnSpMkLst>
            <pc:docMk/>
            <pc:sldMk cId="1879692957" sldId="258"/>
            <ac:cxnSpMk id="19" creationId="{AE98E3A1-49ED-C8D5-AE74-8E9B79DE0438}"/>
          </ac:cxnSpMkLst>
        </pc:cxnChg>
        <pc:cxnChg chg="add del mod">
          <ac:chgData name="Qinghe Meng" userId="8ec5781b-3938-43df-a84f-730d81e9a524" providerId="ADAL" clId="{28B8E620-2A74-45DD-9AF1-E710F37014A6}" dt="2023-03-17T18:44:17.210" v="1033" actId="21"/>
          <ac:cxnSpMkLst>
            <pc:docMk/>
            <pc:sldMk cId="1879692957" sldId="258"/>
            <ac:cxnSpMk id="21" creationId="{D47FC74E-FF67-290C-F018-305D5731FF48}"/>
          </ac:cxnSpMkLst>
        </pc:cxnChg>
        <pc:cxnChg chg="add del mod">
          <ac:chgData name="Qinghe Meng" userId="8ec5781b-3938-43df-a84f-730d81e9a524" providerId="ADAL" clId="{28B8E620-2A74-45DD-9AF1-E710F37014A6}" dt="2023-03-17T18:44:11.162" v="1032"/>
          <ac:cxnSpMkLst>
            <pc:docMk/>
            <pc:sldMk cId="1879692957" sldId="258"/>
            <ac:cxnSpMk id="23" creationId="{4F77B417-8EE9-6CD4-C22C-65BDCCCFAA3C}"/>
          </ac:cxnSpMkLst>
        </pc:cxnChg>
        <pc:cxnChg chg="add mod">
          <ac:chgData name="Qinghe Meng" userId="8ec5781b-3938-43df-a84f-730d81e9a524" providerId="ADAL" clId="{28B8E620-2A74-45DD-9AF1-E710F37014A6}" dt="2023-03-07T21:32:39.489" v="343" actId="1076"/>
          <ac:cxnSpMkLst>
            <pc:docMk/>
            <pc:sldMk cId="1879692957" sldId="258"/>
            <ac:cxnSpMk id="24" creationId="{08961475-1B20-B0E4-0817-43E822759D12}"/>
          </ac:cxnSpMkLst>
        </pc:cxnChg>
        <pc:cxnChg chg="add mod">
          <ac:chgData name="Qinghe Meng" userId="8ec5781b-3938-43df-a84f-730d81e9a524" providerId="ADAL" clId="{28B8E620-2A74-45DD-9AF1-E710F37014A6}" dt="2023-03-07T21:33:10.355" v="351" actId="1076"/>
          <ac:cxnSpMkLst>
            <pc:docMk/>
            <pc:sldMk cId="1879692957" sldId="258"/>
            <ac:cxnSpMk id="25" creationId="{1953B895-B4A5-F2F8-6DA5-036C9605B645}"/>
          </ac:cxnSpMkLst>
        </pc:cxnChg>
        <pc:cxnChg chg="add mod">
          <ac:chgData name="Qinghe Meng" userId="8ec5781b-3938-43df-a84f-730d81e9a524" providerId="ADAL" clId="{28B8E620-2A74-45DD-9AF1-E710F37014A6}" dt="2023-03-07T21:33:08.601" v="350" actId="1076"/>
          <ac:cxnSpMkLst>
            <pc:docMk/>
            <pc:sldMk cId="1879692957" sldId="258"/>
            <ac:cxnSpMk id="26" creationId="{1351BB8D-ED44-7D74-342E-6EA02A12657D}"/>
          </ac:cxnSpMkLst>
        </pc:cxnChg>
        <pc:cxnChg chg="add mod">
          <ac:chgData name="Qinghe Meng" userId="8ec5781b-3938-43df-a84f-730d81e9a524" providerId="ADAL" clId="{28B8E620-2A74-45DD-9AF1-E710F37014A6}" dt="2023-03-07T21:33:12.085" v="352" actId="1076"/>
          <ac:cxnSpMkLst>
            <pc:docMk/>
            <pc:sldMk cId="1879692957" sldId="258"/>
            <ac:cxnSpMk id="27" creationId="{759C4073-1BF5-1998-0A71-9A4F333CC82A}"/>
          </ac:cxnSpMkLst>
        </pc:cxnChg>
        <pc:cxnChg chg="add del mod">
          <ac:chgData name="Qinghe Meng" userId="8ec5781b-3938-43df-a84f-730d81e9a524" providerId="ADAL" clId="{28B8E620-2A74-45DD-9AF1-E710F37014A6}" dt="2023-03-17T18:44:17.210" v="1033" actId="21"/>
          <ac:cxnSpMkLst>
            <pc:docMk/>
            <pc:sldMk cId="1879692957" sldId="258"/>
            <ac:cxnSpMk id="32" creationId="{6C2916A4-955D-7D46-0262-BE110AE10076}"/>
          </ac:cxnSpMkLst>
        </pc:cxnChg>
        <pc:cxnChg chg="add del mod">
          <ac:chgData name="Qinghe Meng" userId="8ec5781b-3938-43df-a84f-730d81e9a524" providerId="ADAL" clId="{28B8E620-2A74-45DD-9AF1-E710F37014A6}" dt="2023-03-17T18:44:17.210" v="1033" actId="21"/>
          <ac:cxnSpMkLst>
            <pc:docMk/>
            <pc:sldMk cId="1879692957" sldId="258"/>
            <ac:cxnSpMk id="33" creationId="{FB7D3933-1632-67B8-C556-80DDDAE3C303}"/>
          </ac:cxnSpMkLst>
        </pc:cxnChg>
        <pc:cxnChg chg="add del mod">
          <ac:chgData name="Qinghe Meng" userId="8ec5781b-3938-43df-a84f-730d81e9a524" providerId="ADAL" clId="{28B8E620-2A74-45DD-9AF1-E710F37014A6}" dt="2023-03-17T18:44:17.210" v="1033" actId="21"/>
          <ac:cxnSpMkLst>
            <pc:docMk/>
            <pc:sldMk cId="1879692957" sldId="258"/>
            <ac:cxnSpMk id="34" creationId="{44BF6FD5-FD94-1035-04AA-EBD4E23CD237}"/>
          </ac:cxnSpMkLst>
        </pc:cxnChg>
        <pc:cxnChg chg="add del mod">
          <ac:chgData name="Qinghe Meng" userId="8ec5781b-3938-43df-a84f-730d81e9a524" providerId="ADAL" clId="{28B8E620-2A74-45DD-9AF1-E710F37014A6}" dt="2023-03-17T18:44:17.210" v="1033" actId="21"/>
          <ac:cxnSpMkLst>
            <pc:docMk/>
            <pc:sldMk cId="1879692957" sldId="258"/>
            <ac:cxnSpMk id="35" creationId="{636C6C36-B31E-1677-5E0D-3054174DD6AF}"/>
          </ac:cxnSpMkLst>
        </pc:cxnChg>
        <pc:cxnChg chg="add mod">
          <ac:chgData name="Qinghe Meng" userId="8ec5781b-3938-43df-a84f-730d81e9a524" providerId="ADAL" clId="{28B8E620-2A74-45DD-9AF1-E710F37014A6}" dt="2023-03-17T18:45:04.489" v="1044" actId="1076"/>
          <ac:cxnSpMkLst>
            <pc:docMk/>
            <pc:sldMk cId="1879692957" sldId="258"/>
            <ac:cxnSpMk id="44" creationId="{6E01ABE6-15AB-FE5F-DEC2-3992D9AC97D9}"/>
          </ac:cxnSpMkLst>
        </pc:cxnChg>
        <pc:cxnChg chg="add mod">
          <ac:chgData name="Qinghe Meng" userId="8ec5781b-3938-43df-a84f-730d81e9a524" providerId="ADAL" clId="{28B8E620-2A74-45DD-9AF1-E710F37014A6}" dt="2023-03-17T18:45:20.173" v="1047" actId="1076"/>
          <ac:cxnSpMkLst>
            <pc:docMk/>
            <pc:sldMk cId="1879692957" sldId="258"/>
            <ac:cxnSpMk id="46" creationId="{FE503A97-FC09-2ED5-7445-163E158F62C7}"/>
          </ac:cxnSpMkLst>
        </pc:cxnChg>
        <pc:cxnChg chg="add mod">
          <ac:chgData name="Qinghe Meng" userId="8ec5781b-3938-43df-a84f-730d81e9a524" providerId="ADAL" clId="{28B8E620-2A74-45DD-9AF1-E710F37014A6}" dt="2023-03-17T18:45:25.869" v="1049" actId="1076"/>
          <ac:cxnSpMkLst>
            <pc:docMk/>
            <pc:sldMk cId="1879692957" sldId="258"/>
            <ac:cxnSpMk id="47" creationId="{44AEB96E-3816-7E34-DBBD-5E899FA11AB5}"/>
          </ac:cxnSpMkLst>
        </pc:cxnChg>
        <pc:cxnChg chg="add mod">
          <ac:chgData name="Qinghe Meng" userId="8ec5781b-3938-43df-a84f-730d81e9a524" providerId="ADAL" clId="{28B8E620-2A74-45DD-9AF1-E710F37014A6}" dt="2023-03-17T18:45:33.023" v="1051" actId="1076"/>
          <ac:cxnSpMkLst>
            <pc:docMk/>
            <pc:sldMk cId="1879692957" sldId="258"/>
            <ac:cxnSpMk id="49" creationId="{EC899C38-7239-5CAB-45A5-E47DFD057844}"/>
          </ac:cxnSpMkLst>
        </pc:cxnChg>
        <pc:cxnChg chg="add mod">
          <ac:chgData name="Qinghe Meng" userId="8ec5781b-3938-43df-a84f-730d81e9a524" providerId="ADAL" clId="{28B8E620-2A74-45DD-9AF1-E710F37014A6}" dt="2023-03-17T18:45:37.828" v="1053" actId="1076"/>
          <ac:cxnSpMkLst>
            <pc:docMk/>
            <pc:sldMk cId="1879692957" sldId="258"/>
            <ac:cxnSpMk id="50" creationId="{A475CE0B-7B54-C51D-DFB3-2B9618CB7877}"/>
          </ac:cxnSpMkLst>
        </pc:cxnChg>
      </pc:sldChg>
      <pc:sldChg chg="addSp delSp modSp add mod">
        <pc:chgData name="Qinghe Meng" userId="8ec5781b-3938-43df-a84f-730d81e9a524" providerId="ADAL" clId="{28B8E620-2A74-45DD-9AF1-E710F37014A6}" dt="2023-03-07T21:57:22.502" v="674" actId="1076"/>
        <pc:sldMkLst>
          <pc:docMk/>
          <pc:sldMk cId="2029615342" sldId="259"/>
        </pc:sldMkLst>
        <pc:spChg chg="mod">
          <ac:chgData name="Qinghe Meng" userId="8ec5781b-3938-43df-a84f-730d81e9a524" providerId="ADAL" clId="{28B8E620-2A74-45DD-9AF1-E710F37014A6}" dt="2023-03-07T21:50:45.905" v="559" actId="6549"/>
          <ac:spMkLst>
            <pc:docMk/>
            <pc:sldMk cId="2029615342" sldId="259"/>
            <ac:spMk id="6" creationId="{5F43ACBE-7784-620B-7DE9-28F3500AA41B}"/>
          </ac:spMkLst>
        </pc:spChg>
        <pc:spChg chg="del">
          <ac:chgData name="Qinghe Meng" userId="8ec5781b-3938-43df-a84f-730d81e9a524" providerId="ADAL" clId="{28B8E620-2A74-45DD-9AF1-E710F37014A6}" dt="2023-03-07T21:27:57.645" v="274" actId="478"/>
          <ac:spMkLst>
            <pc:docMk/>
            <pc:sldMk cId="2029615342" sldId="259"/>
            <ac:spMk id="7" creationId="{AEC2A375-824A-82AA-A2B5-93C1259A1AA2}"/>
          </ac:spMkLst>
        </pc:spChg>
        <pc:spChg chg="mod">
          <ac:chgData name="Qinghe Meng" userId="8ec5781b-3938-43df-a84f-730d81e9a524" providerId="ADAL" clId="{28B8E620-2A74-45DD-9AF1-E710F37014A6}" dt="2023-03-07T21:30:56.635" v="317" actId="20577"/>
          <ac:spMkLst>
            <pc:docMk/>
            <pc:sldMk cId="2029615342" sldId="259"/>
            <ac:spMk id="8" creationId="{56C7C46D-26B3-8966-23B4-73F80ABBF7EE}"/>
          </ac:spMkLst>
        </pc:spChg>
        <pc:spChg chg="mod">
          <ac:chgData name="Qinghe Meng" userId="8ec5781b-3938-43df-a84f-730d81e9a524" providerId="ADAL" clId="{28B8E620-2A74-45DD-9AF1-E710F37014A6}" dt="2023-03-07T21:28:59.642" v="288" actId="14100"/>
          <ac:spMkLst>
            <pc:docMk/>
            <pc:sldMk cId="2029615342" sldId="259"/>
            <ac:spMk id="9" creationId="{575D03C4-8917-71CF-8B44-80EA7D788907}"/>
          </ac:spMkLst>
        </pc:spChg>
        <pc:spChg chg="mod">
          <ac:chgData name="Qinghe Meng" userId="8ec5781b-3938-43df-a84f-730d81e9a524" providerId="ADAL" clId="{28B8E620-2A74-45DD-9AF1-E710F37014A6}" dt="2023-03-07T21:31:32.127" v="330" actId="1076"/>
          <ac:spMkLst>
            <pc:docMk/>
            <pc:sldMk cId="2029615342" sldId="259"/>
            <ac:spMk id="10" creationId="{7B5338E7-FFA2-7C90-12F2-82E06A82E6FB}"/>
          </ac:spMkLst>
        </pc:spChg>
        <pc:spChg chg="mod">
          <ac:chgData name="Qinghe Meng" userId="8ec5781b-3938-43df-a84f-730d81e9a524" providerId="ADAL" clId="{28B8E620-2A74-45DD-9AF1-E710F37014A6}" dt="2023-03-07T21:29:41.607" v="299" actId="1076"/>
          <ac:spMkLst>
            <pc:docMk/>
            <pc:sldMk cId="2029615342" sldId="259"/>
            <ac:spMk id="11" creationId="{D921206A-231E-0020-D196-92FEE916AAE8}"/>
          </ac:spMkLst>
        </pc:spChg>
        <pc:spChg chg="mod">
          <ac:chgData name="Qinghe Meng" userId="8ec5781b-3938-43df-a84f-730d81e9a524" providerId="ADAL" clId="{28B8E620-2A74-45DD-9AF1-E710F37014A6}" dt="2023-03-07T21:30:04.797" v="302" actId="6549"/>
          <ac:spMkLst>
            <pc:docMk/>
            <pc:sldMk cId="2029615342" sldId="259"/>
            <ac:spMk id="12" creationId="{679078DA-C4F6-5441-4EE1-B814696B77EC}"/>
          </ac:spMkLst>
        </pc:spChg>
        <pc:spChg chg="mod">
          <ac:chgData name="Qinghe Meng" userId="8ec5781b-3938-43df-a84f-730d81e9a524" providerId="ADAL" clId="{28B8E620-2A74-45DD-9AF1-E710F37014A6}" dt="2023-03-07T21:28:28.861" v="284" actId="6549"/>
          <ac:spMkLst>
            <pc:docMk/>
            <pc:sldMk cId="2029615342" sldId="259"/>
            <ac:spMk id="14" creationId="{776D6728-CC56-DB82-2A93-611FBE4B20B0}"/>
          </ac:spMkLst>
        </pc:spChg>
        <pc:spChg chg="add mod">
          <ac:chgData name="Qinghe Meng" userId="8ec5781b-3938-43df-a84f-730d81e9a524" providerId="ADAL" clId="{28B8E620-2A74-45DD-9AF1-E710F37014A6}" dt="2023-03-07T21:57:22.502" v="674" actId="1076"/>
          <ac:spMkLst>
            <pc:docMk/>
            <pc:sldMk cId="2029615342" sldId="259"/>
            <ac:spMk id="18" creationId="{4384A274-D11C-1E52-42C1-9446BCFDC8B9}"/>
          </ac:spMkLst>
        </pc:spChg>
        <pc:spChg chg="add mod">
          <ac:chgData name="Qinghe Meng" userId="8ec5781b-3938-43df-a84f-730d81e9a524" providerId="ADAL" clId="{28B8E620-2A74-45DD-9AF1-E710F37014A6}" dt="2023-03-07T21:43:42.290" v="484" actId="1076"/>
          <ac:spMkLst>
            <pc:docMk/>
            <pc:sldMk cId="2029615342" sldId="259"/>
            <ac:spMk id="19" creationId="{1A12B22B-8CC3-A315-F848-647408B14F3F}"/>
          </ac:spMkLst>
        </pc:spChg>
        <pc:spChg chg="mod">
          <ac:chgData name="Qinghe Meng" userId="8ec5781b-3938-43df-a84f-730d81e9a524" providerId="ADAL" clId="{28B8E620-2A74-45DD-9AF1-E710F37014A6}" dt="2023-03-07T21:30:49.181" v="312" actId="1076"/>
          <ac:spMkLst>
            <pc:docMk/>
            <pc:sldMk cId="2029615342" sldId="259"/>
            <ac:spMk id="22" creationId="{6456644C-CED1-066B-4530-032B436F51C6}"/>
          </ac:spMkLst>
        </pc:spChg>
        <pc:spChg chg="add mod">
          <ac:chgData name="Qinghe Meng" userId="8ec5781b-3938-43df-a84f-730d81e9a524" providerId="ADAL" clId="{28B8E620-2A74-45DD-9AF1-E710F37014A6}" dt="2023-03-07T21:44:00.162" v="489" actId="1076"/>
          <ac:spMkLst>
            <pc:docMk/>
            <pc:sldMk cId="2029615342" sldId="259"/>
            <ac:spMk id="25" creationId="{B4B1354E-8A9E-4C5E-F10E-D431119189C8}"/>
          </ac:spMkLst>
        </pc:spChg>
        <pc:spChg chg="add mod">
          <ac:chgData name="Qinghe Meng" userId="8ec5781b-3938-43df-a84f-730d81e9a524" providerId="ADAL" clId="{28B8E620-2A74-45DD-9AF1-E710F37014A6}" dt="2023-03-07T21:44:05.175" v="490" actId="1076"/>
          <ac:spMkLst>
            <pc:docMk/>
            <pc:sldMk cId="2029615342" sldId="259"/>
            <ac:spMk id="26" creationId="{BA3D3F93-24C5-34E8-F087-0EE863275F7F}"/>
          </ac:spMkLst>
        </pc:spChg>
        <pc:spChg chg="add mod">
          <ac:chgData name="Qinghe Meng" userId="8ec5781b-3938-43df-a84f-730d81e9a524" providerId="ADAL" clId="{28B8E620-2A74-45DD-9AF1-E710F37014A6}" dt="2023-03-07T21:43:49.188" v="486" actId="14100"/>
          <ac:spMkLst>
            <pc:docMk/>
            <pc:sldMk cId="2029615342" sldId="259"/>
            <ac:spMk id="28" creationId="{733E9BD7-B487-1674-8409-73F18871FBE5}"/>
          </ac:spMkLst>
        </pc:spChg>
        <pc:picChg chg="add mod">
          <ac:chgData name="Qinghe Meng" userId="8ec5781b-3938-43df-a84f-730d81e9a524" providerId="ADAL" clId="{28B8E620-2A74-45DD-9AF1-E710F37014A6}" dt="2023-03-07T21:28:17.026" v="281" actId="1076"/>
          <ac:picMkLst>
            <pc:docMk/>
            <pc:sldMk cId="2029615342" sldId="259"/>
            <ac:picMk id="3" creationId="{59616DDD-C6B4-5098-7791-9F5AEFD16F97}"/>
          </ac:picMkLst>
        </pc:picChg>
        <pc:picChg chg="del">
          <ac:chgData name="Qinghe Meng" userId="8ec5781b-3938-43df-a84f-730d81e9a524" providerId="ADAL" clId="{28B8E620-2A74-45DD-9AF1-E710F37014A6}" dt="2023-03-07T21:28:05.228" v="275" actId="478"/>
          <ac:picMkLst>
            <pc:docMk/>
            <pc:sldMk cId="2029615342" sldId="259"/>
            <ac:picMk id="4" creationId="{662A7EC4-4997-BF7B-A30E-28B6B78ABC13}"/>
          </ac:picMkLst>
        </pc:picChg>
        <pc:picChg chg="add mod">
          <ac:chgData name="Qinghe Meng" userId="8ec5781b-3938-43df-a84f-730d81e9a524" providerId="ADAL" clId="{28B8E620-2A74-45DD-9AF1-E710F37014A6}" dt="2023-03-07T21:30:07.448" v="303" actId="1076"/>
          <ac:picMkLst>
            <pc:docMk/>
            <pc:sldMk cId="2029615342" sldId="259"/>
            <ac:picMk id="15" creationId="{EC419AA0-6284-1F2E-4CAC-94F826B54B2B}"/>
          </ac:picMkLst>
        </pc:picChg>
        <pc:picChg chg="del">
          <ac:chgData name="Qinghe Meng" userId="8ec5781b-3938-43df-a84f-730d81e9a524" providerId="ADAL" clId="{28B8E620-2A74-45DD-9AF1-E710F37014A6}" dt="2023-03-07T21:29:02.028" v="289" actId="478"/>
          <ac:picMkLst>
            <pc:docMk/>
            <pc:sldMk cId="2029615342" sldId="259"/>
            <ac:picMk id="20" creationId="{BB81B00E-3771-F15B-975A-FCE9BA60F8B7}"/>
          </ac:picMkLst>
        </pc:picChg>
        <pc:cxnChg chg="mod">
          <ac:chgData name="Qinghe Meng" userId="8ec5781b-3938-43df-a84f-730d81e9a524" providerId="ADAL" clId="{28B8E620-2A74-45DD-9AF1-E710F37014A6}" dt="2023-03-07T21:28:22.762" v="282" actId="1076"/>
          <ac:cxnSpMkLst>
            <pc:docMk/>
            <pc:sldMk cId="2029615342" sldId="259"/>
            <ac:cxnSpMk id="13" creationId="{D514497C-A6DE-45A8-E40B-F3A3FEB0958E}"/>
          </ac:cxnSpMkLst>
        </pc:cxnChg>
        <pc:cxnChg chg="add mod">
          <ac:chgData name="Qinghe Meng" userId="8ec5781b-3938-43df-a84f-730d81e9a524" providerId="ADAL" clId="{28B8E620-2A74-45DD-9AF1-E710F37014A6}" dt="2023-03-07T21:32:19.440" v="339" actId="1076"/>
          <ac:cxnSpMkLst>
            <pc:docMk/>
            <pc:sldMk cId="2029615342" sldId="259"/>
            <ac:cxnSpMk id="16" creationId="{E02D87A4-5949-2591-0670-D71D497D1FAC}"/>
          </ac:cxnSpMkLst>
        </pc:cxnChg>
        <pc:cxnChg chg="add mod">
          <ac:chgData name="Qinghe Meng" userId="8ec5781b-3938-43df-a84f-730d81e9a524" providerId="ADAL" clId="{28B8E620-2A74-45DD-9AF1-E710F37014A6}" dt="2023-03-07T21:32:19.440" v="339" actId="1076"/>
          <ac:cxnSpMkLst>
            <pc:docMk/>
            <pc:sldMk cId="2029615342" sldId="259"/>
            <ac:cxnSpMk id="17" creationId="{816AA884-6DB3-F28D-70A7-4CF29856A87D}"/>
          </ac:cxnSpMkLst>
        </pc:cxnChg>
        <pc:cxnChg chg="mod">
          <ac:chgData name="Qinghe Meng" userId="8ec5781b-3938-43df-a84f-730d81e9a524" providerId="ADAL" clId="{28B8E620-2A74-45DD-9AF1-E710F37014A6}" dt="2023-03-07T21:30:46.841" v="311" actId="1076"/>
          <ac:cxnSpMkLst>
            <pc:docMk/>
            <pc:sldMk cId="2029615342" sldId="259"/>
            <ac:cxnSpMk id="21" creationId="{D47FC74E-FF67-290C-F018-305D5731FF48}"/>
          </ac:cxnSpMkLst>
        </pc:cxnChg>
        <pc:cxnChg chg="add mod">
          <ac:chgData name="Qinghe Meng" userId="8ec5781b-3938-43df-a84f-730d81e9a524" providerId="ADAL" clId="{28B8E620-2A74-45DD-9AF1-E710F37014A6}" dt="2023-03-07T21:32:26.689" v="341" actId="1076"/>
          <ac:cxnSpMkLst>
            <pc:docMk/>
            <pc:sldMk cId="2029615342" sldId="259"/>
            <ac:cxnSpMk id="23" creationId="{594C1189-9AD8-3585-FB2F-A43B2EBE2E22}"/>
          </ac:cxnSpMkLst>
        </pc:cxnChg>
        <pc:cxnChg chg="add mod">
          <ac:chgData name="Qinghe Meng" userId="8ec5781b-3938-43df-a84f-730d81e9a524" providerId="ADAL" clId="{28B8E620-2A74-45DD-9AF1-E710F37014A6}" dt="2023-03-07T21:32:26.689" v="341" actId="1076"/>
          <ac:cxnSpMkLst>
            <pc:docMk/>
            <pc:sldMk cId="2029615342" sldId="259"/>
            <ac:cxnSpMk id="24" creationId="{63758A1C-BF85-3E37-4683-D3314828F8FB}"/>
          </ac:cxnSpMkLst>
        </pc:cxnChg>
      </pc:sldChg>
      <pc:sldChg chg="addSp delSp modSp add mod">
        <pc:chgData name="Qinghe Meng" userId="8ec5781b-3938-43df-a84f-730d81e9a524" providerId="ADAL" clId="{28B8E620-2A74-45DD-9AF1-E710F37014A6}" dt="2023-03-07T21:50:49.680" v="561" actId="6549"/>
        <pc:sldMkLst>
          <pc:docMk/>
          <pc:sldMk cId="1195960701" sldId="260"/>
        </pc:sldMkLst>
        <pc:spChg chg="mod">
          <ac:chgData name="Qinghe Meng" userId="8ec5781b-3938-43df-a84f-730d81e9a524" providerId="ADAL" clId="{28B8E620-2A74-45DD-9AF1-E710F37014A6}" dt="2023-03-07T21:50:49.680" v="561" actId="6549"/>
          <ac:spMkLst>
            <pc:docMk/>
            <pc:sldMk cId="1195960701" sldId="260"/>
            <ac:spMk id="6" creationId="{5F43ACBE-7784-620B-7DE9-28F3500AA41B}"/>
          </ac:spMkLst>
        </pc:spChg>
        <pc:spChg chg="mod">
          <ac:chgData name="Qinghe Meng" userId="8ec5781b-3938-43df-a84f-730d81e9a524" providerId="ADAL" clId="{28B8E620-2A74-45DD-9AF1-E710F37014A6}" dt="2023-03-07T21:39:34.079" v="436" actId="1076"/>
          <ac:spMkLst>
            <pc:docMk/>
            <pc:sldMk cId="1195960701" sldId="260"/>
            <ac:spMk id="8" creationId="{56C7C46D-26B3-8966-23B4-73F80ABBF7EE}"/>
          </ac:spMkLst>
        </pc:spChg>
        <pc:spChg chg="mod">
          <ac:chgData name="Qinghe Meng" userId="8ec5781b-3938-43df-a84f-730d81e9a524" providerId="ADAL" clId="{28B8E620-2A74-45DD-9AF1-E710F37014A6}" dt="2023-03-07T21:36:21.948" v="405" actId="1076"/>
          <ac:spMkLst>
            <pc:docMk/>
            <pc:sldMk cId="1195960701" sldId="260"/>
            <ac:spMk id="9" creationId="{575D03C4-8917-71CF-8B44-80EA7D788907}"/>
          </ac:spMkLst>
        </pc:spChg>
        <pc:spChg chg="mod">
          <ac:chgData name="Qinghe Meng" userId="8ec5781b-3938-43df-a84f-730d81e9a524" providerId="ADAL" clId="{28B8E620-2A74-45DD-9AF1-E710F37014A6}" dt="2023-03-07T21:39:27.599" v="434" actId="1076"/>
          <ac:spMkLst>
            <pc:docMk/>
            <pc:sldMk cId="1195960701" sldId="260"/>
            <ac:spMk id="10" creationId="{7B5338E7-FFA2-7C90-12F2-82E06A82E6FB}"/>
          </ac:spMkLst>
        </pc:spChg>
        <pc:spChg chg="mod">
          <ac:chgData name="Qinghe Meng" userId="8ec5781b-3938-43df-a84f-730d81e9a524" providerId="ADAL" clId="{28B8E620-2A74-45DD-9AF1-E710F37014A6}" dt="2023-03-07T21:39:30.868" v="435" actId="1076"/>
          <ac:spMkLst>
            <pc:docMk/>
            <pc:sldMk cId="1195960701" sldId="260"/>
            <ac:spMk id="11" creationId="{D921206A-231E-0020-D196-92FEE916AAE8}"/>
          </ac:spMkLst>
        </pc:spChg>
        <pc:spChg chg="mod">
          <ac:chgData name="Qinghe Meng" userId="8ec5781b-3938-43df-a84f-730d81e9a524" providerId="ADAL" clId="{28B8E620-2A74-45DD-9AF1-E710F37014A6}" dt="2023-03-07T21:38:49.465" v="430" actId="6549"/>
          <ac:spMkLst>
            <pc:docMk/>
            <pc:sldMk cId="1195960701" sldId="260"/>
            <ac:spMk id="12" creationId="{679078DA-C4F6-5441-4EE1-B814696B77EC}"/>
          </ac:spMkLst>
        </pc:spChg>
        <pc:spChg chg="mod">
          <ac:chgData name="Qinghe Meng" userId="8ec5781b-3938-43df-a84f-730d81e9a524" providerId="ADAL" clId="{28B8E620-2A74-45DD-9AF1-E710F37014A6}" dt="2023-03-07T21:37:10.073" v="416" actId="6549"/>
          <ac:spMkLst>
            <pc:docMk/>
            <pc:sldMk cId="1195960701" sldId="260"/>
            <ac:spMk id="14" creationId="{776D6728-CC56-DB82-2A93-611FBE4B20B0}"/>
          </ac:spMkLst>
        </pc:spChg>
        <pc:spChg chg="add mod">
          <ac:chgData name="Qinghe Meng" userId="8ec5781b-3938-43df-a84f-730d81e9a524" providerId="ADAL" clId="{28B8E620-2A74-45DD-9AF1-E710F37014A6}" dt="2023-03-07T21:44:36.867" v="494" actId="14100"/>
          <ac:spMkLst>
            <pc:docMk/>
            <pc:sldMk cId="1195960701" sldId="260"/>
            <ac:spMk id="17" creationId="{F7230C47-C344-7B52-BAB6-095DD2A66DC7}"/>
          </ac:spMkLst>
        </pc:spChg>
        <pc:spChg chg="add mod">
          <ac:chgData name="Qinghe Meng" userId="8ec5781b-3938-43df-a84f-730d81e9a524" providerId="ADAL" clId="{28B8E620-2A74-45DD-9AF1-E710F37014A6}" dt="2023-03-07T21:45:25.121" v="504" actId="1076"/>
          <ac:spMkLst>
            <pc:docMk/>
            <pc:sldMk cId="1195960701" sldId="260"/>
            <ac:spMk id="20" creationId="{2CE60334-3C89-08D8-078A-355CA67C885D}"/>
          </ac:spMkLst>
        </pc:spChg>
        <pc:spChg chg="mod">
          <ac:chgData name="Qinghe Meng" userId="8ec5781b-3938-43df-a84f-730d81e9a524" providerId="ADAL" clId="{28B8E620-2A74-45DD-9AF1-E710F37014A6}" dt="2023-03-07T21:39:04.016" v="433" actId="1076"/>
          <ac:spMkLst>
            <pc:docMk/>
            <pc:sldMk cId="1195960701" sldId="260"/>
            <ac:spMk id="22" creationId="{6456644C-CED1-066B-4530-032B436F51C6}"/>
          </ac:spMkLst>
        </pc:spChg>
        <pc:spChg chg="add mod">
          <ac:chgData name="Qinghe Meng" userId="8ec5781b-3938-43df-a84f-730d81e9a524" providerId="ADAL" clId="{28B8E620-2A74-45DD-9AF1-E710F37014A6}" dt="2023-03-07T21:45:18.656" v="503" actId="1076"/>
          <ac:spMkLst>
            <pc:docMk/>
            <pc:sldMk cId="1195960701" sldId="260"/>
            <ac:spMk id="23" creationId="{D0894B9F-420C-2824-843A-57C194C3D7A2}"/>
          </ac:spMkLst>
        </pc:spChg>
        <pc:spChg chg="add mod">
          <ac:chgData name="Qinghe Meng" userId="8ec5781b-3938-43df-a84f-730d81e9a524" providerId="ADAL" clId="{28B8E620-2A74-45DD-9AF1-E710F37014A6}" dt="2023-03-07T21:46:08.756" v="511" actId="1076"/>
          <ac:spMkLst>
            <pc:docMk/>
            <pc:sldMk cId="1195960701" sldId="260"/>
            <ac:spMk id="30" creationId="{737CF8AB-4E84-5C4A-5F08-CF94A22842F7}"/>
          </ac:spMkLst>
        </pc:spChg>
        <pc:spChg chg="add mod">
          <ac:chgData name="Qinghe Meng" userId="8ec5781b-3938-43df-a84f-730d81e9a524" providerId="ADAL" clId="{28B8E620-2A74-45DD-9AF1-E710F37014A6}" dt="2023-03-07T21:46:03.820" v="510" actId="1076"/>
          <ac:spMkLst>
            <pc:docMk/>
            <pc:sldMk cId="1195960701" sldId="260"/>
            <ac:spMk id="31" creationId="{588EEE2E-D60A-64AC-9643-F0AE9BECBC52}"/>
          </ac:spMkLst>
        </pc:spChg>
        <pc:picChg chg="del">
          <ac:chgData name="Qinghe Meng" userId="8ec5781b-3938-43df-a84f-730d81e9a524" providerId="ADAL" clId="{28B8E620-2A74-45DD-9AF1-E710F37014A6}" dt="2023-03-07T21:31:37.242" v="331" actId="478"/>
          <ac:picMkLst>
            <pc:docMk/>
            <pc:sldMk cId="1195960701" sldId="260"/>
            <ac:picMk id="3" creationId="{59616DDD-C6B4-5098-7791-9F5AEFD16F97}"/>
          </ac:picMkLst>
        </pc:picChg>
        <pc:picChg chg="add mod">
          <ac:chgData name="Qinghe Meng" userId="8ec5781b-3938-43df-a84f-730d81e9a524" providerId="ADAL" clId="{28B8E620-2A74-45DD-9AF1-E710F37014A6}" dt="2023-03-07T21:45:50.664" v="508" actId="1076"/>
          <ac:picMkLst>
            <pc:docMk/>
            <pc:sldMk cId="1195960701" sldId="260"/>
            <ac:picMk id="4" creationId="{0B03D01C-867A-9746-69ED-3CA2B7C2B39A}"/>
          </ac:picMkLst>
        </pc:picChg>
        <pc:picChg chg="add mod">
          <ac:chgData name="Qinghe Meng" userId="8ec5781b-3938-43df-a84f-730d81e9a524" providerId="ADAL" clId="{28B8E620-2A74-45DD-9AF1-E710F37014A6}" dt="2023-03-07T21:38:02.974" v="423" actId="1076"/>
          <ac:picMkLst>
            <pc:docMk/>
            <pc:sldMk cId="1195960701" sldId="260"/>
            <ac:picMk id="7" creationId="{9107F4CA-3A2D-4614-3B6E-0699656E46DB}"/>
          </ac:picMkLst>
        </pc:picChg>
        <pc:picChg chg="del">
          <ac:chgData name="Qinghe Meng" userId="8ec5781b-3938-43df-a84f-730d81e9a524" providerId="ADAL" clId="{28B8E620-2A74-45DD-9AF1-E710F37014A6}" dt="2023-03-07T21:31:38.203" v="332" actId="478"/>
          <ac:picMkLst>
            <pc:docMk/>
            <pc:sldMk cId="1195960701" sldId="260"/>
            <ac:picMk id="15" creationId="{EC419AA0-6284-1F2E-4CAC-94F826B54B2B}"/>
          </ac:picMkLst>
        </pc:picChg>
        <pc:cxnChg chg="mod">
          <ac:chgData name="Qinghe Meng" userId="8ec5781b-3938-43df-a84f-730d81e9a524" providerId="ADAL" clId="{28B8E620-2A74-45DD-9AF1-E710F37014A6}" dt="2023-03-07T21:36:59.112" v="410" actId="1076"/>
          <ac:cxnSpMkLst>
            <pc:docMk/>
            <pc:sldMk cId="1195960701" sldId="260"/>
            <ac:cxnSpMk id="13" creationId="{D514497C-A6DE-45A8-E40B-F3A3FEB0958E}"/>
          </ac:cxnSpMkLst>
        </pc:cxnChg>
        <pc:cxnChg chg="add mod">
          <ac:chgData name="Qinghe Meng" userId="8ec5781b-3938-43df-a84f-730d81e9a524" providerId="ADAL" clId="{28B8E620-2A74-45DD-9AF1-E710F37014A6}" dt="2023-03-07T21:44:54.904" v="498" actId="14100"/>
          <ac:cxnSpMkLst>
            <pc:docMk/>
            <pc:sldMk cId="1195960701" sldId="260"/>
            <ac:cxnSpMk id="18" creationId="{7DBE0B8C-7964-82DD-5219-2EBB6828605F}"/>
          </ac:cxnSpMkLst>
        </pc:cxnChg>
        <pc:cxnChg chg="add mod">
          <ac:chgData name="Qinghe Meng" userId="8ec5781b-3938-43df-a84f-730d81e9a524" providerId="ADAL" clId="{28B8E620-2A74-45DD-9AF1-E710F37014A6}" dt="2023-03-07T21:45:01.016" v="500" actId="1076"/>
          <ac:cxnSpMkLst>
            <pc:docMk/>
            <pc:sldMk cId="1195960701" sldId="260"/>
            <ac:cxnSpMk id="19" creationId="{857B8940-E07E-EFA0-3E86-4678157EF9AD}"/>
          </ac:cxnSpMkLst>
        </pc:cxnChg>
        <pc:cxnChg chg="mod">
          <ac:chgData name="Qinghe Meng" userId="8ec5781b-3938-43df-a84f-730d81e9a524" providerId="ADAL" clId="{28B8E620-2A74-45DD-9AF1-E710F37014A6}" dt="2023-03-07T21:38:57.184" v="432" actId="1076"/>
          <ac:cxnSpMkLst>
            <pc:docMk/>
            <pc:sldMk cId="1195960701" sldId="260"/>
            <ac:cxnSpMk id="21" creationId="{D47FC74E-FF67-290C-F018-305D5731FF48}"/>
          </ac:cxnSpMkLst>
        </pc:cxnChg>
        <pc:cxnChg chg="add mod">
          <ac:chgData name="Qinghe Meng" userId="8ec5781b-3938-43df-a84f-730d81e9a524" providerId="ADAL" clId="{28B8E620-2A74-45DD-9AF1-E710F37014A6}" dt="2023-03-07T21:45:45.067" v="506" actId="1076"/>
          <ac:cxnSpMkLst>
            <pc:docMk/>
            <pc:sldMk cId="1195960701" sldId="260"/>
            <ac:cxnSpMk id="28" creationId="{7FEBDD86-9181-D529-FE49-0B2135758886}"/>
          </ac:cxnSpMkLst>
        </pc:cxnChg>
        <pc:cxnChg chg="add mod">
          <ac:chgData name="Qinghe Meng" userId="8ec5781b-3938-43df-a84f-730d81e9a524" providerId="ADAL" clId="{28B8E620-2A74-45DD-9AF1-E710F37014A6}" dt="2023-03-07T21:45:59.302" v="509" actId="1076"/>
          <ac:cxnSpMkLst>
            <pc:docMk/>
            <pc:sldMk cId="1195960701" sldId="260"/>
            <ac:cxnSpMk id="29" creationId="{FC07B4A3-A7EA-B0B5-7A04-0318A8EDEAF7}"/>
          </ac:cxnSpMkLst>
        </pc:cxnChg>
      </pc:sldChg>
      <pc:sldChg chg="addSp delSp modSp add mod">
        <pc:chgData name="Qinghe Meng" userId="8ec5781b-3938-43df-a84f-730d81e9a524" providerId="ADAL" clId="{28B8E620-2A74-45DD-9AF1-E710F37014A6}" dt="2023-03-08T13:55:15.016" v="984" actId="1076"/>
        <pc:sldMkLst>
          <pc:docMk/>
          <pc:sldMk cId="945282863" sldId="261"/>
        </pc:sldMkLst>
        <pc:spChg chg="mod">
          <ac:chgData name="Qinghe Meng" userId="8ec5781b-3938-43df-a84f-730d81e9a524" providerId="ADAL" clId="{28B8E620-2A74-45DD-9AF1-E710F37014A6}" dt="2023-03-07T21:50:53.409" v="563" actId="6549"/>
          <ac:spMkLst>
            <pc:docMk/>
            <pc:sldMk cId="945282863" sldId="261"/>
            <ac:spMk id="6" creationId="{5F43ACBE-7784-620B-7DE9-28F3500AA41B}"/>
          </ac:spMkLst>
        </pc:spChg>
        <pc:spChg chg="mod">
          <ac:chgData name="Qinghe Meng" userId="8ec5781b-3938-43df-a84f-730d81e9a524" providerId="ADAL" clId="{28B8E620-2A74-45DD-9AF1-E710F37014A6}" dt="2023-03-07T21:49:04.753" v="547" actId="20577"/>
          <ac:spMkLst>
            <pc:docMk/>
            <pc:sldMk cId="945282863" sldId="261"/>
            <ac:spMk id="8" creationId="{56C7C46D-26B3-8966-23B4-73F80ABBF7EE}"/>
          </ac:spMkLst>
        </pc:spChg>
        <pc:spChg chg="mod">
          <ac:chgData name="Qinghe Meng" userId="8ec5781b-3938-43df-a84f-730d81e9a524" providerId="ADAL" clId="{28B8E620-2A74-45DD-9AF1-E710F37014A6}" dt="2023-03-08T13:55:15.016" v="984" actId="1076"/>
          <ac:spMkLst>
            <pc:docMk/>
            <pc:sldMk cId="945282863" sldId="261"/>
            <ac:spMk id="10" creationId="{7B5338E7-FFA2-7C90-12F2-82E06A82E6FB}"/>
          </ac:spMkLst>
        </pc:spChg>
        <pc:spChg chg="mod">
          <ac:chgData name="Qinghe Meng" userId="8ec5781b-3938-43df-a84f-730d81e9a524" providerId="ADAL" clId="{28B8E620-2A74-45DD-9AF1-E710F37014A6}" dt="2023-03-07T21:48:47.313" v="536" actId="20577"/>
          <ac:spMkLst>
            <pc:docMk/>
            <pc:sldMk cId="945282863" sldId="261"/>
            <ac:spMk id="12" creationId="{679078DA-C4F6-5441-4EE1-B814696B77EC}"/>
          </ac:spMkLst>
        </pc:spChg>
        <pc:spChg chg="mod">
          <ac:chgData name="Qinghe Meng" userId="8ec5781b-3938-43df-a84f-730d81e9a524" providerId="ADAL" clId="{28B8E620-2A74-45DD-9AF1-E710F37014A6}" dt="2023-03-07T21:43:13.828" v="482" actId="20577"/>
          <ac:spMkLst>
            <pc:docMk/>
            <pc:sldMk cId="945282863" sldId="261"/>
            <ac:spMk id="14" creationId="{776D6728-CC56-DB82-2A93-611FBE4B20B0}"/>
          </ac:spMkLst>
        </pc:spChg>
        <pc:spChg chg="add mod">
          <ac:chgData name="Qinghe Meng" userId="8ec5781b-3938-43df-a84f-730d81e9a524" providerId="ADAL" clId="{28B8E620-2A74-45DD-9AF1-E710F37014A6}" dt="2023-03-07T21:47:04.901" v="520" actId="1076"/>
          <ac:spMkLst>
            <pc:docMk/>
            <pc:sldMk cId="945282863" sldId="261"/>
            <ac:spMk id="16" creationId="{C8E21B0C-1F51-0BBF-CB52-C64CEAF7DFC0}"/>
          </ac:spMkLst>
        </pc:spChg>
        <pc:spChg chg="mod">
          <ac:chgData name="Qinghe Meng" userId="8ec5781b-3938-43df-a84f-730d81e9a524" providerId="ADAL" clId="{28B8E620-2A74-45DD-9AF1-E710F37014A6}" dt="2023-03-07T21:46:25.634" v="515" actId="14100"/>
          <ac:spMkLst>
            <pc:docMk/>
            <pc:sldMk cId="945282863" sldId="261"/>
            <ac:spMk id="17" creationId="{F7230C47-C344-7B52-BAB6-095DD2A66DC7}"/>
          </ac:spMkLst>
        </pc:spChg>
        <pc:spChg chg="add mod">
          <ac:chgData name="Qinghe Meng" userId="8ec5781b-3938-43df-a84f-730d81e9a524" providerId="ADAL" clId="{28B8E620-2A74-45DD-9AF1-E710F37014A6}" dt="2023-03-07T21:47:08.001" v="521" actId="1076"/>
          <ac:spMkLst>
            <pc:docMk/>
            <pc:sldMk cId="945282863" sldId="261"/>
            <ac:spMk id="18" creationId="{50DCF701-70C2-3DD8-6D82-BF521B9062FA}"/>
          </ac:spMkLst>
        </pc:spChg>
        <pc:spChg chg="mod">
          <ac:chgData name="Qinghe Meng" userId="8ec5781b-3938-43df-a84f-730d81e9a524" providerId="ADAL" clId="{28B8E620-2A74-45DD-9AF1-E710F37014A6}" dt="2023-03-07T21:48:58.594" v="540" actId="20577"/>
          <ac:spMkLst>
            <pc:docMk/>
            <pc:sldMk cId="945282863" sldId="261"/>
            <ac:spMk id="22" creationId="{6456644C-CED1-066B-4530-032B436F51C6}"/>
          </ac:spMkLst>
        </pc:spChg>
        <pc:spChg chg="add mod">
          <ac:chgData name="Qinghe Meng" userId="8ec5781b-3938-43df-a84f-730d81e9a524" providerId="ADAL" clId="{28B8E620-2A74-45DD-9AF1-E710F37014A6}" dt="2023-03-07T21:49:26.763" v="549" actId="1076"/>
          <ac:spMkLst>
            <pc:docMk/>
            <pc:sldMk cId="945282863" sldId="261"/>
            <ac:spMk id="25" creationId="{9EFC4EF1-5785-F627-E842-BB3333FA9B4E}"/>
          </ac:spMkLst>
        </pc:spChg>
        <pc:spChg chg="add mod">
          <ac:chgData name="Qinghe Meng" userId="8ec5781b-3938-43df-a84f-730d81e9a524" providerId="ADAL" clId="{28B8E620-2A74-45DD-9AF1-E710F37014A6}" dt="2023-03-07T21:49:26.763" v="549" actId="1076"/>
          <ac:spMkLst>
            <pc:docMk/>
            <pc:sldMk cId="945282863" sldId="261"/>
            <ac:spMk id="26" creationId="{4BDE884C-ECA0-996D-56F9-788FB4B4BB10}"/>
          </ac:spMkLst>
        </pc:spChg>
        <pc:picChg chg="add mod">
          <ac:chgData name="Qinghe Meng" userId="8ec5781b-3938-43df-a84f-730d81e9a524" providerId="ADAL" clId="{28B8E620-2A74-45DD-9AF1-E710F37014A6}" dt="2023-03-07T21:42:49.088" v="473" actId="1076"/>
          <ac:picMkLst>
            <pc:docMk/>
            <pc:sldMk cId="945282863" sldId="261"/>
            <ac:picMk id="3" creationId="{49A5DC5C-C829-52AB-2135-3D369899A708}"/>
          </ac:picMkLst>
        </pc:picChg>
        <pc:picChg chg="del">
          <ac:chgData name="Qinghe Meng" userId="8ec5781b-3938-43df-a84f-730d81e9a524" providerId="ADAL" clId="{28B8E620-2A74-45DD-9AF1-E710F37014A6}" dt="2023-03-07T21:41:45.876" v="459" actId="478"/>
          <ac:picMkLst>
            <pc:docMk/>
            <pc:sldMk cId="945282863" sldId="261"/>
            <ac:picMk id="4" creationId="{0B03D01C-867A-9746-69ED-3CA2B7C2B39A}"/>
          </ac:picMkLst>
        </pc:picChg>
        <pc:picChg chg="del">
          <ac:chgData name="Qinghe Meng" userId="8ec5781b-3938-43df-a84f-730d81e9a524" providerId="ADAL" clId="{28B8E620-2A74-45DD-9AF1-E710F37014A6}" dt="2023-03-07T21:42:30.916" v="472" actId="478"/>
          <ac:picMkLst>
            <pc:docMk/>
            <pc:sldMk cId="945282863" sldId="261"/>
            <ac:picMk id="7" creationId="{9107F4CA-3A2D-4614-3B6E-0699656E46DB}"/>
          </ac:picMkLst>
        </pc:picChg>
        <pc:picChg chg="add mod">
          <ac:chgData name="Qinghe Meng" userId="8ec5781b-3938-43df-a84f-730d81e9a524" providerId="ADAL" clId="{28B8E620-2A74-45DD-9AF1-E710F37014A6}" dt="2023-03-07T21:48:41.378" v="533" actId="1076"/>
          <ac:picMkLst>
            <pc:docMk/>
            <pc:sldMk cId="945282863" sldId="261"/>
            <ac:picMk id="20" creationId="{F31C82C9-627F-48D0-FA2A-682108109A65}"/>
          </ac:picMkLst>
        </pc:picChg>
        <pc:cxnChg chg="add mod">
          <ac:chgData name="Qinghe Meng" userId="8ec5781b-3938-43df-a84f-730d81e9a524" providerId="ADAL" clId="{28B8E620-2A74-45DD-9AF1-E710F37014A6}" dt="2023-03-07T21:47:00.858" v="518" actId="1076"/>
          <ac:cxnSpMkLst>
            <pc:docMk/>
            <pc:sldMk cId="945282863" sldId="261"/>
            <ac:cxnSpMk id="5" creationId="{90C1534C-6C95-D3BF-E438-19510A2F6847}"/>
          </ac:cxnSpMkLst>
        </pc:cxnChg>
        <pc:cxnChg chg="mod">
          <ac:chgData name="Qinghe Meng" userId="8ec5781b-3938-43df-a84f-730d81e9a524" providerId="ADAL" clId="{28B8E620-2A74-45DD-9AF1-E710F37014A6}" dt="2023-03-07T21:42:57.051" v="475" actId="1076"/>
          <ac:cxnSpMkLst>
            <pc:docMk/>
            <pc:sldMk cId="945282863" sldId="261"/>
            <ac:cxnSpMk id="13" creationId="{D514497C-A6DE-45A8-E40B-F3A3FEB0958E}"/>
          </ac:cxnSpMkLst>
        </pc:cxnChg>
        <pc:cxnChg chg="add mod">
          <ac:chgData name="Qinghe Meng" userId="8ec5781b-3938-43df-a84f-730d81e9a524" providerId="ADAL" clId="{28B8E620-2A74-45DD-9AF1-E710F37014A6}" dt="2023-03-07T21:47:02.667" v="519" actId="1076"/>
          <ac:cxnSpMkLst>
            <pc:docMk/>
            <pc:sldMk cId="945282863" sldId="261"/>
            <ac:cxnSpMk id="15" creationId="{257397E5-772D-EE5B-DA80-26ACA315F035}"/>
          </ac:cxnSpMkLst>
        </pc:cxnChg>
        <pc:cxnChg chg="mod">
          <ac:chgData name="Qinghe Meng" userId="8ec5781b-3938-43df-a84f-730d81e9a524" providerId="ADAL" clId="{28B8E620-2A74-45DD-9AF1-E710F37014A6}" dt="2023-03-07T21:48:53.472" v="537" actId="1076"/>
          <ac:cxnSpMkLst>
            <pc:docMk/>
            <pc:sldMk cId="945282863" sldId="261"/>
            <ac:cxnSpMk id="21" creationId="{D47FC74E-FF67-290C-F018-305D5731FF48}"/>
          </ac:cxnSpMkLst>
        </pc:cxnChg>
        <pc:cxnChg chg="add mod">
          <ac:chgData name="Qinghe Meng" userId="8ec5781b-3938-43df-a84f-730d81e9a524" providerId="ADAL" clId="{28B8E620-2A74-45DD-9AF1-E710F37014A6}" dt="2023-03-07T21:49:26.763" v="549" actId="1076"/>
          <ac:cxnSpMkLst>
            <pc:docMk/>
            <pc:sldMk cId="945282863" sldId="261"/>
            <ac:cxnSpMk id="23" creationId="{38FFC826-DF1F-9A80-E3CD-F7EA39AC7E43}"/>
          </ac:cxnSpMkLst>
        </pc:cxnChg>
        <pc:cxnChg chg="add mod">
          <ac:chgData name="Qinghe Meng" userId="8ec5781b-3938-43df-a84f-730d81e9a524" providerId="ADAL" clId="{28B8E620-2A74-45DD-9AF1-E710F37014A6}" dt="2023-03-07T21:49:26.763" v="549" actId="1076"/>
          <ac:cxnSpMkLst>
            <pc:docMk/>
            <pc:sldMk cId="945282863" sldId="261"/>
            <ac:cxnSpMk id="24" creationId="{54058631-9AA2-FF61-3988-51F4900357DE}"/>
          </ac:cxnSpMkLst>
        </pc:cxnChg>
      </pc:sldChg>
      <pc:sldChg chg="addSp delSp modSp add mod">
        <pc:chgData name="Qinghe Meng" userId="8ec5781b-3938-43df-a84f-730d81e9a524" providerId="ADAL" clId="{28B8E620-2A74-45DD-9AF1-E710F37014A6}" dt="2023-03-17T18:58:53.479" v="1089" actId="1076"/>
        <pc:sldMkLst>
          <pc:docMk/>
          <pc:sldMk cId="495224942" sldId="262"/>
        </pc:sldMkLst>
        <pc:spChg chg="mod">
          <ac:chgData name="Qinghe Meng" userId="8ec5781b-3938-43df-a84f-730d81e9a524" providerId="ADAL" clId="{28B8E620-2A74-45DD-9AF1-E710F37014A6}" dt="2023-03-07T21:57:48.253" v="677" actId="20577"/>
          <ac:spMkLst>
            <pc:docMk/>
            <pc:sldMk cId="495224942" sldId="262"/>
            <ac:spMk id="6" creationId="{5F43ACBE-7784-620B-7DE9-28F3500AA41B}"/>
          </ac:spMkLst>
        </pc:spChg>
        <pc:spChg chg="mod">
          <ac:chgData name="Qinghe Meng" userId="8ec5781b-3938-43df-a84f-730d81e9a524" providerId="ADAL" clId="{28B8E620-2A74-45DD-9AF1-E710F37014A6}" dt="2023-03-07T21:56:34.094" v="663" actId="6549"/>
          <ac:spMkLst>
            <pc:docMk/>
            <pc:sldMk cId="495224942" sldId="262"/>
            <ac:spMk id="9" creationId="{575D03C4-8917-71CF-8B44-80EA7D788907}"/>
          </ac:spMkLst>
        </pc:spChg>
        <pc:spChg chg="mod">
          <ac:chgData name="Qinghe Meng" userId="8ec5781b-3938-43df-a84f-730d81e9a524" providerId="ADAL" clId="{28B8E620-2A74-45DD-9AF1-E710F37014A6}" dt="2023-03-07T21:56:40.989" v="664" actId="1076"/>
          <ac:spMkLst>
            <pc:docMk/>
            <pc:sldMk cId="495224942" sldId="262"/>
            <ac:spMk id="10" creationId="{7B5338E7-FFA2-7C90-12F2-82E06A82E6FB}"/>
          </ac:spMkLst>
        </pc:spChg>
        <pc:spChg chg="mod">
          <ac:chgData name="Qinghe Meng" userId="8ec5781b-3938-43df-a84f-730d81e9a524" providerId="ADAL" clId="{28B8E620-2A74-45DD-9AF1-E710F37014A6}" dt="2023-03-07T22:00:55.421" v="715" actId="1076"/>
          <ac:spMkLst>
            <pc:docMk/>
            <pc:sldMk cId="495224942" sldId="262"/>
            <ac:spMk id="11" creationId="{D921206A-231E-0020-D196-92FEE916AAE8}"/>
          </ac:spMkLst>
        </pc:spChg>
        <pc:spChg chg="mod">
          <ac:chgData name="Qinghe Meng" userId="8ec5781b-3938-43df-a84f-730d81e9a524" providerId="ADAL" clId="{28B8E620-2A74-45DD-9AF1-E710F37014A6}" dt="2023-03-17T18:57:36.920" v="1069" actId="20577"/>
          <ac:spMkLst>
            <pc:docMk/>
            <pc:sldMk cId="495224942" sldId="262"/>
            <ac:spMk id="12" creationId="{679078DA-C4F6-5441-4EE1-B814696B77EC}"/>
          </ac:spMkLst>
        </pc:spChg>
        <pc:spChg chg="add mod">
          <ac:chgData name="Qinghe Meng" userId="8ec5781b-3938-43df-a84f-730d81e9a524" providerId="ADAL" clId="{28B8E620-2A74-45DD-9AF1-E710F37014A6}" dt="2023-03-17T18:58:50.883" v="1088" actId="1076"/>
          <ac:spMkLst>
            <pc:docMk/>
            <pc:sldMk cId="495224942" sldId="262"/>
            <ac:spMk id="14" creationId="{5EF1FB7B-90A7-579B-0F24-46DC607DDF26}"/>
          </ac:spMkLst>
        </pc:spChg>
        <pc:spChg chg="del mod">
          <ac:chgData name="Qinghe Meng" userId="8ec5781b-3938-43df-a84f-730d81e9a524" providerId="ADAL" clId="{28B8E620-2A74-45DD-9AF1-E710F37014A6}" dt="2023-03-07T21:53:29.086" v="609" actId="478"/>
          <ac:spMkLst>
            <pc:docMk/>
            <pc:sldMk cId="495224942" sldId="262"/>
            <ac:spMk id="14" creationId="{776D6728-CC56-DB82-2A93-611FBE4B20B0}"/>
          </ac:spMkLst>
        </pc:spChg>
        <pc:spChg chg="add mod">
          <ac:chgData name="Qinghe Meng" userId="8ec5781b-3938-43df-a84f-730d81e9a524" providerId="ADAL" clId="{28B8E620-2A74-45DD-9AF1-E710F37014A6}" dt="2023-03-17T18:58:46.085" v="1086" actId="1076"/>
          <ac:spMkLst>
            <pc:docMk/>
            <pc:sldMk cId="495224942" sldId="262"/>
            <ac:spMk id="15" creationId="{1CADF086-E58F-157D-335D-4FB7846071EB}"/>
          </ac:spMkLst>
        </pc:spChg>
        <pc:spChg chg="add mod">
          <ac:chgData name="Qinghe Meng" userId="8ec5781b-3938-43df-a84f-730d81e9a524" providerId="ADAL" clId="{28B8E620-2A74-45DD-9AF1-E710F37014A6}" dt="2023-03-17T18:58:53.479" v="1089" actId="1076"/>
          <ac:spMkLst>
            <pc:docMk/>
            <pc:sldMk cId="495224942" sldId="262"/>
            <ac:spMk id="16" creationId="{A096ED58-6602-6573-9773-9FD4AC070A01}"/>
          </ac:spMkLst>
        </pc:spChg>
        <pc:spChg chg="del mod">
          <ac:chgData name="Qinghe Meng" userId="8ec5781b-3938-43df-a84f-730d81e9a524" providerId="ADAL" clId="{28B8E620-2A74-45DD-9AF1-E710F37014A6}" dt="2023-03-07T21:54:22.095" v="626" actId="478"/>
          <ac:spMkLst>
            <pc:docMk/>
            <pc:sldMk cId="495224942" sldId="262"/>
            <ac:spMk id="16" creationId="{C8E21B0C-1F51-0BBF-CB52-C64CEAF7DFC0}"/>
          </ac:spMkLst>
        </pc:spChg>
        <pc:spChg chg="add mod">
          <ac:chgData name="Qinghe Meng" userId="8ec5781b-3938-43df-a84f-730d81e9a524" providerId="ADAL" clId="{28B8E620-2A74-45DD-9AF1-E710F37014A6}" dt="2023-03-17T18:58:48.345" v="1087" actId="1076"/>
          <ac:spMkLst>
            <pc:docMk/>
            <pc:sldMk cId="495224942" sldId="262"/>
            <ac:spMk id="18" creationId="{362E3ACE-3896-197C-B234-12C5435B1EF0}"/>
          </ac:spMkLst>
        </pc:spChg>
        <pc:spChg chg="del mod">
          <ac:chgData name="Qinghe Meng" userId="8ec5781b-3938-43df-a84f-730d81e9a524" providerId="ADAL" clId="{28B8E620-2A74-45DD-9AF1-E710F37014A6}" dt="2023-03-07T21:54:20.783" v="625" actId="478"/>
          <ac:spMkLst>
            <pc:docMk/>
            <pc:sldMk cId="495224942" sldId="262"/>
            <ac:spMk id="18" creationId="{50DCF701-70C2-3DD8-6D82-BF521B9062FA}"/>
          </ac:spMkLst>
        </pc:spChg>
        <pc:spChg chg="del">
          <ac:chgData name="Qinghe Meng" userId="8ec5781b-3938-43df-a84f-730d81e9a524" providerId="ADAL" clId="{28B8E620-2A74-45DD-9AF1-E710F37014A6}" dt="2023-03-07T21:54:40.349" v="634" actId="478"/>
          <ac:spMkLst>
            <pc:docMk/>
            <pc:sldMk cId="495224942" sldId="262"/>
            <ac:spMk id="22" creationId="{6456644C-CED1-066B-4530-032B436F51C6}"/>
          </ac:spMkLst>
        </pc:spChg>
        <pc:spChg chg="del">
          <ac:chgData name="Qinghe Meng" userId="8ec5781b-3938-43df-a84f-730d81e9a524" providerId="ADAL" clId="{28B8E620-2A74-45DD-9AF1-E710F37014A6}" dt="2023-03-07T21:54:40.349" v="634" actId="478"/>
          <ac:spMkLst>
            <pc:docMk/>
            <pc:sldMk cId="495224942" sldId="262"/>
            <ac:spMk id="25" creationId="{9EFC4EF1-5785-F627-E842-BB3333FA9B4E}"/>
          </ac:spMkLst>
        </pc:spChg>
        <pc:spChg chg="del">
          <ac:chgData name="Qinghe Meng" userId="8ec5781b-3938-43df-a84f-730d81e9a524" providerId="ADAL" clId="{28B8E620-2A74-45DD-9AF1-E710F37014A6}" dt="2023-03-07T21:54:40.349" v="634" actId="478"/>
          <ac:spMkLst>
            <pc:docMk/>
            <pc:sldMk cId="495224942" sldId="262"/>
            <ac:spMk id="26" creationId="{4BDE884C-ECA0-996D-56F9-788FB4B4BB10}"/>
          </ac:spMkLst>
        </pc:spChg>
        <pc:spChg chg="add del mod">
          <ac:chgData name="Qinghe Meng" userId="8ec5781b-3938-43df-a84f-730d81e9a524" providerId="ADAL" clId="{28B8E620-2A74-45DD-9AF1-E710F37014A6}" dt="2023-03-07T21:55:45.086" v="651" actId="478"/>
          <ac:spMkLst>
            <pc:docMk/>
            <pc:sldMk cId="495224942" sldId="262"/>
            <ac:spMk id="27" creationId="{D002C2EC-482A-780E-B8D9-308FDBDB6FB1}"/>
          </ac:spMkLst>
        </pc:spChg>
        <pc:spChg chg="add del mod">
          <ac:chgData name="Qinghe Meng" userId="8ec5781b-3938-43df-a84f-730d81e9a524" providerId="ADAL" clId="{28B8E620-2A74-45DD-9AF1-E710F37014A6}" dt="2023-03-07T21:55:45.086" v="651" actId="478"/>
          <ac:spMkLst>
            <pc:docMk/>
            <pc:sldMk cId="495224942" sldId="262"/>
            <ac:spMk id="33" creationId="{679B4805-9995-8860-B8DA-F6F80A7B2FB5}"/>
          </ac:spMkLst>
        </pc:spChg>
        <pc:spChg chg="add del mod">
          <ac:chgData name="Qinghe Meng" userId="8ec5781b-3938-43df-a84f-730d81e9a524" providerId="ADAL" clId="{28B8E620-2A74-45DD-9AF1-E710F37014A6}" dt="2023-03-07T21:55:45.086" v="651" actId="478"/>
          <ac:spMkLst>
            <pc:docMk/>
            <pc:sldMk cId="495224942" sldId="262"/>
            <ac:spMk id="34" creationId="{99943CC7-CA42-E49F-F37E-B3C2FB71F96C}"/>
          </ac:spMkLst>
        </pc:spChg>
        <pc:spChg chg="add mod">
          <ac:chgData name="Qinghe Meng" userId="8ec5781b-3938-43df-a84f-730d81e9a524" providerId="ADAL" clId="{28B8E620-2A74-45DD-9AF1-E710F37014A6}" dt="2023-03-07T22:03:46.435" v="751" actId="1076"/>
          <ac:spMkLst>
            <pc:docMk/>
            <pc:sldMk cId="495224942" sldId="262"/>
            <ac:spMk id="43" creationId="{CBD35D97-F00D-326D-B0D7-696817961A50}"/>
          </ac:spMkLst>
        </pc:spChg>
        <pc:spChg chg="add mod">
          <ac:chgData name="Qinghe Meng" userId="8ec5781b-3938-43df-a84f-730d81e9a524" providerId="ADAL" clId="{28B8E620-2A74-45DD-9AF1-E710F37014A6}" dt="2023-03-07T22:03:50.079" v="752" actId="1076"/>
          <ac:spMkLst>
            <pc:docMk/>
            <pc:sldMk cId="495224942" sldId="262"/>
            <ac:spMk id="45" creationId="{C230ABDE-A96E-D6EF-857A-2630182E6298}"/>
          </ac:spMkLst>
        </pc:spChg>
        <pc:spChg chg="add mod">
          <ac:chgData name="Qinghe Meng" userId="8ec5781b-3938-43df-a84f-730d81e9a524" providerId="ADAL" clId="{28B8E620-2A74-45DD-9AF1-E710F37014A6}" dt="2023-03-07T22:03:57.200" v="755" actId="1076"/>
          <ac:spMkLst>
            <pc:docMk/>
            <pc:sldMk cId="495224942" sldId="262"/>
            <ac:spMk id="46" creationId="{1C4C75CC-2BC0-A01E-301E-4A3D088B11A5}"/>
          </ac:spMkLst>
        </pc:spChg>
        <pc:spChg chg="add mod">
          <ac:chgData name="Qinghe Meng" userId="8ec5781b-3938-43df-a84f-730d81e9a524" providerId="ADAL" clId="{28B8E620-2A74-45DD-9AF1-E710F37014A6}" dt="2023-03-07T22:03:54.717" v="754" actId="1076"/>
          <ac:spMkLst>
            <pc:docMk/>
            <pc:sldMk cId="495224942" sldId="262"/>
            <ac:spMk id="47" creationId="{96335ED7-140B-F872-C7BA-886E8C53AF22}"/>
          </ac:spMkLst>
        </pc:spChg>
        <pc:spChg chg="add del mod">
          <ac:chgData name="Qinghe Meng" userId="8ec5781b-3938-43df-a84f-730d81e9a524" providerId="ADAL" clId="{28B8E620-2A74-45DD-9AF1-E710F37014A6}" dt="2023-03-17T18:57:03.668" v="1060" actId="21"/>
          <ac:spMkLst>
            <pc:docMk/>
            <pc:sldMk cId="495224942" sldId="262"/>
            <ac:spMk id="54" creationId="{9629FB93-94FD-DCDB-6EFC-08E56D98BCC8}"/>
          </ac:spMkLst>
        </pc:spChg>
        <pc:spChg chg="add del mod">
          <ac:chgData name="Qinghe Meng" userId="8ec5781b-3938-43df-a84f-730d81e9a524" providerId="ADAL" clId="{28B8E620-2A74-45DD-9AF1-E710F37014A6}" dt="2023-03-17T18:57:03.668" v="1060" actId="21"/>
          <ac:spMkLst>
            <pc:docMk/>
            <pc:sldMk cId="495224942" sldId="262"/>
            <ac:spMk id="55" creationId="{A6A959D2-28A9-ADD7-4CED-306C9EFA8FCF}"/>
          </ac:spMkLst>
        </pc:spChg>
        <pc:spChg chg="add del mod">
          <ac:chgData name="Qinghe Meng" userId="8ec5781b-3938-43df-a84f-730d81e9a524" providerId="ADAL" clId="{28B8E620-2A74-45DD-9AF1-E710F37014A6}" dt="2023-03-17T18:57:03.668" v="1060" actId="21"/>
          <ac:spMkLst>
            <pc:docMk/>
            <pc:sldMk cId="495224942" sldId="262"/>
            <ac:spMk id="56" creationId="{E6499843-5C61-7F7F-3029-0E4B6EF45EF5}"/>
          </ac:spMkLst>
        </pc:spChg>
        <pc:spChg chg="add del mod">
          <ac:chgData name="Qinghe Meng" userId="8ec5781b-3938-43df-a84f-730d81e9a524" providerId="ADAL" clId="{28B8E620-2A74-45DD-9AF1-E710F37014A6}" dt="2023-03-17T18:57:03.668" v="1060" actId="21"/>
          <ac:spMkLst>
            <pc:docMk/>
            <pc:sldMk cId="495224942" sldId="262"/>
            <ac:spMk id="57" creationId="{3565A83E-928D-C50E-D269-F432CFC333F2}"/>
          </ac:spMkLst>
        </pc:spChg>
        <pc:spChg chg="add mod">
          <ac:chgData name="Qinghe Meng" userId="8ec5781b-3938-43df-a84f-730d81e9a524" providerId="ADAL" clId="{28B8E620-2A74-45DD-9AF1-E710F37014A6}" dt="2023-03-07T22:00:38.927" v="712" actId="1076"/>
          <ac:spMkLst>
            <pc:docMk/>
            <pc:sldMk cId="495224942" sldId="262"/>
            <ac:spMk id="59" creationId="{4A22D417-1872-3B77-8A68-F2E5B65B7CA7}"/>
          </ac:spMkLst>
        </pc:spChg>
        <pc:spChg chg="add mod">
          <ac:chgData name="Qinghe Meng" userId="8ec5781b-3938-43df-a84f-730d81e9a524" providerId="ADAL" clId="{28B8E620-2A74-45DD-9AF1-E710F37014A6}" dt="2023-03-17T18:57:45.242" v="1070" actId="1076"/>
          <ac:spMkLst>
            <pc:docMk/>
            <pc:sldMk cId="495224942" sldId="262"/>
            <ac:spMk id="61" creationId="{89FC8300-005F-D839-A0B2-239EDEACFEDB}"/>
          </ac:spMkLst>
        </pc:spChg>
        <pc:picChg chg="del">
          <ac:chgData name="Qinghe Meng" userId="8ec5781b-3938-43df-a84f-730d81e9a524" providerId="ADAL" clId="{28B8E620-2A74-45DD-9AF1-E710F37014A6}" dt="2023-03-07T21:49:56.560" v="551" actId="478"/>
          <ac:picMkLst>
            <pc:docMk/>
            <pc:sldMk cId="495224942" sldId="262"/>
            <ac:picMk id="3" creationId="{49A5DC5C-C829-52AB-2135-3D369899A708}"/>
          </ac:picMkLst>
        </pc:picChg>
        <pc:picChg chg="add mod">
          <ac:chgData name="Qinghe Meng" userId="8ec5781b-3938-43df-a84f-730d81e9a524" providerId="ADAL" clId="{28B8E620-2A74-45DD-9AF1-E710F37014A6}" dt="2023-03-17T18:58:12.373" v="1075" actId="1076"/>
          <ac:picMkLst>
            <pc:docMk/>
            <pc:sldMk cId="495224942" sldId="262"/>
            <ac:picMk id="3" creationId="{D0C0DE40-9677-B095-C11E-87AF0AFE321A}"/>
          </ac:picMkLst>
        </pc:picChg>
        <pc:picChg chg="add del mod">
          <ac:chgData name="Qinghe Meng" userId="8ec5781b-3938-43df-a84f-730d81e9a524" providerId="ADAL" clId="{28B8E620-2A74-45DD-9AF1-E710F37014A6}" dt="2023-03-07T21:55:42.845" v="650" actId="478"/>
          <ac:picMkLst>
            <pc:docMk/>
            <pc:sldMk cId="495224942" sldId="262"/>
            <ac:picMk id="4" creationId="{5D4F6C32-EEF4-1BEB-E085-3E17DFB0CC5E}"/>
          </ac:picMkLst>
        </pc:picChg>
        <pc:picChg chg="del">
          <ac:chgData name="Qinghe Meng" userId="8ec5781b-3938-43df-a84f-730d81e9a524" providerId="ADAL" clId="{28B8E620-2A74-45DD-9AF1-E710F37014A6}" dt="2023-03-07T21:51:12.431" v="573" actId="478"/>
          <ac:picMkLst>
            <pc:docMk/>
            <pc:sldMk cId="495224942" sldId="262"/>
            <ac:picMk id="20" creationId="{F31C82C9-627F-48D0-FA2A-682108109A65}"/>
          </ac:picMkLst>
        </pc:picChg>
        <pc:picChg chg="add mod">
          <ac:chgData name="Qinghe Meng" userId="8ec5781b-3938-43df-a84f-730d81e9a524" providerId="ADAL" clId="{28B8E620-2A74-45DD-9AF1-E710F37014A6}" dt="2023-03-07T22:01:39.271" v="723" actId="1076"/>
          <ac:picMkLst>
            <pc:docMk/>
            <pc:sldMk cId="495224942" sldId="262"/>
            <ac:picMk id="36" creationId="{F4C428FB-1F8A-7278-F1A2-AC03384A5255}"/>
          </ac:picMkLst>
        </pc:picChg>
        <pc:picChg chg="add del mod">
          <ac:chgData name="Qinghe Meng" userId="8ec5781b-3938-43df-a84f-730d81e9a524" providerId="ADAL" clId="{28B8E620-2A74-45DD-9AF1-E710F37014A6}" dt="2023-03-07T21:58:09.398" v="681"/>
          <ac:picMkLst>
            <pc:docMk/>
            <pc:sldMk cId="495224942" sldId="262"/>
            <ac:picMk id="44" creationId="{FDFFF034-2603-8477-F3EC-7F7D5B526CCA}"/>
          </ac:picMkLst>
        </pc:picChg>
        <pc:picChg chg="add del mod">
          <ac:chgData name="Qinghe Meng" userId="8ec5781b-3938-43df-a84f-730d81e9a524" providerId="ADAL" clId="{28B8E620-2A74-45DD-9AF1-E710F37014A6}" dt="2023-03-17T18:56:52.728" v="1058" actId="478"/>
          <ac:picMkLst>
            <pc:docMk/>
            <pc:sldMk cId="495224942" sldId="262"/>
            <ac:picMk id="49" creationId="{89897620-F585-E9B5-B26C-BD098138A6AB}"/>
          </ac:picMkLst>
        </pc:picChg>
        <pc:cxnChg chg="add mod">
          <ac:chgData name="Qinghe Meng" userId="8ec5781b-3938-43df-a84f-730d81e9a524" providerId="ADAL" clId="{28B8E620-2A74-45DD-9AF1-E710F37014A6}" dt="2023-03-17T18:58:36.750" v="1081" actId="1076"/>
          <ac:cxnSpMkLst>
            <pc:docMk/>
            <pc:sldMk cId="495224942" sldId="262"/>
            <ac:cxnSpMk id="4" creationId="{8E235063-6411-9569-E80C-F057FB7A104D}"/>
          </ac:cxnSpMkLst>
        </pc:cxnChg>
        <pc:cxnChg chg="add mod">
          <ac:chgData name="Qinghe Meng" userId="8ec5781b-3938-43df-a84f-730d81e9a524" providerId="ADAL" clId="{28B8E620-2A74-45DD-9AF1-E710F37014A6}" dt="2023-03-17T18:58:38.355" v="1082" actId="1076"/>
          <ac:cxnSpMkLst>
            <pc:docMk/>
            <pc:sldMk cId="495224942" sldId="262"/>
            <ac:cxnSpMk id="5" creationId="{4AAD85F2-BC09-6615-5338-AC2CA3D9EEAB}"/>
          </ac:cxnSpMkLst>
        </pc:cxnChg>
        <pc:cxnChg chg="del mod">
          <ac:chgData name="Qinghe Meng" userId="8ec5781b-3938-43df-a84f-730d81e9a524" providerId="ADAL" clId="{28B8E620-2A74-45DD-9AF1-E710F37014A6}" dt="2023-03-07T21:54:23.741" v="628" actId="478"/>
          <ac:cxnSpMkLst>
            <pc:docMk/>
            <pc:sldMk cId="495224942" sldId="262"/>
            <ac:cxnSpMk id="5" creationId="{90C1534C-6C95-D3BF-E438-19510A2F6847}"/>
          </ac:cxnSpMkLst>
        </pc:cxnChg>
        <pc:cxnChg chg="add mod">
          <ac:chgData name="Qinghe Meng" userId="8ec5781b-3938-43df-a84f-730d81e9a524" providerId="ADAL" clId="{28B8E620-2A74-45DD-9AF1-E710F37014A6}" dt="2023-03-17T18:58:39.820" v="1083" actId="1076"/>
          <ac:cxnSpMkLst>
            <pc:docMk/>
            <pc:sldMk cId="495224942" sldId="262"/>
            <ac:cxnSpMk id="7" creationId="{B545ED75-26B9-6F4B-2D54-23B92B12ED18}"/>
          </ac:cxnSpMkLst>
        </pc:cxnChg>
        <pc:cxnChg chg="add mod">
          <ac:chgData name="Qinghe Meng" userId="8ec5781b-3938-43df-a84f-730d81e9a524" providerId="ADAL" clId="{28B8E620-2A74-45DD-9AF1-E710F37014A6}" dt="2023-03-17T18:58:41.343" v="1084" actId="1076"/>
          <ac:cxnSpMkLst>
            <pc:docMk/>
            <pc:sldMk cId="495224942" sldId="262"/>
            <ac:cxnSpMk id="13" creationId="{7E30F5E1-0C95-58FC-55BD-5AC55173F66F}"/>
          </ac:cxnSpMkLst>
        </pc:cxnChg>
        <pc:cxnChg chg="del mod">
          <ac:chgData name="Qinghe Meng" userId="8ec5781b-3938-43df-a84f-730d81e9a524" providerId="ADAL" clId="{28B8E620-2A74-45DD-9AF1-E710F37014A6}" dt="2023-03-07T21:53:08.703" v="601" actId="478"/>
          <ac:cxnSpMkLst>
            <pc:docMk/>
            <pc:sldMk cId="495224942" sldId="262"/>
            <ac:cxnSpMk id="13" creationId="{D514497C-A6DE-45A8-E40B-F3A3FEB0958E}"/>
          </ac:cxnSpMkLst>
        </pc:cxnChg>
        <pc:cxnChg chg="del mod">
          <ac:chgData name="Qinghe Meng" userId="8ec5781b-3938-43df-a84f-730d81e9a524" providerId="ADAL" clId="{28B8E620-2A74-45DD-9AF1-E710F37014A6}" dt="2023-03-07T21:54:22.862" v="627" actId="478"/>
          <ac:cxnSpMkLst>
            <pc:docMk/>
            <pc:sldMk cId="495224942" sldId="262"/>
            <ac:cxnSpMk id="15" creationId="{257397E5-772D-EE5B-DA80-26ACA315F035}"/>
          </ac:cxnSpMkLst>
        </pc:cxnChg>
        <pc:cxnChg chg="add mod">
          <ac:chgData name="Qinghe Meng" userId="8ec5781b-3938-43df-a84f-730d81e9a524" providerId="ADAL" clId="{28B8E620-2A74-45DD-9AF1-E710F37014A6}" dt="2023-03-17T18:57:58.078" v="1073" actId="1076"/>
          <ac:cxnSpMkLst>
            <pc:docMk/>
            <pc:sldMk cId="495224942" sldId="262"/>
            <ac:cxnSpMk id="19" creationId="{28D4D0AB-07D4-56E2-1AAD-6213B1FB7CD5}"/>
          </ac:cxnSpMkLst>
        </pc:cxnChg>
        <pc:cxnChg chg="add del mod">
          <ac:chgData name="Qinghe Meng" userId="8ec5781b-3938-43df-a84f-730d81e9a524" providerId="ADAL" clId="{28B8E620-2A74-45DD-9AF1-E710F37014A6}" dt="2023-03-07T21:55:45.086" v="651" actId="478"/>
          <ac:cxnSpMkLst>
            <pc:docMk/>
            <pc:sldMk cId="495224942" sldId="262"/>
            <ac:cxnSpMk id="19" creationId="{E7F3116B-13FF-551E-9E13-C0D84D559CD1}"/>
          </ac:cxnSpMkLst>
        </pc:cxnChg>
        <pc:cxnChg chg="del">
          <ac:chgData name="Qinghe Meng" userId="8ec5781b-3938-43df-a84f-730d81e9a524" providerId="ADAL" clId="{28B8E620-2A74-45DD-9AF1-E710F37014A6}" dt="2023-03-07T21:54:40.349" v="634" actId="478"/>
          <ac:cxnSpMkLst>
            <pc:docMk/>
            <pc:sldMk cId="495224942" sldId="262"/>
            <ac:cxnSpMk id="21" creationId="{D47FC74E-FF67-290C-F018-305D5731FF48}"/>
          </ac:cxnSpMkLst>
        </pc:cxnChg>
        <pc:cxnChg chg="del">
          <ac:chgData name="Qinghe Meng" userId="8ec5781b-3938-43df-a84f-730d81e9a524" providerId="ADAL" clId="{28B8E620-2A74-45DD-9AF1-E710F37014A6}" dt="2023-03-07T21:54:40.349" v="634" actId="478"/>
          <ac:cxnSpMkLst>
            <pc:docMk/>
            <pc:sldMk cId="495224942" sldId="262"/>
            <ac:cxnSpMk id="23" creationId="{38FFC826-DF1F-9A80-E3CD-F7EA39AC7E43}"/>
          </ac:cxnSpMkLst>
        </pc:cxnChg>
        <pc:cxnChg chg="del">
          <ac:chgData name="Qinghe Meng" userId="8ec5781b-3938-43df-a84f-730d81e9a524" providerId="ADAL" clId="{28B8E620-2A74-45DD-9AF1-E710F37014A6}" dt="2023-03-07T21:54:40.349" v="634" actId="478"/>
          <ac:cxnSpMkLst>
            <pc:docMk/>
            <pc:sldMk cId="495224942" sldId="262"/>
            <ac:cxnSpMk id="24" creationId="{54058631-9AA2-FF61-3988-51F4900357DE}"/>
          </ac:cxnSpMkLst>
        </pc:cxnChg>
        <pc:cxnChg chg="add del mod">
          <ac:chgData name="Qinghe Meng" userId="8ec5781b-3938-43df-a84f-730d81e9a524" providerId="ADAL" clId="{28B8E620-2A74-45DD-9AF1-E710F37014A6}" dt="2023-03-07T21:55:45.086" v="651" actId="478"/>
          <ac:cxnSpMkLst>
            <pc:docMk/>
            <pc:sldMk cId="495224942" sldId="262"/>
            <ac:cxnSpMk id="28" creationId="{59EDB4DC-5FB1-5AC5-00B8-B690047DB7DE}"/>
          </ac:cxnSpMkLst>
        </pc:cxnChg>
        <pc:cxnChg chg="add del mod">
          <ac:chgData name="Qinghe Meng" userId="8ec5781b-3938-43df-a84f-730d81e9a524" providerId="ADAL" clId="{28B8E620-2A74-45DD-9AF1-E710F37014A6}" dt="2023-03-07T21:55:45.086" v="651" actId="478"/>
          <ac:cxnSpMkLst>
            <pc:docMk/>
            <pc:sldMk cId="495224942" sldId="262"/>
            <ac:cxnSpMk id="29" creationId="{77153A0D-642C-7A44-3F5D-E15497D5ADA4}"/>
          </ac:cxnSpMkLst>
        </pc:cxnChg>
        <pc:cxnChg chg="add mod">
          <ac:chgData name="Qinghe Meng" userId="8ec5781b-3938-43df-a84f-730d81e9a524" providerId="ADAL" clId="{28B8E620-2A74-45DD-9AF1-E710F37014A6}" dt="2023-03-07T21:56:51.074" v="666" actId="14100"/>
          <ac:cxnSpMkLst>
            <pc:docMk/>
            <pc:sldMk cId="495224942" sldId="262"/>
            <ac:cxnSpMk id="38" creationId="{C8C9E76F-D854-D91A-855E-50F556CAC3EA}"/>
          </ac:cxnSpMkLst>
        </pc:cxnChg>
        <pc:cxnChg chg="add mod">
          <ac:chgData name="Qinghe Meng" userId="8ec5781b-3938-43df-a84f-730d81e9a524" providerId="ADAL" clId="{28B8E620-2A74-45DD-9AF1-E710F37014A6}" dt="2023-03-07T21:57:00.326" v="668" actId="1076"/>
          <ac:cxnSpMkLst>
            <pc:docMk/>
            <pc:sldMk cId="495224942" sldId="262"/>
            <ac:cxnSpMk id="40" creationId="{EF86F867-0505-BE64-7472-F472CA553B75}"/>
          </ac:cxnSpMkLst>
        </pc:cxnChg>
        <pc:cxnChg chg="add mod">
          <ac:chgData name="Qinghe Meng" userId="8ec5781b-3938-43df-a84f-730d81e9a524" providerId="ADAL" clId="{28B8E620-2A74-45DD-9AF1-E710F37014A6}" dt="2023-03-07T21:57:06.909" v="670" actId="1076"/>
          <ac:cxnSpMkLst>
            <pc:docMk/>
            <pc:sldMk cId="495224942" sldId="262"/>
            <ac:cxnSpMk id="41" creationId="{142902CC-B3C2-0495-46B3-BDD050D14151}"/>
          </ac:cxnSpMkLst>
        </pc:cxnChg>
        <pc:cxnChg chg="add mod">
          <ac:chgData name="Qinghe Meng" userId="8ec5781b-3938-43df-a84f-730d81e9a524" providerId="ADAL" clId="{28B8E620-2A74-45DD-9AF1-E710F37014A6}" dt="2023-03-07T21:57:12.342" v="672" actId="1076"/>
          <ac:cxnSpMkLst>
            <pc:docMk/>
            <pc:sldMk cId="495224942" sldId="262"/>
            <ac:cxnSpMk id="42" creationId="{D201244E-A91D-8A1F-6CAE-F5E506C1C478}"/>
          </ac:cxnSpMkLst>
        </pc:cxnChg>
        <pc:cxnChg chg="add del mod">
          <ac:chgData name="Qinghe Meng" userId="8ec5781b-3938-43df-a84f-730d81e9a524" providerId="ADAL" clId="{28B8E620-2A74-45DD-9AF1-E710F37014A6}" dt="2023-03-17T18:57:03.668" v="1060" actId="21"/>
          <ac:cxnSpMkLst>
            <pc:docMk/>
            <pc:sldMk cId="495224942" sldId="262"/>
            <ac:cxnSpMk id="50" creationId="{7620B5D0-BB37-DC2A-F76B-2687E3839A87}"/>
          </ac:cxnSpMkLst>
        </pc:cxnChg>
        <pc:cxnChg chg="add del mod">
          <ac:chgData name="Qinghe Meng" userId="8ec5781b-3938-43df-a84f-730d81e9a524" providerId="ADAL" clId="{28B8E620-2A74-45DD-9AF1-E710F37014A6}" dt="2023-03-17T18:57:03.668" v="1060" actId="21"/>
          <ac:cxnSpMkLst>
            <pc:docMk/>
            <pc:sldMk cId="495224942" sldId="262"/>
            <ac:cxnSpMk id="51" creationId="{13203E32-549F-A5F7-B43B-CACEAE4369BF}"/>
          </ac:cxnSpMkLst>
        </pc:cxnChg>
        <pc:cxnChg chg="add del mod">
          <ac:chgData name="Qinghe Meng" userId="8ec5781b-3938-43df-a84f-730d81e9a524" providerId="ADAL" clId="{28B8E620-2A74-45DD-9AF1-E710F37014A6}" dt="2023-03-17T18:57:03.668" v="1060" actId="21"/>
          <ac:cxnSpMkLst>
            <pc:docMk/>
            <pc:sldMk cId="495224942" sldId="262"/>
            <ac:cxnSpMk id="52" creationId="{4BA6DFC1-5AEC-0D50-399C-C067E94D4ECB}"/>
          </ac:cxnSpMkLst>
        </pc:cxnChg>
        <pc:cxnChg chg="add del mod">
          <ac:chgData name="Qinghe Meng" userId="8ec5781b-3938-43df-a84f-730d81e9a524" providerId="ADAL" clId="{28B8E620-2A74-45DD-9AF1-E710F37014A6}" dt="2023-03-17T18:57:03.668" v="1060" actId="21"/>
          <ac:cxnSpMkLst>
            <pc:docMk/>
            <pc:sldMk cId="495224942" sldId="262"/>
            <ac:cxnSpMk id="53" creationId="{64A466DC-DFB0-86C5-AEF2-5112E004187B}"/>
          </ac:cxnSpMkLst>
        </pc:cxnChg>
        <pc:cxnChg chg="add mod">
          <ac:chgData name="Qinghe Meng" userId="8ec5781b-3938-43df-a84f-730d81e9a524" providerId="ADAL" clId="{28B8E620-2A74-45DD-9AF1-E710F37014A6}" dt="2023-03-07T22:00:38.927" v="712" actId="1076"/>
          <ac:cxnSpMkLst>
            <pc:docMk/>
            <pc:sldMk cId="495224942" sldId="262"/>
            <ac:cxnSpMk id="58" creationId="{367EA7C3-ECB7-82E6-8A21-98DF410AA291}"/>
          </ac:cxnSpMkLst>
        </pc:cxnChg>
        <pc:cxnChg chg="add del mod">
          <ac:chgData name="Qinghe Meng" userId="8ec5781b-3938-43df-a84f-730d81e9a524" providerId="ADAL" clId="{28B8E620-2A74-45DD-9AF1-E710F37014A6}" dt="2023-03-17T18:57:03.668" v="1060" actId="21"/>
          <ac:cxnSpMkLst>
            <pc:docMk/>
            <pc:sldMk cId="495224942" sldId="262"/>
            <ac:cxnSpMk id="60" creationId="{00A8A763-EFD5-987A-BE57-91D806F3886C}"/>
          </ac:cxnSpMkLst>
        </pc:cxnChg>
      </pc:sldChg>
      <pc:sldChg chg="addSp delSp modSp add mod">
        <pc:chgData name="Qinghe Meng" userId="8ec5781b-3938-43df-a84f-730d81e9a524" providerId="ADAL" clId="{28B8E620-2A74-45DD-9AF1-E710F37014A6}" dt="2023-03-08T13:55:02.255" v="983" actId="1076"/>
        <pc:sldMkLst>
          <pc:docMk/>
          <pc:sldMk cId="3465296187" sldId="263"/>
        </pc:sldMkLst>
        <pc:spChg chg="mod">
          <ac:chgData name="Qinghe Meng" userId="8ec5781b-3938-43df-a84f-730d81e9a524" providerId="ADAL" clId="{28B8E620-2A74-45DD-9AF1-E710F37014A6}" dt="2023-03-07T22:04:51.262" v="768" actId="1076"/>
          <ac:spMkLst>
            <pc:docMk/>
            <pc:sldMk cId="3465296187" sldId="263"/>
            <ac:spMk id="8" creationId="{56C7C46D-26B3-8966-23B4-73F80ABBF7EE}"/>
          </ac:spMkLst>
        </pc:spChg>
        <pc:spChg chg="mod">
          <ac:chgData name="Qinghe Meng" userId="8ec5781b-3938-43df-a84f-730d81e9a524" providerId="ADAL" clId="{28B8E620-2A74-45DD-9AF1-E710F37014A6}" dt="2023-03-08T13:55:02.255" v="983" actId="1076"/>
          <ac:spMkLst>
            <pc:docMk/>
            <pc:sldMk cId="3465296187" sldId="263"/>
            <ac:spMk id="11" creationId="{D921206A-231E-0020-D196-92FEE916AAE8}"/>
          </ac:spMkLst>
        </pc:spChg>
        <pc:spChg chg="mod">
          <ac:chgData name="Qinghe Meng" userId="8ec5781b-3938-43df-a84f-730d81e9a524" providerId="ADAL" clId="{28B8E620-2A74-45DD-9AF1-E710F37014A6}" dt="2023-03-07T22:11:28.086" v="832" actId="6549"/>
          <ac:spMkLst>
            <pc:docMk/>
            <pc:sldMk cId="3465296187" sldId="263"/>
            <ac:spMk id="12" creationId="{679078DA-C4F6-5441-4EE1-B814696B77EC}"/>
          </ac:spMkLst>
        </pc:spChg>
        <pc:spChg chg="add del mod">
          <ac:chgData name="Qinghe Meng" userId="8ec5781b-3938-43df-a84f-730d81e9a524" providerId="ADAL" clId="{28B8E620-2A74-45DD-9AF1-E710F37014A6}" dt="2023-03-08T13:31:48.235" v="879" actId="478"/>
          <ac:spMkLst>
            <pc:docMk/>
            <pc:sldMk cId="3465296187" sldId="263"/>
            <ac:spMk id="13" creationId="{933979F8-913F-1682-6BEF-63651C03C687}"/>
          </ac:spMkLst>
        </pc:spChg>
        <pc:spChg chg="add mod">
          <ac:chgData name="Qinghe Meng" userId="8ec5781b-3938-43df-a84f-730d81e9a524" providerId="ADAL" clId="{28B8E620-2A74-45DD-9AF1-E710F37014A6}" dt="2023-03-07T22:04:45.833" v="767" actId="1076"/>
          <ac:spMkLst>
            <pc:docMk/>
            <pc:sldMk cId="3465296187" sldId="263"/>
            <ac:spMk id="14" creationId="{F2FB6215-4856-2448-B034-09C5150B1E59}"/>
          </ac:spMkLst>
        </pc:spChg>
        <pc:spChg chg="add mod">
          <ac:chgData name="Qinghe Meng" userId="8ec5781b-3938-43df-a84f-730d81e9a524" providerId="ADAL" clId="{28B8E620-2A74-45DD-9AF1-E710F37014A6}" dt="2023-03-07T22:04:41.594" v="766" actId="1076"/>
          <ac:spMkLst>
            <pc:docMk/>
            <pc:sldMk cId="3465296187" sldId="263"/>
            <ac:spMk id="15" creationId="{961304DA-4953-F177-3055-97E9592D3F62}"/>
          </ac:spMkLst>
        </pc:spChg>
        <pc:spChg chg="add mod">
          <ac:chgData name="Qinghe Meng" userId="8ec5781b-3938-43df-a84f-730d81e9a524" providerId="ADAL" clId="{28B8E620-2A74-45DD-9AF1-E710F37014A6}" dt="2023-03-07T22:11:45.845" v="836" actId="6549"/>
          <ac:spMkLst>
            <pc:docMk/>
            <pc:sldMk cId="3465296187" sldId="263"/>
            <ac:spMk id="21" creationId="{14A7666F-4100-84B8-EB6A-9B88853C5579}"/>
          </ac:spMkLst>
        </pc:spChg>
        <pc:spChg chg="add mod">
          <ac:chgData name="Qinghe Meng" userId="8ec5781b-3938-43df-a84f-730d81e9a524" providerId="ADAL" clId="{28B8E620-2A74-45DD-9AF1-E710F37014A6}" dt="2023-03-08T13:32:11.360" v="883" actId="1076"/>
          <ac:spMkLst>
            <pc:docMk/>
            <pc:sldMk cId="3465296187" sldId="263"/>
            <ac:spMk id="26" creationId="{69E7A55D-D447-0CE7-44E7-F3F2247D936C}"/>
          </ac:spMkLst>
        </pc:spChg>
        <pc:spChg chg="mod">
          <ac:chgData name="Qinghe Meng" userId="8ec5781b-3938-43df-a84f-730d81e9a524" providerId="ADAL" clId="{28B8E620-2A74-45DD-9AF1-E710F37014A6}" dt="2023-03-07T22:06:11.925" v="769" actId="1076"/>
          <ac:spMkLst>
            <pc:docMk/>
            <pc:sldMk cId="3465296187" sldId="263"/>
            <ac:spMk id="27" creationId="{D002C2EC-482A-780E-B8D9-308FDBDB6FB1}"/>
          </ac:spMkLst>
        </pc:spChg>
        <pc:spChg chg="add mod">
          <ac:chgData name="Qinghe Meng" userId="8ec5781b-3938-43df-a84f-730d81e9a524" providerId="ADAL" clId="{28B8E620-2A74-45DD-9AF1-E710F37014A6}" dt="2023-03-08T13:32:31.074" v="888" actId="1076"/>
          <ac:spMkLst>
            <pc:docMk/>
            <pc:sldMk cId="3465296187" sldId="263"/>
            <ac:spMk id="30" creationId="{0D3E31B1-56CF-D812-FF62-AB26EDA5F1E3}"/>
          </ac:spMkLst>
        </pc:spChg>
        <pc:spChg chg="add mod">
          <ac:chgData name="Qinghe Meng" userId="8ec5781b-3938-43df-a84f-730d81e9a524" providerId="ADAL" clId="{28B8E620-2A74-45DD-9AF1-E710F37014A6}" dt="2023-03-08T13:32:28.273" v="887" actId="1076"/>
          <ac:spMkLst>
            <pc:docMk/>
            <pc:sldMk cId="3465296187" sldId="263"/>
            <ac:spMk id="31" creationId="{8BA0CA19-01BD-0069-9431-670DE79A6631}"/>
          </ac:spMkLst>
        </pc:spChg>
        <pc:spChg chg="add mod">
          <ac:chgData name="Qinghe Meng" userId="8ec5781b-3938-43df-a84f-730d81e9a524" providerId="ADAL" clId="{28B8E620-2A74-45DD-9AF1-E710F37014A6}" dt="2023-03-08T13:32:23.683" v="886" actId="1076"/>
          <ac:spMkLst>
            <pc:docMk/>
            <pc:sldMk cId="3465296187" sldId="263"/>
            <ac:spMk id="32" creationId="{231BE9E1-9BC2-0A0C-6B50-83084222E19A}"/>
          </ac:spMkLst>
        </pc:spChg>
        <pc:spChg chg="mod">
          <ac:chgData name="Qinghe Meng" userId="8ec5781b-3938-43df-a84f-730d81e9a524" providerId="ADAL" clId="{28B8E620-2A74-45DD-9AF1-E710F37014A6}" dt="2023-03-07T22:04:36.180" v="764" actId="1076"/>
          <ac:spMkLst>
            <pc:docMk/>
            <pc:sldMk cId="3465296187" sldId="263"/>
            <ac:spMk id="33" creationId="{679B4805-9995-8860-B8DA-F6F80A7B2FB5}"/>
          </ac:spMkLst>
        </pc:spChg>
        <pc:spChg chg="mod">
          <ac:chgData name="Qinghe Meng" userId="8ec5781b-3938-43df-a84f-730d81e9a524" providerId="ADAL" clId="{28B8E620-2A74-45DD-9AF1-E710F37014A6}" dt="2023-03-07T22:04:33.224" v="763" actId="1076"/>
          <ac:spMkLst>
            <pc:docMk/>
            <pc:sldMk cId="3465296187" sldId="263"/>
            <ac:spMk id="34" creationId="{99943CC7-CA42-E49F-F37E-B3C2FB71F96C}"/>
          </ac:spMkLst>
        </pc:spChg>
        <pc:picChg chg="add del mod">
          <ac:chgData name="Qinghe Meng" userId="8ec5781b-3938-43df-a84f-730d81e9a524" providerId="ADAL" clId="{28B8E620-2A74-45DD-9AF1-E710F37014A6}" dt="2023-03-07T22:10:57.718" v="829" actId="478"/>
          <ac:picMkLst>
            <pc:docMk/>
            <pc:sldMk cId="3465296187" sldId="263"/>
            <ac:picMk id="16" creationId="{7317D6B1-B810-81D5-9349-42E4A3F2BFB7}"/>
          </ac:picMkLst>
        </pc:picChg>
        <pc:picChg chg="add mod">
          <ac:chgData name="Qinghe Meng" userId="8ec5781b-3938-43df-a84f-730d81e9a524" providerId="ADAL" clId="{28B8E620-2A74-45DD-9AF1-E710F37014A6}" dt="2023-03-07T22:11:25.469" v="831" actId="1076"/>
          <ac:picMkLst>
            <pc:docMk/>
            <pc:sldMk cId="3465296187" sldId="263"/>
            <ac:picMk id="18" creationId="{884B54F1-F525-A495-076A-F09A882AE211}"/>
          </ac:picMkLst>
        </pc:picChg>
        <pc:cxnChg chg="add mod">
          <ac:chgData name="Qinghe Meng" userId="8ec5781b-3938-43df-a84f-730d81e9a524" providerId="ADAL" clId="{28B8E620-2A74-45DD-9AF1-E710F37014A6}" dt="2023-03-07T22:03:02.814" v="743" actId="1076"/>
          <ac:cxnSpMkLst>
            <pc:docMk/>
            <pc:sldMk cId="3465296187" sldId="263"/>
            <ac:cxnSpMk id="5" creationId="{2786D0E1-0D36-F321-F07C-231F9E3B638F}"/>
          </ac:cxnSpMkLst>
        </pc:cxnChg>
        <pc:cxnChg chg="add mod">
          <ac:chgData name="Qinghe Meng" userId="8ec5781b-3938-43df-a84f-730d81e9a524" providerId="ADAL" clId="{28B8E620-2A74-45DD-9AF1-E710F37014A6}" dt="2023-03-07T22:02:58.701" v="742" actId="1076"/>
          <ac:cxnSpMkLst>
            <pc:docMk/>
            <pc:sldMk cId="3465296187" sldId="263"/>
            <ac:cxnSpMk id="7" creationId="{D1373202-63A2-848B-86E3-FA769E647111}"/>
          </ac:cxnSpMkLst>
        </pc:cxnChg>
        <pc:cxnChg chg="mod">
          <ac:chgData name="Qinghe Meng" userId="8ec5781b-3938-43df-a84f-730d81e9a524" providerId="ADAL" clId="{28B8E620-2A74-45DD-9AF1-E710F37014A6}" dt="2023-03-07T22:06:15.395" v="770" actId="1076"/>
          <ac:cxnSpMkLst>
            <pc:docMk/>
            <pc:sldMk cId="3465296187" sldId="263"/>
            <ac:cxnSpMk id="19" creationId="{E7F3116B-13FF-551E-9E13-C0D84D559CD1}"/>
          </ac:cxnSpMkLst>
        </pc:cxnChg>
        <pc:cxnChg chg="add mod">
          <ac:chgData name="Qinghe Meng" userId="8ec5781b-3938-43df-a84f-730d81e9a524" providerId="ADAL" clId="{28B8E620-2A74-45DD-9AF1-E710F37014A6}" dt="2023-03-07T22:11:42.014" v="834" actId="1076"/>
          <ac:cxnSpMkLst>
            <pc:docMk/>
            <pc:sldMk cId="3465296187" sldId="263"/>
            <ac:cxnSpMk id="20" creationId="{54192CC4-BBF1-C1AE-E420-DAF804798671}"/>
          </ac:cxnSpMkLst>
        </pc:cxnChg>
        <pc:cxnChg chg="add mod">
          <ac:chgData name="Qinghe Meng" userId="8ec5781b-3938-43df-a84f-730d81e9a524" providerId="ADAL" clId="{28B8E620-2A74-45DD-9AF1-E710F37014A6}" dt="2023-03-08T13:31:40.288" v="877" actId="1076"/>
          <ac:cxnSpMkLst>
            <pc:docMk/>
            <pc:sldMk cId="3465296187" sldId="263"/>
            <ac:cxnSpMk id="22" creationId="{7A7D1AA8-09E2-343A-9519-2110CAE2B846}"/>
          </ac:cxnSpMkLst>
        </pc:cxnChg>
        <pc:cxnChg chg="add mod">
          <ac:chgData name="Qinghe Meng" userId="8ec5781b-3938-43df-a84f-730d81e9a524" providerId="ADAL" clId="{28B8E620-2A74-45DD-9AF1-E710F37014A6}" dt="2023-03-08T13:31:37.245" v="876" actId="1076"/>
          <ac:cxnSpMkLst>
            <pc:docMk/>
            <pc:sldMk cId="3465296187" sldId="263"/>
            <ac:cxnSpMk id="23" creationId="{267FE205-4320-5033-458E-89D333BC8B87}"/>
          </ac:cxnSpMkLst>
        </pc:cxnChg>
        <pc:cxnChg chg="add mod">
          <ac:chgData name="Qinghe Meng" userId="8ec5781b-3938-43df-a84f-730d81e9a524" providerId="ADAL" clId="{28B8E620-2A74-45DD-9AF1-E710F37014A6}" dt="2023-03-08T13:31:34.129" v="875" actId="1076"/>
          <ac:cxnSpMkLst>
            <pc:docMk/>
            <pc:sldMk cId="3465296187" sldId="263"/>
            <ac:cxnSpMk id="24" creationId="{27ECCAF5-C30E-E13C-48E7-E3458C76E77F}"/>
          </ac:cxnSpMkLst>
        </pc:cxnChg>
        <pc:cxnChg chg="add mod">
          <ac:chgData name="Qinghe Meng" userId="8ec5781b-3938-43df-a84f-730d81e9a524" providerId="ADAL" clId="{28B8E620-2A74-45DD-9AF1-E710F37014A6}" dt="2023-03-08T13:31:29.104" v="874" actId="1076"/>
          <ac:cxnSpMkLst>
            <pc:docMk/>
            <pc:sldMk cId="3465296187" sldId="263"/>
            <ac:cxnSpMk id="25" creationId="{FB8C1E75-4400-15D0-E41C-AE6826255203}"/>
          </ac:cxnSpMkLst>
        </pc:cxnChg>
        <pc:cxnChg chg="mod">
          <ac:chgData name="Qinghe Meng" userId="8ec5781b-3938-43df-a84f-730d81e9a524" providerId="ADAL" clId="{28B8E620-2A74-45DD-9AF1-E710F37014A6}" dt="2023-03-07T22:01:30.372" v="721" actId="14100"/>
          <ac:cxnSpMkLst>
            <pc:docMk/>
            <pc:sldMk cId="3465296187" sldId="263"/>
            <ac:cxnSpMk id="28" creationId="{59EDB4DC-5FB1-5AC5-00B8-B690047DB7DE}"/>
          </ac:cxnSpMkLst>
        </pc:cxnChg>
        <pc:cxnChg chg="mod">
          <ac:chgData name="Qinghe Meng" userId="8ec5781b-3938-43df-a84f-730d81e9a524" providerId="ADAL" clId="{28B8E620-2A74-45DD-9AF1-E710F37014A6}" dt="2023-03-07T22:02:30.181" v="736" actId="1076"/>
          <ac:cxnSpMkLst>
            <pc:docMk/>
            <pc:sldMk cId="3465296187" sldId="263"/>
            <ac:cxnSpMk id="29" creationId="{77153A0D-642C-7A44-3F5D-E15497D5ADA4}"/>
          </ac:cxnSpMkLst>
        </pc:cxnChg>
      </pc:sldChg>
      <pc:sldChg chg="addSp delSp modSp add mod">
        <pc:chgData name="Qinghe Meng" userId="8ec5781b-3938-43df-a84f-730d81e9a524" providerId="ADAL" clId="{28B8E620-2A74-45DD-9AF1-E710F37014A6}" dt="2023-03-08T13:54:57.361" v="982" actId="1076"/>
        <pc:sldMkLst>
          <pc:docMk/>
          <pc:sldMk cId="3109864510" sldId="264"/>
        </pc:sldMkLst>
        <pc:spChg chg="add mod">
          <ac:chgData name="Qinghe Meng" userId="8ec5781b-3938-43df-a84f-730d81e9a524" providerId="ADAL" clId="{28B8E620-2A74-45DD-9AF1-E710F37014A6}" dt="2023-03-08T13:52:59.206" v="958" actId="1076"/>
          <ac:spMkLst>
            <pc:docMk/>
            <pc:sldMk cId="3109864510" sldId="264"/>
            <ac:spMk id="4" creationId="{BDDD0A9A-47FB-C705-055D-AAFEE3BCD0D6}"/>
          </ac:spMkLst>
        </pc:spChg>
        <pc:spChg chg="add mod">
          <ac:chgData name="Qinghe Meng" userId="8ec5781b-3938-43df-a84f-730d81e9a524" providerId="ADAL" clId="{28B8E620-2A74-45DD-9AF1-E710F37014A6}" dt="2023-03-08T13:53:12.392" v="960" actId="1076"/>
          <ac:spMkLst>
            <pc:docMk/>
            <pc:sldMk cId="3109864510" sldId="264"/>
            <ac:spMk id="5" creationId="{69898F49-F580-9F11-4B78-AD7EB8D2BF7B}"/>
          </ac:spMkLst>
        </pc:spChg>
        <pc:spChg chg="mod">
          <ac:chgData name="Qinghe Meng" userId="8ec5781b-3938-43df-a84f-730d81e9a524" providerId="ADAL" clId="{28B8E620-2A74-45DD-9AF1-E710F37014A6}" dt="2023-03-07T22:12:09.621" v="849" actId="6549"/>
          <ac:spMkLst>
            <pc:docMk/>
            <pc:sldMk cId="3109864510" sldId="264"/>
            <ac:spMk id="6" creationId="{5F43ACBE-7784-620B-7DE9-28F3500AA41B}"/>
          </ac:spMkLst>
        </pc:spChg>
        <pc:spChg chg="add mod">
          <ac:chgData name="Qinghe Meng" userId="8ec5781b-3938-43df-a84f-730d81e9a524" providerId="ADAL" clId="{28B8E620-2A74-45DD-9AF1-E710F37014A6}" dt="2023-03-08T13:54:57.361" v="982" actId="1076"/>
          <ac:spMkLst>
            <pc:docMk/>
            <pc:sldMk cId="3109864510" sldId="264"/>
            <ac:spMk id="7" creationId="{216D9B20-C76F-7B6C-C145-390A68337CC3}"/>
          </ac:spMkLst>
        </pc:spChg>
        <pc:spChg chg="mod">
          <ac:chgData name="Qinghe Meng" userId="8ec5781b-3938-43df-a84f-730d81e9a524" providerId="ADAL" clId="{28B8E620-2A74-45DD-9AF1-E710F37014A6}" dt="2023-03-07T22:13:09.606" v="863" actId="20577"/>
          <ac:spMkLst>
            <pc:docMk/>
            <pc:sldMk cId="3109864510" sldId="264"/>
            <ac:spMk id="9" creationId="{575D03C4-8917-71CF-8B44-80EA7D788907}"/>
          </ac:spMkLst>
        </pc:spChg>
        <pc:spChg chg="del mod">
          <ac:chgData name="Qinghe Meng" userId="8ec5781b-3938-43df-a84f-730d81e9a524" providerId="ADAL" clId="{28B8E620-2A74-45DD-9AF1-E710F37014A6}" dt="2023-03-08T13:35:32.440" v="902" actId="478"/>
          <ac:spMkLst>
            <pc:docMk/>
            <pc:sldMk cId="3109864510" sldId="264"/>
            <ac:spMk id="11" creationId="{D921206A-231E-0020-D196-92FEE916AAE8}"/>
          </ac:spMkLst>
        </pc:spChg>
        <pc:spChg chg="mod">
          <ac:chgData name="Qinghe Meng" userId="8ec5781b-3938-43df-a84f-730d81e9a524" providerId="ADAL" clId="{28B8E620-2A74-45DD-9AF1-E710F37014A6}" dt="2023-03-08T13:42:09.141" v="915" actId="20577"/>
          <ac:spMkLst>
            <pc:docMk/>
            <pc:sldMk cId="3109864510" sldId="264"/>
            <ac:spMk id="12" creationId="{679078DA-C4F6-5441-4EE1-B814696B77EC}"/>
          </ac:spMkLst>
        </pc:spChg>
        <pc:spChg chg="del">
          <ac:chgData name="Qinghe Meng" userId="8ec5781b-3938-43df-a84f-730d81e9a524" providerId="ADAL" clId="{28B8E620-2A74-45DD-9AF1-E710F37014A6}" dt="2023-03-07T22:07:24.248" v="795" actId="478"/>
          <ac:spMkLst>
            <pc:docMk/>
            <pc:sldMk cId="3109864510" sldId="264"/>
            <ac:spMk id="13" creationId="{933979F8-913F-1682-6BEF-63651C03C687}"/>
          </ac:spMkLst>
        </pc:spChg>
        <pc:spChg chg="del mod">
          <ac:chgData name="Qinghe Meng" userId="8ec5781b-3938-43df-a84f-730d81e9a524" providerId="ADAL" clId="{28B8E620-2A74-45DD-9AF1-E710F37014A6}" dt="2023-03-07T22:07:24.248" v="795" actId="478"/>
          <ac:spMkLst>
            <pc:docMk/>
            <pc:sldMk cId="3109864510" sldId="264"/>
            <ac:spMk id="14" creationId="{F2FB6215-4856-2448-B034-09C5150B1E59}"/>
          </ac:spMkLst>
        </pc:spChg>
        <pc:spChg chg="del mod">
          <ac:chgData name="Qinghe Meng" userId="8ec5781b-3938-43df-a84f-730d81e9a524" providerId="ADAL" clId="{28B8E620-2A74-45DD-9AF1-E710F37014A6}" dt="2023-03-07T22:07:24.248" v="795" actId="478"/>
          <ac:spMkLst>
            <pc:docMk/>
            <pc:sldMk cId="3109864510" sldId="264"/>
            <ac:spMk id="15" creationId="{961304DA-4953-F177-3055-97E9592D3F62}"/>
          </ac:spMkLst>
        </pc:spChg>
        <pc:spChg chg="add mod">
          <ac:chgData name="Qinghe Meng" userId="8ec5781b-3938-43df-a84f-730d81e9a524" providerId="ADAL" clId="{28B8E620-2A74-45DD-9AF1-E710F37014A6}" dt="2023-03-08T13:52:13.509" v="950" actId="1076"/>
          <ac:spMkLst>
            <pc:docMk/>
            <pc:sldMk cId="3109864510" sldId="264"/>
            <ac:spMk id="18" creationId="{D4333F05-0680-18CF-504F-B8BD54E2D9E8}"/>
          </ac:spMkLst>
        </pc:spChg>
        <pc:spChg chg="add del mod">
          <ac:chgData name="Qinghe Meng" userId="8ec5781b-3938-43df-a84f-730d81e9a524" providerId="ADAL" clId="{28B8E620-2A74-45DD-9AF1-E710F37014A6}" dt="2023-03-08T13:35:27.897" v="900" actId="478"/>
          <ac:spMkLst>
            <pc:docMk/>
            <pc:sldMk cId="3109864510" sldId="264"/>
            <ac:spMk id="22" creationId="{55191183-448F-3A89-082B-417C3962917F}"/>
          </ac:spMkLst>
        </pc:spChg>
        <pc:spChg chg="add del mod">
          <ac:chgData name="Qinghe Meng" userId="8ec5781b-3938-43df-a84f-730d81e9a524" providerId="ADAL" clId="{28B8E620-2A74-45DD-9AF1-E710F37014A6}" dt="2023-03-08T13:35:27.897" v="900" actId="478"/>
          <ac:spMkLst>
            <pc:docMk/>
            <pc:sldMk cId="3109864510" sldId="264"/>
            <ac:spMk id="23" creationId="{BEF85C10-3C77-F40D-406B-8EB8F77C08FF}"/>
          </ac:spMkLst>
        </pc:spChg>
        <pc:spChg chg="add del mod">
          <ac:chgData name="Qinghe Meng" userId="8ec5781b-3938-43df-a84f-730d81e9a524" providerId="ADAL" clId="{28B8E620-2A74-45DD-9AF1-E710F37014A6}" dt="2023-03-08T13:35:27.897" v="900" actId="478"/>
          <ac:spMkLst>
            <pc:docMk/>
            <pc:sldMk cId="3109864510" sldId="264"/>
            <ac:spMk id="26" creationId="{05684DA0-9C50-E834-B7E4-3ADB81CAFCBE}"/>
          </ac:spMkLst>
        </pc:spChg>
        <pc:spChg chg="del mod">
          <ac:chgData name="Qinghe Meng" userId="8ec5781b-3938-43df-a84f-730d81e9a524" providerId="ADAL" clId="{28B8E620-2A74-45DD-9AF1-E710F37014A6}" dt="2023-03-07T22:07:24.248" v="795" actId="478"/>
          <ac:spMkLst>
            <pc:docMk/>
            <pc:sldMk cId="3109864510" sldId="264"/>
            <ac:spMk id="27" creationId="{D002C2EC-482A-780E-B8D9-308FDBDB6FB1}"/>
          </ac:spMkLst>
        </pc:spChg>
        <pc:spChg chg="add del mod">
          <ac:chgData name="Qinghe Meng" userId="8ec5781b-3938-43df-a84f-730d81e9a524" providerId="ADAL" clId="{28B8E620-2A74-45DD-9AF1-E710F37014A6}" dt="2023-03-08T13:35:27.897" v="900" actId="478"/>
          <ac:spMkLst>
            <pc:docMk/>
            <pc:sldMk cId="3109864510" sldId="264"/>
            <ac:spMk id="30" creationId="{8238379B-330D-3D4D-D3B6-E1AD32FAD609}"/>
          </ac:spMkLst>
        </pc:spChg>
        <pc:spChg chg="add mod">
          <ac:chgData name="Qinghe Meng" userId="8ec5781b-3938-43df-a84f-730d81e9a524" providerId="ADAL" clId="{28B8E620-2A74-45DD-9AF1-E710F37014A6}" dt="2023-03-07T22:14:35.053" v="869" actId="1076"/>
          <ac:spMkLst>
            <pc:docMk/>
            <pc:sldMk cId="3109864510" sldId="264"/>
            <ac:spMk id="32" creationId="{E0D9DCDA-E2A3-72CC-0C0D-7A0B56C7EC3E}"/>
          </ac:spMkLst>
        </pc:spChg>
        <pc:spChg chg="del mod">
          <ac:chgData name="Qinghe Meng" userId="8ec5781b-3938-43df-a84f-730d81e9a524" providerId="ADAL" clId="{28B8E620-2A74-45DD-9AF1-E710F37014A6}" dt="2023-03-07T22:07:24.248" v="795" actId="478"/>
          <ac:spMkLst>
            <pc:docMk/>
            <pc:sldMk cId="3109864510" sldId="264"/>
            <ac:spMk id="33" creationId="{679B4805-9995-8860-B8DA-F6F80A7B2FB5}"/>
          </ac:spMkLst>
        </pc:spChg>
        <pc:spChg chg="del mod">
          <ac:chgData name="Qinghe Meng" userId="8ec5781b-3938-43df-a84f-730d81e9a524" providerId="ADAL" clId="{28B8E620-2A74-45DD-9AF1-E710F37014A6}" dt="2023-03-07T22:07:24.248" v="795" actId="478"/>
          <ac:spMkLst>
            <pc:docMk/>
            <pc:sldMk cId="3109864510" sldId="264"/>
            <ac:spMk id="34" creationId="{99943CC7-CA42-E49F-F37E-B3C2FB71F96C}"/>
          </ac:spMkLst>
        </pc:spChg>
        <pc:spChg chg="add del mod">
          <ac:chgData name="Qinghe Meng" userId="8ec5781b-3938-43df-a84f-730d81e9a524" providerId="ADAL" clId="{28B8E620-2A74-45DD-9AF1-E710F37014A6}" dt="2023-03-07T22:12:50.404" v="859" actId="478"/>
          <ac:spMkLst>
            <pc:docMk/>
            <pc:sldMk cId="3109864510" sldId="264"/>
            <ac:spMk id="37" creationId="{1316D5BC-DEE3-DE3E-1C67-11D6FED8EE3D}"/>
          </ac:spMkLst>
        </pc:spChg>
        <pc:spChg chg="add del mod">
          <ac:chgData name="Qinghe Meng" userId="8ec5781b-3938-43df-a84f-730d81e9a524" providerId="ADAL" clId="{28B8E620-2A74-45DD-9AF1-E710F37014A6}" dt="2023-03-07T22:12:50.404" v="859" actId="478"/>
          <ac:spMkLst>
            <pc:docMk/>
            <pc:sldMk cId="3109864510" sldId="264"/>
            <ac:spMk id="38" creationId="{182CC377-906A-8A90-2CE1-01D1AD4FB476}"/>
          </ac:spMkLst>
        </pc:spChg>
        <pc:spChg chg="add del mod">
          <ac:chgData name="Qinghe Meng" userId="8ec5781b-3938-43df-a84f-730d81e9a524" providerId="ADAL" clId="{28B8E620-2A74-45DD-9AF1-E710F37014A6}" dt="2023-03-07T22:12:50.404" v="859" actId="478"/>
          <ac:spMkLst>
            <pc:docMk/>
            <pc:sldMk cId="3109864510" sldId="264"/>
            <ac:spMk id="41" creationId="{5BD1C53F-7A37-F7CE-41A6-28923215BB87}"/>
          </ac:spMkLst>
        </pc:spChg>
        <pc:spChg chg="add del mod">
          <ac:chgData name="Qinghe Meng" userId="8ec5781b-3938-43df-a84f-730d81e9a524" providerId="ADAL" clId="{28B8E620-2A74-45DD-9AF1-E710F37014A6}" dt="2023-03-07T22:12:50.404" v="859" actId="478"/>
          <ac:spMkLst>
            <pc:docMk/>
            <pc:sldMk cId="3109864510" sldId="264"/>
            <ac:spMk id="42" creationId="{9CC1BFEA-0C0B-E4B5-A272-DB5E95F334ED}"/>
          </ac:spMkLst>
        </pc:spChg>
        <pc:spChg chg="add mod">
          <ac:chgData name="Qinghe Meng" userId="8ec5781b-3938-43df-a84f-730d81e9a524" providerId="ADAL" clId="{28B8E620-2A74-45DD-9AF1-E710F37014A6}" dt="2023-03-08T13:52:48.112" v="956" actId="1076"/>
          <ac:spMkLst>
            <pc:docMk/>
            <pc:sldMk cId="3109864510" sldId="264"/>
            <ac:spMk id="50" creationId="{C5474BBB-B642-974F-7098-C074D7A907C7}"/>
          </ac:spMkLst>
        </pc:spChg>
        <pc:spChg chg="add mod">
          <ac:chgData name="Qinghe Meng" userId="8ec5781b-3938-43df-a84f-730d81e9a524" providerId="ADAL" clId="{28B8E620-2A74-45DD-9AF1-E710F37014A6}" dt="2023-03-08T13:35:17.575" v="899" actId="1076"/>
          <ac:spMkLst>
            <pc:docMk/>
            <pc:sldMk cId="3109864510" sldId="264"/>
            <ac:spMk id="51" creationId="{49B1E2B1-97DE-1885-D127-999173D6E15D}"/>
          </ac:spMkLst>
        </pc:spChg>
        <pc:picChg chg="add del mod">
          <ac:chgData name="Qinghe Meng" userId="8ec5781b-3938-43df-a84f-730d81e9a524" providerId="ADAL" clId="{28B8E620-2A74-45DD-9AF1-E710F37014A6}" dt="2023-03-07T22:12:38.229" v="853" actId="478"/>
          <ac:picMkLst>
            <pc:docMk/>
            <pc:sldMk cId="3109864510" sldId="264"/>
            <ac:picMk id="3" creationId="{4C1CE13D-228E-93F0-FAE1-4570D87B6D40}"/>
          </ac:picMkLst>
        </pc:picChg>
        <pc:picChg chg="del">
          <ac:chgData name="Qinghe Meng" userId="8ec5781b-3938-43df-a84f-730d81e9a524" providerId="ADAL" clId="{28B8E620-2A74-45DD-9AF1-E710F37014A6}" dt="2023-03-07T22:06:48.487" v="787" actId="478"/>
          <ac:picMkLst>
            <pc:docMk/>
            <pc:sldMk cId="3109864510" sldId="264"/>
            <ac:picMk id="4" creationId="{5D4F6C32-EEF4-1BEB-E085-3E17DFB0CC5E}"/>
          </ac:picMkLst>
        </pc:picChg>
        <pc:picChg chg="add del mod">
          <ac:chgData name="Qinghe Meng" userId="8ec5781b-3938-43df-a84f-730d81e9a524" providerId="ADAL" clId="{28B8E620-2A74-45DD-9AF1-E710F37014A6}" dt="2023-03-07T22:11:52.900" v="837" actId="478"/>
          <ac:picMkLst>
            <pc:docMk/>
            <pc:sldMk cId="3109864510" sldId="264"/>
            <ac:picMk id="44" creationId="{EADF8D2F-E5F4-344F-A2DC-8CA710964015}"/>
          </ac:picMkLst>
        </pc:picChg>
        <pc:picChg chg="add mod">
          <ac:chgData name="Qinghe Meng" userId="8ec5781b-3938-43df-a84f-730d81e9a524" providerId="ADAL" clId="{28B8E620-2A74-45DD-9AF1-E710F37014A6}" dt="2023-03-07T22:12:59.906" v="860" actId="1076"/>
          <ac:picMkLst>
            <pc:docMk/>
            <pc:sldMk cId="3109864510" sldId="264"/>
            <ac:picMk id="46" creationId="{9A0AD859-7DFF-4D53-0E7A-091CC762BEE5}"/>
          </ac:picMkLst>
        </pc:picChg>
        <pc:picChg chg="add mod">
          <ac:chgData name="Qinghe Meng" userId="8ec5781b-3938-43df-a84f-730d81e9a524" providerId="ADAL" clId="{28B8E620-2A74-45DD-9AF1-E710F37014A6}" dt="2023-03-08T13:52:17.029" v="951" actId="14100"/>
          <ac:picMkLst>
            <pc:docMk/>
            <pc:sldMk cId="3109864510" sldId="264"/>
            <ac:picMk id="53" creationId="{4BC7D9BD-9850-3C52-756D-ED4F3ABBE70E}"/>
          </ac:picMkLst>
        </pc:picChg>
        <pc:cxnChg chg="add mod">
          <ac:chgData name="Qinghe Meng" userId="8ec5781b-3938-43df-a84f-730d81e9a524" providerId="ADAL" clId="{28B8E620-2A74-45DD-9AF1-E710F37014A6}" dt="2023-03-08T13:52:37.754" v="953" actId="1076"/>
          <ac:cxnSpMkLst>
            <pc:docMk/>
            <pc:sldMk cId="3109864510" sldId="264"/>
            <ac:cxnSpMk id="2" creationId="{605B3DF5-453F-0585-B6E4-6068A665F42E}"/>
          </ac:cxnSpMkLst>
        </pc:cxnChg>
        <pc:cxnChg chg="add mod">
          <ac:chgData name="Qinghe Meng" userId="8ec5781b-3938-43df-a84f-730d81e9a524" providerId="ADAL" clId="{28B8E620-2A74-45DD-9AF1-E710F37014A6}" dt="2023-03-08T13:52:45.155" v="955" actId="1076"/>
          <ac:cxnSpMkLst>
            <pc:docMk/>
            <pc:sldMk cId="3109864510" sldId="264"/>
            <ac:cxnSpMk id="3" creationId="{466CE3EC-8932-5EC3-56BD-7EF2190FCE23}"/>
          </ac:cxnSpMkLst>
        </pc:cxnChg>
        <pc:cxnChg chg="del mod">
          <ac:chgData name="Qinghe Meng" userId="8ec5781b-3938-43df-a84f-730d81e9a524" providerId="ADAL" clId="{28B8E620-2A74-45DD-9AF1-E710F37014A6}" dt="2023-03-07T22:07:24.248" v="795" actId="478"/>
          <ac:cxnSpMkLst>
            <pc:docMk/>
            <pc:sldMk cId="3109864510" sldId="264"/>
            <ac:cxnSpMk id="5" creationId="{2786D0E1-0D36-F321-F07C-231F9E3B638F}"/>
          </ac:cxnSpMkLst>
        </pc:cxnChg>
        <pc:cxnChg chg="del mod">
          <ac:chgData name="Qinghe Meng" userId="8ec5781b-3938-43df-a84f-730d81e9a524" providerId="ADAL" clId="{28B8E620-2A74-45DD-9AF1-E710F37014A6}" dt="2023-03-07T22:07:24.248" v="795" actId="478"/>
          <ac:cxnSpMkLst>
            <pc:docMk/>
            <pc:sldMk cId="3109864510" sldId="264"/>
            <ac:cxnSpMk id="7" creationId="{D1373202-63A2-848B-86E3-FA769E647111}"/>
          </ac:cxnSpMkLst>
        </pc:cxnChg>
        <pc:cxnChg chg="add mod">
          <ac:chgData name="Qinghe Meng" userId="8ec5781b-3938-43df-a84f-730d81e9a524" providerId="ADAL" clId="{28B8E620-2A74-45DD-9AF1-E710F37014A6}" dt="2023-03-08T13:52:13.509" v="950" actId="1076"/>
          <ac:cxnSpMkLst>
            <pc:docMk/>
            <pc:sldMk cId="3109864510" sldId="264"/>
            <ac:cxnSpMk id="16" creationId="{BA2CF221-E61B-773A-8D37-1E728A7C8930}"/>
          </ac:cxnSpMkLst>
        </pc:cxnChg>
        <pc:cxnChg chg="del mod">
          <ac:chgData name="Qinghe Meng" userId="8ec5781b-3938-43df-a84f-730d81e9a524" providerId="ADAL" clId="{28B8E620-2A74-45DD-9AF1-E710F37014A6}" dt="2023-03-07T22:07:24.248" v="795" actId="478"/>
          <ac:cxnSpMkLst>
            <pc:docMk/>
            <pc:sldMk cId="3109864510" sldId="264"/>
            <ac:cxnSpMk id="19" creationId="{E7F3116B-13FF-551E-9E13-C0D84D559CD1}"/>
          </ac:cxnSpMkLst>
        </pc:cxnChg>
        <pc:cxnChg chg="add del mod">
          <ac:chgData name="Qinghe Meng" userId="8ec5781b-3938-43df-a84f-730d81e9a524" providerId="ADAL" clId="{28B8E620-2A74-45DD-9AF1-E710F37014A6}" dt="2023-03-08T13:35:27.897" v="900" actId="478"/>
          <ac:cxnSpMkLst>
            <pc:docMk/>
            <pc:sldMk cId="3109864510" sldId="264"/>
            <ac:cxnSpMk id="20" creationId="{142AF06B-CCA3-83F6-10FC-81386ECD21D1}"/>
          </ac:cxnSpMkLst>
        </pc:cxnChg>
        <pc:cxnChg chg="add del mod">
          <ac:chgData name="Qinghe Meng" userId="8ec5781b-3938-43df-a84f-730d81e9a524" providerId="ADAL" clId="{28B8E620-2A74-45DD-9AF1-E710F37014A6}" dt="2023-03-08T13:35:27.897" v="900" actId="478"/>
          <ac:cxnSpMkLst>
            <pc:docMk/>
            <pc:sldMk cId="3109864510" sldId="264"/>
            <ac:cxnSpMk id="21" creationId="{C38FA175-C3BE-39CC-CD50-F48BF38866F2}"/>
          </ac:cxnSpMkLst>
        </pc:cxnChg>
        <pc:cxnChg chg="add del mod">
          <ac:chgData name="Qinghe Meng" userId="8ec5781b-3938-43df-a84f-730d81e9a524" providerId="ADAL" clId="{28B8E620-2A74-45DD-9AF1-E710F37014A6}" dt="2023-03-08T13:35:27.897" v="900" actId="478"/>
          <ac:cxnSpMkLst>
            <pc:docMk/>
            <pc:sldMk cId="3109864510" sldId="264"/>
            <ac:cxnSpMk id="24" creationId="{EBDEA6AD-DDD3-980F-F59A-2DA721D65360}"/>
          </ac:cxnSpMkLst>
        </pc:cxnChg>
        <pc:cxnChg chg="add del mod">
          <ac:chgData name="Qinghe Meng" userId="8ec5781b-3938-43df-a84f-730d81e9a524" providerId="ADAL" clId="{28B8E620-2A74-45DD-9AF1-E710F37014A6}" dt="2023-03-08T13:35:27.897" v="900" actId="478"/>
          <ac:cxnSpMkLst>
            <pc:docMk/>
            <pc:sldMk cId="3109864510" sldId="264"/>
            <ac:cxnSpMk id="25" creationId="{FBFB2672-1214-2D5E-9C09-581D441F4C16}"/>
          </ac:cxnSpMkLst>
        </pc:cxnChg>
        <pc:cxnChg chg="del mod">
          <ac:chgData name="Qinghe Meng" userId="8ec5781b-3938-43df-a84f-730d81e9a524" providerId="ADAL" clId="{28B8E620-2A74-45DD-9AF1-E710F37014A6}" dt="2023-03-07T22:07:24.248" v="795" actId="478"/>
          <ac:cxnSpMkLst>
            <pc:docMk/>
            <pc:sldMk cId="3109864510" sldId="264"/>
            <ac:cxnSpMk id="28" creationId="{59EDB4DC-5FB1-5AC5-00B8-B690047DB7DE}"/>
          </ac:cxnSpMkLst>
        </pc:cxnChg>
        <pc:cxnChg chg="del mod">
          <ac:chgData name="Qinghe Meng" userId="8ec5781b-3938-43df-a84f-730d81e9a524" providerId="ADAL" clId="{28B8E620-2A74-45DD-9AF1-E710F37014A6}" dt="2023-03-07T22:07:24.248" v="795" actId="478"/>
          <ac:cxnSpMkLst>
            <pc:docMk/>
            <pc:sldMk cId="3109864510" sldId="264"/>
            <ac:cxnSpMk id="29" creationId="{77153A0D-642C-7A44-3F5D-E15497D5ADA4}"/>
          </ac:cxnSpMkLst>
        </pc:cxnChg>
        <pc:cxnChg chg="add mod">
          <ac:chgData name="Qinghe Meng" userId="8ec5781b-3938-43df-a84f-730d81e9a524" providerId="ADAL" clId="{28B8E620-2A74-45DD-9AF1-E710F37014A6}" dt="2023-03-07T22:14:35.053" v="869" actId="1076"/>
          <ac:cxnSpMkLst>
            <pc:docMk/>
            <pc:sldMk cId="3109864510" sldId="264"/>
            <ac:cxnSpMk id="31" creationId="{79FEEF68-1AB4-B520-7238-60C22415BADC}"/>
          </ac:cxnSpMkLst>
        </pc:cxnChg>
        <pc:cxnChg chg="add del mod">
          <ac:chgData name="Qinghe Meng" userId="8ec5781b-3938-43df-a84f-730d81e9a524" providerId="ADAL" clId="{28B8E620-2A74-45DD-9AF1-E710F37014A6}" dt="2023-03-07T22:12:50.404" v="859" actId="478"/>
          <ac:cxnSpMkLst>
            <pc:docMk/>
            <pc:sldMk cId="3109864510" sldId="264"/>
            <ac:cxnSpMk id="35" creationId="{E1696F08-D28F-4C4F-8DE9-9DEA631F1FF4}"/>
          </ac:cxnSpMkLst>
        </pc:cxnChg>
        <pc:cxnChg chg="add del mod">
          <ac:chgData name="Qinghe Meng" userId="8ec5781b-3938-43df-a84f-730d81e9a524" providerId="ADAL" clId="{28B8E620-2A74-45DD-9AF1-E710F37014A6}" dt="2023-03-07T22:12:50.404" v="859" actId="478"/>
          <ac:cxnSpMkLst>
            <pc:docMk/>
            <pc:sldMk cId="3109864510" sldId="264"/>
            <ac:cxnSpMk id="36" creationId="{B991FBC7-AB2D-B716-47E9-262CD123945F}"/>
          </ac:cxnSpMkLst>
        </pc:cxnChg>
        <pc:cxnChg chg="add del mod">
          <ac:chgData name="Qinghe Meng" userId="8ec5781b-3938-43df-a84f-730d81e9a524" providerId="ADAL" clId="{28B8E620-2A74-45DD-9AF1-E710F37014A6}" dt="2023-03-07T22:12:50.404" v="859" actId="478"/>
          <ac:cxnSpMkLst>
            <pc:docMk/>
            <pc:sldMk cId="3109864510" sldId="264"/>
            <ac:cxnSpMk id="39" creationId="{4D231CCC-6E4D-754F-F8F0-2FC3DA17CC0F}"/>
          </ac:cxnSpMkLst>
        </pc:cxnChg>
        <pc:cxnChg chg="add del mod">
          <ac:chgData name="Qinghe Meng" userId="8ec5781b-3938-43df-a84f-730d81e9a524" providerId="ADAL" clId="{28B8E620-2A74-45DD-9AF1-E710F37014A6}" dt="2023-03-07T22:12:50.404" v="859" actId="478"/>
          <ac:cxnSpMkLst>
            <pc:docMk/>
            <pc:sldMk cId="3109864510" sldId="264"/>
            <ac:cxnSpMk id="40" creationId="{9FB7DBE2-1E8E-D885-4C8F-0965D423A32B}"/>
          </ac:cxnSpMkLst>
        </pc:cxnChg>
        <pc:cxnChg chg="add mod">
          <ac:chgData name="Qinghe Meng" userId="8ec5781b-3938-43df-a84f-730d81e9a524" providerId="ADAL" clId="{28B8E620-2A74-45DD-9AF1-E710F37014A6}" dt="2023-03-08T13:34:41.426" v="893" actId="1076"/>
          <ac:cxnSpMkLst>
            <pc:docMk/>
            <pc:sldMk cId="3109864510" sldId="264"/>
            <ac:cxnSpMk id="47" creationId="{6AAF21C2-DB84-E79A-5FBF-B2944B235F75}"/>
          </ac:cxnSpMkLst>
        </pc:cxnChg>
        <pc:cxnChg chg="add mod">
          <ac:chgData name="Qinghe Meng" userId="8ec5781b-3938-43df-a84f-730d81e9a524" providerId="ADAL" clId="{28B8E620-2A74-45DD-9AF1-E710F37014A6}" dt="2023-03-08T13:34:52.758" v="895" actId="1076"/>
          <ac:cxnSpMkLst>
            <pc:docMk/>
            <pc:sldMk cId="3109864510" sldId="264"/>
            <ac:cxnSpMk id="49" creationId="{55502BE4-D4E9-9692-53F7-4B178EFA8810}"/>
          </ac:cxnSpMkLst>
        </pc:cxnChg>
      </pc:sldChg>
      <pc:sldChg chg="addSp delSp modSp add mod">
        <pc:chgData name="Qinghe Meng" userId="8ec5781b-3938-43df-a84f-730d81e9a524" providerId="ADAL" clId="{28B8E620-2A74-45DD-9AF1-E710F37014A6}" dt="2023-03-08T13:54:45.208" v="980" actId="1076"/>
        <pc:sldMkLst>
          <pc:docMk/>
          <pc:sldMk cId="286503637" sldId="265"/>
        </pc:sldMkLst>
        <pc:spChg chg="mod">
          <ac:chgData name="Qinghe Meng" userId="8ec5781b-3938-43df-a84f-730d81e9a524" providerId="ADAL" clId="{28B8E620-2A74-45DD-9AF1-E710F37014A6}" dt="2023-03-08T13:50:11.473" v="949" actId="6549"/>
          <ac:spMkLst>
            <pc:docMk/>
            <pc:sldMk cId="286503637" sldId="265"/>
            <ac:spMk id="9" creationId="{575D03C4-8917-71CF-8B44-80EA7D788907}"/>
          </ac:spMkLst>
        </pc:spChg>
        <pc:spChg chg="mod">
          <ac:chgData name="Qinghe Meng" userId="8ec5781b-3938-43df-a84f-730d81e9a524" providerId="ADAL" clId="{28B8E620-2A74-45DD-9AF1-E710F37014A6}" dt="2023-03-08T13:54:38.839" v="978" actId="1076"/>
          <ac:spMkLst>
            <pc:docMk/>
            <pc:sldMk cId="286503637" sldId="265"/>
            <ac:spMk id="10" creationId="{7B5338E7-FFA2-7C90-12F2-82E06A82E6FB}"/>
          </ac:spMkLst>
        </pc:spChg>
        <pc:spChg chg="del">
          <ac:chgData name="Qinghe Meng" userId="8ec5781b-3938-43df-a84f-730d81e9a524" providerId="ADAL" clId="{28B8E620-2A74-45DD-9AF1-E710F37014A6}" dt="2023-03-08T13:35:36.216" v="903" actId="478"/>
          <ac:spMkLst>
            <pc:docMk/>
            <pc:sldMk cId="286503637" sldId="265"/>
            <ac:spMk id="11" creationId="{D921206A-231E-0020-D196-92FEE916AAE8}"/>
          </ac:spMkLst>
        </pc:spChg>
        <pc:spChg chg="mod">
          <ac:chgData name="Qinghe Meng" userId="8ec5781b-3938-43df-a84f-730d81e9a524" providerId="ADAL" clId="{28B8E620-2A74-45DD-9AF1-E710F37014A6}" dt="2023-03-08T13:48:40.021" v="938" actId="6549"/>
          <ac:spMkLst>
            <pc:docMk/>
            <pc:sldMk cId="286503637" sldId="265"/>
            <ac:spMk id="12" creationId="{679078DA-C4F6-5441-4EE1-B814696B77EC}"/>
          </ac:spMkLst>
        </pc:spChg>
        <pc:spChg chg="add mod">
          <ac:chgData name="Qinghe Meng" userId="8ec5781b-3938-43df-a84f-730d81e9a524" providerId="ADAL" clId="{28B8E620-2A74-45DD-9AF1-E710F37014A6}" dt="2023-03-08T13:54:07.920" v="971" actId="1076"/>
          <ac:spMkLst>
            <pc:docMk/>
            <pc:sldMk cId="286503637" sldId="265"/>
            <ac:spMk id="13" creationId="{976BBF24-E62E-8681-5596-195580A58BF5}"/>
          </ac:spMkLst>
        </pc:spChg>
        <pc:spChg chg="add mod">
          <ac:chgData name="Qinghe Meng" userId="8ec5781b-3938-43df-a84f-730d81e9a524" providerId="ADAL" clId="{28B8E620-2A74-45DD-9AF1-E710F37014A6}" dt="2023-03-08T13:54:13.350" v="973" actId="1076"/>
          <ac:spMkLst>
            <pc:docMk/>
            <pc:sldMk cId="286503637" sldId="265"/>
            <ac:spMk id="14" creationId="{2A074713-63FF-3858-0CB3-ECE061C56A17}"/>
          </ac:spMkLst>
        </pc:spChg>
        <pc:spChg chg="add mod">
          <ac:chgData name="Qinghe Meng" userId="8ec5781b-3938-43df-a84f-730d81e9a524" providerId="ADAL" clId="{28B8E620-2A74-45DD-9AF1-E710F37014A6}" dt="2023-03-08T13:54:25.525" v="977" actId="1076"/>
          <ac:spMkLst>
            <pc:docMk/>
            <pc:sldMk cId="286503637" sldId="265"/>
            <ac:spMk id="15" creationId="{E6C84921-D4E6-5DB0-D020-1E38CD558C4A}"/>
          </ac:spMkLst>
        </pc:spChg>
        <pc:spChg chg="mod">
          <ac:chgData name="Qinghe Meng" userId="8ec5781b-3938-43df-a84f-730d81e9a524" providerId="ADAL" clId="{28B8E620-2A74-45DD-9AF1-E710F37014A6}" dt="2023-03-08T13:48:58.465" v="944" actId="6549"/>
          <ac:spMkLst>
            <pc:docMk/>
            <pc:sldMk cId="286503637" sldId="265"/>
            <ac:spMk id="18" creationId="{D4333F05-0680-18CF-504F-B8BD54E2D9E8}"/>
          </ac:spMkLst>
        </pc:spChg>
        <pc:spChg chg="add mod">
          <ac:chgData name="Qinghe Meng" userId="8ec5781b-3938-43df-a84f-730d81e9a524" providerId="ADAL" clId="{28B8E620-2A74-45DD-9AF1-E710F37014A6}" dt="2023-03-08T13:54:21.866" v="976" actId="1076"/>
          <ac:spMkLst>
            <pc:docMk/>
            <pc:sldMk cId="286503637" sldId="265"/>
            <ac:spMk id="19" creationId="{4874CE69-37C8-E5B6-93B5-B14A8941E6DA}"/>
          </ac:spMkLst>
        </pc:spChg>
        <pc:spChg chg="add mod">
          <ac:chgData name="Qinghe Meng" userId="8ec5781b-3938-43df-a84f-730d81e9a524" providerId="ADAL" clId="{28B8E620-2A74-45DD-9AF1-E710F37014A6}" dt="2023-03-08T13:54:45.208" v="980" actId="1076"/>
          <ac:spMkLst>
            <pc:docMk/>
            <pc:sldMk cId="286503637" sldId="265"/>
            <ac:spMk id="20" creationId="{903E4F16-ECCF-5812-4EBE-CFF0D9E2C421}"/>
          </ac:spMkLst>
        </pc:spChg>
        <pc:spChg chg="del">
          <ac:chgData name="Qinghe Meng" userId="8ec5781b-3938-43df-a84f-730d81e9a524" providerId="ADAL" clId="{28B8E620-2A74-45DD-9AF1-E710F37014A6}" dt="2023-03-08T13:35:41.385" v="905" actId="478"/>
          <ac:spMkLst>
            <pc:docMk/>
            <pc:sldMk cId="286503637" sldId="265"/>
            <ac:spMk id="22" creationId="{55191183-448F-3A89-082B-417C3962917F}"/>
          </ac:spMkLst>
        </pc:spChg>
        <pc:spChg chg="del">
          <ac:chgData name="Qinghe Meng" userId="8ec5781b-3938-43df-a84f-730d81e9a524" providerId="ADAL" clId="{28B8E620-2A74-45DD-9AF1-E710F37014A6}" dt="2023-03-08T13:35:41.385" v="905" actId="478"/>
          <ac:spMkLst>
            <pc:docMk/>
            <pc:sldMk cId="286503637" sldId="265"/>
            <ac:spMk id="23" creationId="{BEF85C10-3C77-F40D-406B-8EB8F77C08FF}"/>
          </ac:spMkLst>
        </pc:spChg>
        <pc:spChg chg="del">
          <ac:chgData name="Qinghe Meng" userId="8ec5781b-3938-43df-a84f-730d81e9a524" providerId="ADAL" clId="{28B8E620-2A74-45DD-9AF1-E710F37014A6}" dt="2023-03-08T13:35:41.385" v="905" actId="478"/>
          <ac:spMkLst>
            <pc:docMk/>
            <pc:sldMk cId="286503637" sldId="265"/>
            <ac:spMk id="26" creationId="{05684DA0-9C50-E834-B7E4-3ADB81CAFCBE}"/>
          </ac:spMkLst>
        </pc:spChg>
        <pc:spChg chg="del">
          <ac:chgData name="Qinghe Meng" userId="8ec5781b-3938-43df-a84f-730d81e9a524" providerId="ADAL" clId="{28B8E620-2A74-45DD-9AF1-E710F37014A6}" dt="2023-03-08T13:35:41.385" v="905" actId="478"/>
          <ac:spMkLst>
            <pc:docMk/>
            <pc:sldMk cId="286503637" sldId="265"/>
            <ac:spMk id="30" creationId="{8238379B-330D-3D4D-D3B6-E1AD32FAD609}"/>
          </ac:spMkLst>
        </pc:spChg>
        <pc:picChg chg="mod">
          <ac:chgData name="Qinghe Meng" userId="8ec5781b-3938-43df-a84f-730d81e9a524" providerId="ADAL" clId="{28B8E620-2A74-45DD-9AF1-E710F37014A6}" dt="2023-03-08T13:49:34.891" v="946"/>
          <ac:picMkLst>
            <pc:docMk/>
            <pc:sldMk cId="286503637" sldId="265"/>
            <ac:picMk id="3" creationId="{4C1CE13D-228E-93F0-FAE1-4570D87B6D40}"/>
          </ac:picMkLst>
        </pc:picChg>
        <pc:picChg chg="add mod">
          <ac:chgData name="Qinghe Meng" userId="8ec5781b-3938-43df-a84f-730d81e9a524" providerId="ADAL" clId="{28B8E620-2A74-45DD-9AF1-E710F37014A6}" dt="2023-03-08T13:48:18.924" v="932" actId="14100"/>
          <ac:picMkLst>
            <pc:docMk/>
            <pc:sldMk cId="286503637" sldId="265"/>
            <ac:picMk id="4" creationId="{C1422E7B-F8CE-7E27-5882-B144E8BD26BA}"/>
          </ac:picMkLst>
        </pc:picChg>
        <pc:cxnChg chg="add mod">
          <ac:chgData name="Qinghe Meng" userId="8ec5781b-3938-43df-a84f-730d81e9a524" providerId="ADAL" clId="{28B8E620-2A74-45DD-9AF1-E710F37014A6}" dt="2023-03-08T13:53:37.321" v="962" actId="1076"/>
          <ac:cxnSpMkLst>
            <pc:docMk/>
            <pc:sldMk cId="286503637" sldId="265"/>
            <ac:cxnSpMk id="2" creationId="{2FCA63FF-EB17-85FF-5A01-C5FF9F076278}"/>
          </ac:cxnSpMkLst>
        </pc:cxnChg>
        <pc:cxnChg chg="add mod">
          <ac:chgData name="Qinghe Meng" userId="8ec5781b-3938-43df-a84f-730d81e9a524" providerId="ADAL" clId="{28B8E620-2A74-45DD-9AF1-E710F37014A6}" dt="2023-03-08T13:53:57.026" v="968" actId="1076"/>
          <ac:cxnSpMkLst>
            <pc:docMk/>
            <pc:sldMk cId="286503637" sldId="265"/>
            <ac:cxnSpMk id="5" creationId="{7F228EDD-E5B0-0ABF-2FBD-882EB26F83A8}"/>
          </ac:cxnSpMkLst>
        </pc:cxnChg>
        <pc:cxnChg chg="add mod">
          <ac:chgData name="Qinghe Meng" userId="8ec5781b-3938-43df-a84f-730d81e9a524" providerId="ADAL" clId="{28B8E620-2A74-45DD-9AF1-E710F37014A6}" dt="2023-03-08T13:53:58.659" v="969" actId="1076"/>
          <ac:cxnSpMkLst>
            <pc:docMk/>
            <pc:sldMk cId="286503637" sldId="265"/>
            <ac:cxnSpMk id="7" creationId="{47295D9E-8122-12ED-FCBA-F5CD608C8247}"/>
          </ac:cxnSpMkLst>
        </pc:cxnChg>
        <pc:cxnChg chg="add mod">
          <ac:chgData name="Qinghe Meng" userId="8ec5781b-3938-43df-a84f-730d81e9a524" providerId="ADAL" clId="{28B8E620-2A74-45DD-9AF1-E710F37014A6}" dt="2023-03-08T13:53:45.801" v="966" actId="1076"/>
          <ac:cxnSpMkLst>
            <pc:docMk/>
            <pc:sldMk cId="286503637" sldId="265"/>
            <ac:cxnSpMk id="11" creationId="{4D224DBE-9287-9C05-B58C-D63207B8F69B}"/>
          </ac:cxnSpMkLst>
        </pc:cxnChg>
        <pc:cxnChg chg="mod">
          <ac:chgData name="Qinghe Meng" userId="8ec5781b-3938-43df-a84f-730d81e9a524" providerId="ADAL" clId="{28B8E620-2A74-45DD-9AF1-E710F37014A6}" dt="2023-03-08T13:49:02.064" v="945" actId="1076"/>
          <ac:cxnSpMkLst>
            <pc:docMk/>
            <pc:sldMk cId="286503637" sldId="265"/>
            <ac:cxnSpMk id="16" creationId="{BA2CF221-E61B-773A-8D37-1E728A7C8930}"/>
          </ac:cxnSpMkLst>
        </pc:cxnChg>
        <pc:cxnChg chg="del">
          <ac:chgData name="Qinghe Meng" userId="8ec5781b-3938-43df-a84f-730d81e9a524" providerId="ADAL" clId="{28B8E620-2A74-45DD-9AF1-E710F37014A6}" dt="2023-03-08T13:35:39.176" v="904" actId="478"/>
          <ac:cxnSpMkLst>
            <pc:docMk/>
            <pc:sldMk cId="286503637" sldId="265"/>
            <ac:cxnSpMk id="20" creationId="{142AF06B-CCA3-83F6-10FC-81386ECD21D1}"/>
          </ac:cxnSpMkLst>
        </pc:cxnChg>
        <pc:cxnChg chg="del">
          <ac:chgData name="Qinghe Meng" userId="8ec5781b-3938-43df-a84f-730d81e9a524" providerId="ADAL" clId="{28B8E620-2A74-45DD-9AF1-E710F37014A6}" dt="2023-03-08T13:35:41.385" v="905" actId="478"/>
          <ac:cxnSpMkLst>
            <pc:docMk/>
            <pc:sldMk cId="286503637" sldId="265"/>
            <ac:cxnSpMk id="21" creationId="{C38FA175-C3BE-39CC-CD50-F48BF38866F2}"/>
          </ac:cxnSpMkLst>
        </pc:cxnChg>
        <pc:cxnChg chg="del">
          <ac:chgData name="Qinghe Meng" userId="8ec5781b-3938-43df-a84f-730d81e9a524" providerId="ADAL" clId="{28B8E620-2A74-45DD-9AF1-E710F37014A6}" dt="2023-03-08T13:35:41.385" v="905" actId="478"/>
          <ac:cxnSpMkLst>
            <pc:docMk/>
            <pc:sldMk cId="286503637" sldId="265"/>
            <ac:cxnSpMk id="24" creationId="{EBDEA6AD-DDD3-980F-F59A-2DA721D65360}"/>
          </ac:cxnSpMkLst>
        </pc:cxnChg>
        <pc:cxnChg chg="del">
          <ac:chgData name="Qinghe Meng" userId="8ec5781b-3938-43df-a84f-730d81e9a524" providerId="ADAL" clId="{28B8E620-2A74-45DD-9AF1-E710F37014A6}" dt="2023-03-08T13:35:41.385" v="905" actId="478"/>
          <ac:cxnSpMkLst>
            <pc:docMk/>
            <pc:sldMk cId="286503637" sldId="265"/>
            <ac:cxnSpMk id="25" creationId="{FBFB2672-1214-2D5E-9C09-581D441F4C16}"/>
          </ac:cxnSpMkLst>
        </pc:cxnChg>
      </pc:sldChg>
    </pc:docChg>
  </pc:docChgLst>
  <pc:docChgLst>
    <pc:chgData name="Qinghe Meng" userId="8ec5781b-3938-43df-a84f-730d81e9a524" providerId="ADAL" clId="{06F2C50D-C49D-4BEA-A599-4BA810DF5E88}"/>
    <pc:docChg chg="modSld sldOrd">
      <pc:chgData name="Qinghe Meng" userId="8ec5781b-3938-43df-a84f-730d81e9a524" providerId="ADAL" clId="{06F2C50D-C49D-4BEA-A599-4BA810DF5E88}" dt="2023-08-17T20:47:05.969" v="39" actId="6549"/>
      <pc:docMkLst>
        <pc:docMk/>
      </pc:docMkLst>
      <pc:sldChg chg="modSp mod">
        <pc:chgData name="Qinghe Meng" userId="8ec5781b-3938-43df-a84f-730d81e9a524" providerId="ADAL" clId="{06F2C50D-C49D-4BEA-A599-4BA810DF5E88}" dt="2023-08-17T20:45:59.398" v="27" actId="20577"/>
        <pc:sldMkLst>
          <pc:docMk/>
          <pc:sldMk cId="1416481732" sldId="256"/>
        </pc:sldMkLst>
        <pc:spChg chg="mod">
          <ac:chgData name="Qinghe Meng" userId="8ec5781b-3938-43df-a84f-730d81e9a524" providerId="ADAL" clId="{06F2C50D-C49D-4BEA-A599-4BA810DF5E88}" dt="2023-08-17T20:45:59.398" v="27" actId="20577"/>
          <ac:spMkLst>
            <pc:docMk/>
            <pc:sldMk cId="1416481732" sldId="256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7T20:46:06.066" v="28" actId="20577"/>
        <pc:sldMkLst>
          <pc:docMk/>
          <pc:sldMk cId="1879692957" sldId="258"/>
        </pc:sldMkLst>
        <pc:spChg chg="mod">
          <ac:chgData name="Qinghe Meng" userId="8ec5781b-3938-43df-a84f-730d81e9a524" providerId="ADAL" clId="{06F2C50D-C49D-4BEA-A599-4BA810DF5E88}" dt="2023-08-17T20:46:06.066" v="28" actId="20577"/>
          <ac:spMkLst>
            <pc:docMk/>
            <pc:sldMk cId="1879692957" sldId="258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7T20:46:10.466" v="29" actId="20577"/>
        <pc:sldMkLst>
          <pc:docMk/>
          <pc:sldMk cId="2029615342" sldId="259"/>
        </pc:sldMkLst>
        <pc:spChg chg="mod">
          <ac:chgData name="Qinghe Meng" userId="8ec5781b-3938-43df-a84f-730d81e9a524" providerId="ADAL" clId="{06F2C50D-C49D-4BEA-A599-4BA810DF5E88}" dt="2023-08-17T20:46:10.466" v="29" actId="20577"/>
          <ac:spMkLst>
            <pc:docMk/>
            <pc:sldMk cId="2029615342" sldId="259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7T20:46:15.761" v="30" actId="20577"/>
        <pc:sldMkLst>
          <pc:docMk/>
          <pc:sldMk cId="1195960701" sldId="260"/>
        </pc:sldMkLst>
        <pc:spChg chg="mod">
          <ac:chgData name="Qinghe Meng" userId="8ec5781b-3938-43df-a84f-730d81e9a524" providerId="ADAL" clId="{06F2C50D-C49D-4BEA-A599-4BA810DF5E88}" dt="2023-08-17T20:46:15.761" v="30" actId="20577"/>
          <ac:spMkLst>
            <pc:docMk/>
            <pc:sldMk cId="1195960701" sldId="260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7T20:46:23.109" v="32" actId="6549"/>
        <pc:sldMkLst>
          <pc:docMk/>
          <pc:sldMk cId="945282863" sldId="261"/>
        </pc:sldMkLst>
        <pc:spChg chg="mod">
          <ac:chgData name="Qinghe Meng" userId="8ec5781b-3938-43df-a84f-730d81e9a524" providerId="ADAL" clId="{06F2C50D-C49D-4BEA-A599-4BA810DF5E88}" dt="2023-08-17T20:46:23.109" v="32" actId="6549"/>
          <ac:spMkLst>
            <pc:docMk/>
            <pc:sldMk cId="945282863" sldId="261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0T13:22:05.652" v="21" actId="6549"/>
        <pc:sldMkLst>
          <pc:docMk/>
          <pc:sldMk cId="495224942" sldId="262"/>
        </pc:sldMkLst>
        <pc:spChg chg="mod">
          <ac:chgData name="Qinghe Meng" userId="8ec5781b-3938-43df-a84f-730d81e9a524" providerId="ADAL" clId="{06F2C50D-C49D-4BEA-A599-4BA810DF5E88}" dt="2023-08-10T13:22:05.652" v="21" actId="6549"/>
          <ac:spMkLst>
            <pc:docMk/>
            <pc:sldMk cId="495224942" sldId="262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7T20:46:54.160" v="35" actId="20577"/>
        <pc:sldMkLst>
          <pc:docMk/>
          <pc:sldMk cId="3465296187" sldId="263"/>
        </pc:sldMkLst>
        <pc:spChg chg="mod">
          <ac:chgData name="Qinghe Meng" userId="8ec5781b-3938-43df-a84f-730d81e9a524" providerId="ADAL" clId="{06F2C50D-C49D-4BEA-A599-4BA810DF5E88}" dt="2023-08-17T20:46:54.160" v="35" actId="20577"/>
          <ac:spMkLst>
            <pc:docMk/>
            <pc:sldMk cId="3465296187" sldId="263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7T20:46:59.217" v="36" actId="20577"/>
        <pc:sldMkLst>
          <pc:docMk/>
          <pc:sldMk cId="3109864510" sldId="264"/>
        </pc:sldMkLst>
        <pc:spChg chg="mod">
          <ac:chgData name="Qinghe Meng" userId="8ec5781b-3938-43df-a84f-730d81e9a524" providerId="ADAL" clId="{06F2C50D-C49D-4BEA-A599-4BA810DF5E88}" dt="2023-08-17T20:46:59.217" v="36" actId="20577"/>
          <ac:spMkLst>
            <pc:docMk/>
            <pc:sldMk cId="3109864510" sldId="264"/>
            <ac:spMk id="6" creationId="{5F43ACBE-7784-620B-7DE9-28F3500AA41B}"/>
          </ac:spMkLst>
        </pc:spChg>
      </pc:sldChg>
      <pc:sldChg chg="modSp mod">
        <pc:chgData name="Qinghe Meng" userId="8ec5781b-3938-43df-a84f-730d81e9a524" providerId="ADAL" clId="{06F2C50D-C49D-4BEA-A599-4BA810DF5E88}" dt="2023-08-17T20:47:05.969" v="39" actId="6549"/>
        <pc:sldMkLst>
          <pc:docMk/>
          <pc:sldMk cId="286503637" sldId="265"/>
        </pc:sldMkLst>
        <pc:spChg chg="mod">
          <ac:chgData name="Qinghe Meng" userId="8ec5781b-3938-43df-a84f-730d81e9a524" providerId="ADAL" clId="{06F2C50D-C49D-4BEA-A599-4BA810DF5E88}" dt="2023-08-17T20:47:05.969" v="39" actId="6549"/>
          <ac:spMkLst>
            <pc:docMk/>
            <pc:sldMk cId="286503637" sldId="265"/>
            <ac:spMk id="6" creationId="{5F43ACBE-7784-620B-7DE9-28F3500AA41B}"/>
          </ac:spMkLst>
        </pc:spChg>
      </pc:sldChg>
      <pc:sldChg chg="addSp modSp mod ord">
        <pc:chgData name="Qinghe Meng" userId="8ec5781b-3938-43df-a84f-730d81e9a524" providerId="ADAL" clId="{06F2C50D-C49D-4BEA-A599-4BA810DF5E88}" dt="2023-08-17T20:46:39.865" v="34"/>
        <pc:sldMkLst>
          <pc:docMk/>
          <pc:sldMk cId="176818767" sldId="266"/>
        </pc:sldMkLst>
        <pc:spChg chg="add mod">
          <ac:chgData name="Qinghe Meng" userId="8ec5781b-3938-43df-a84f-730d81e9a524" providerId="ADAL" clId="{06F2C50D-C49D-4BEA-A599-4BA810DF5E88}" dt="2023-08-10T13:21:15.406" v="9" actId="1076"/>
          <ac:spMkLst>
            <pc:docMk/>
            <pc:sldMk cId="176818767" sldId="266"/>
            <ac:spMk id="2" creationId="{21ADCAD5-6A83-4F22-E14E-D253749BAB74}"/>
          </ac:spMkLst>
        </pc:spChg>
        <pc:graphicFrameChg chg="mod">
          <ac:chgData name="Qinghe Meng" userId="8ec5781b-3938-43df-a84f-730d81e9a524" providerId="ADAL" clId="{06F2C50D-C49D-4BEA-A599-4BA810DF5E88}" dt="2023-08-10T13:22:39.766" v="26" actId="1076"/>
          <ac:graphicFrameMkLst>
            <pc:docMk/>
            <pc:sldMk cId="176818767" sldId="266"/>
            <ac:graphicFrameMk id="5" creationId="{8CF2E221-2326-7523-55DA-B3261E91F1E9}"/>
          </ac:graphicFrameMkLst>
        </pc:graphicFrameChg>
      </pc:sldChg>
    </pc:docChg>
  </pc:docChgLst>
  <pc:docChgLst>
    <pc:chgData name="Qinghe Meng" userId="8ec5781b-3938-43df-a84f-730d81e9a524" providerId="ADAL" clId="{292932D7-7F6F-4295-9162-2DFCEAD4270B}"/>
    <pc:docChg chg="custSel addSld modSld">
      <pc:chgData name="Qinghe Meng" userId="8ec5781b-3938-43df-a84f-730d81e9a524" providerId="ADAL" clId="{292932D7-7F6F-4295-9162-2DFCEAD4270B}" dt="2023-04-20T19:39:29.875" v="6" actId="1076"/>
      <pc:docMkLst>
        <pc:docMk/>
      </pc:docMkLst>
      <pc:sldChg chg="addSp delSp modSp new mod">
        <pc:chgData name="Qinghe Meng" userId="8ec5781b-3938-43df-a84f-730d81e9a524" providerId="ADAL" clId="{292932D7-7F6F-4295-9162-2DFCEAD4270B}" dt="2023-04-20T19:39:29.875" v="6" actId="1076"/>
        <pc:sldMkLst>
          <pc:docMk/>
          <pc:sldMk cId="176818767" sldId="266"/>
        </pc:sldMkLst>
        <pc:spChg chg="del">
          <ac:chgData name="Qinghe Meng" userId="8ec5781b-3938-43df-a84f-730d81e9a524" providerId="ADAL" clId="{292932D7-7F6F-4295-9162-2DFCEAD4270B}" dt="2023-04-20T19:36:29.268" v="1" actId="478"/>
          <ac:spMkLst>
            <pc:docMk/>
            <pc:sldMk cId="176818767" sldId="266"/>
            <ac:spMk id="2" creationId="{DC1123BE-9DBE-4E77-0A5E-C8C4B42FAACF}"/>
          </ac:spMkLst>
        </pc:spChg>
        <pc:spChg chg="del">
          <ac:chgData name="Qinghe Meng" userId="8ec5781b-3938-43df-a84f-730d81e9a524" providerId="ADAL" clId="{292932D7-7F6F-4295-9162-2DFCEAD4270B}" dt="2023-04-20T19:36:31.098" v="2" actId="478"/>
          <ac:spMkLst>
            <pc:docMk/>
            <pc:sldMk cId="176818767" sldId="266"/>
            <ac:spMk id="3" creationId="{793D9BE6-3785-77AE-7A24-BB566E111622}"/>
          </ac:spMkLst>
        </pc:spChg>
        <pc:graphicFrameChg chg="add mod">
          <ac:chgData name="Qinghe Meng" userId="8ec5781b-3938-43df-a84f-730d81e9a524" providerId="ADAL" clId="{292932D7-7F6F-4295-9162-2DFCEAD4270B}" dt="2023-04-20T19:36:36.048" v="4" actId="1076"/>
          <ac:graphicFrameMkLst>
            <pc:docMk/>
            <pc:sldMk cId="176818767" sldId="266"/>
            <ac:graphicFrameMk id="4" creationId="{9EDA62E9-F027-526E-6829-27845E0FE706}"/>
          </ac:graphicFrameMkLst>
        </pc:graphicFrameChg>
        <pc:graphicFrameChg chg="add mod">
          <ac:chgData name="Qinghe Meng" userId="8ec5781b-3938-43df-a84f-730d81e9a524" providerId="ADAL" clId="{292932D7-7F6F-4295-9162-2DFCEAD4270B}" dt="2023-04-20T19:39:29.875" v="6" actId="1076"/>
          <ac:graphicFrameMkLst>
            <pc:docMk/>
            <pc:sldMk cId="176818767" sldId="266"/>
            <ac:graphicFrameMk id="5" creationId="{8CF2E221-2326-7523-55DA-B3261E91F1E9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7E6A5-95D0-AF82-1136-294D642C1A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94AAAC-006B-33F8-BC95-BA749CC8D8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8CEBB-2A23-5240-A788-52441C408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8B0D05-D29C-26F9-2291-DA2C631883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3D7AED-4143-F82F-FE4C-FB8CB3C2F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731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3BF18-B99F-794A-7C30-8DB81B50E7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BF2D5E-C927-AF6D-8A67-A10320909D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B69462-3D94-8E83-E461-EE55BAE045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80438-8451-1BED-883F-52DC56E20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7CF756-A77A-0689-36E7-5409E2A91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525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B20E09-6F0D-3BA8-5273-0D9F7C509E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78439F-752B-242F-CA29-0C175D8C10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AD3919-705F-36E9-C69A-73B24019D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D9DF88-BAC9-2869-3A22-943416944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A443F9-5D53-8C38-665F-946AE63D8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263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5228DF-C848-B927-575F-B68C76652B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ED4FF7-3EAD-ABA3-C8C3-0DB6FB463C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B94F79-2C6E-2C36-AE3A-131EF9ED7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D81DEB-B152-00F4-3CEE-A19FADD88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E9AAF0-9DA4-A73C-D9E1-629ADE7B2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440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EC6EF7-C5CB-66AA-F32D-B8A8EFA32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8D9491-2964-0A8E-BD16-B94B93EF94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233853-16A4-9629-B4BF-ED233CBCA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2B8940-16C1-43F3-E8CD-AD68CEE87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20E25C-48B3-2A1B-3B06-FE7288C95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553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70E1A6-9C30-1385-2894-5D95048871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48BF5-CD3E-F9C0-404D-2822612A27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9D23B5-055F-C15B-3E36-46A684D12C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3E8BC8-A971-D459-BCD4-62DFA74D3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4FF57E-6D01-3041-21F9-ED84AB8FE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2CE0D0-6D9C-82F2-7A26-20BB7EA23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304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4677F8-39B2-A87F-A105-10C2C5663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BB38A1-45D9-410A-0301-120E8FE372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0F1FDF-5EA4-2397-D0BB-3F573961BE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967BF3-4DA1-314A-2ED3-24FBFED1A8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1368A7C-444A-1C08-F156-4ABB2B1B92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4DA09E-0570-CB37-6806-1D8B0BE0F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410545-486D-14F1-EFC2-FCBE7749F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C40063-00C9-AD69-800D-E27611F2C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767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60943E-C056-33CF-D32A-F11FAE1BD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ED1DC8-0A73-7E85-6E01-C12731400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A9CA1E-9BF7-7B4D-18ED-E6BFE355E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BE8353-8534-BDC0-C789-D8299CCDF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767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DE859B-04D0-ED71-42D9-CEEA87243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AD65CEC-4F3C-EC98-B21A-0F86DAD90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D005FE-B25E-BBA4-BDBB-56C21D4D9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877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90429F-E128-AFA7-1C42-31411D465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7B1512-AE6C-BB33-970A-7561BA7874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CBA9F7-DF27-7A24-E288-C181BD9C21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0D5CC4-C6B7-B33F-3E26-21D78D086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F82797-DFF5-49E8-6C02-3B2E6E443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765DF7-B67E-E0DE-4B18-BFEF95FAB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371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A518F6-2A5A-BCFA-7DF1-B278E0E79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88BCC2-131E-F0A8-B7B4-07CD96C176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D12F12-3C85-2E2C-B8D5-3DB4DCD2A2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F92B19-C379-A878-5A41-CA19F8AC6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60F998-5544-3426-8B0D-C3A5772F1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8FDBB7-9887-10FC-036D-CBCDEFCCA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319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F00CC1-DB1F-3E7B-06E2-CAEC74059E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593518-041A-3302-64A6-E3F854253B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2006C4-1CAF-B6E5-E9FB-FDAA626BC8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6BCB14-F24B-44EA-835C-5C2C4A7FCE91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50BA82-C92C-75FC-0CBC-FF1A4439E9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E75781-4225-7EAE-0A60-BCC52DC4A3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A8F98-FE8E-4E2D-BAD0-653CF2A29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61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wmf"/><Relationship Id="rId4" Type="http://schemas.openxmlformats.org/officeDocument/2006/relationships/oleObject" Target="../embeddings/oleObject2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document&#10;&#10;Description automatically generated with low confidence">
            <a:extLst>
              <a:ext uri="{FF2B5EF4-FFF2-40B4-BE49-F238E27FC236}">
                <a16:creationId xmlns:a16="http://schemas.microsoft.com/office/drawing/2014/main" id="{D82EFDB1-9CFD-85D8-4F2D-A78971F310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5512" y="1661532"/>
            <a:ext cx="4352028" cy="325536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2562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6 A–Cytochrome 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C2A375-824A-82AA-A2B5-93C1259A1AA2}"/>
              </a:ext>
            </a:extLst>
          </p:cNvPr>
          <p:cNvSpPr txBox="1"/>
          <p:nvPr/>
        </p:nvSpPr>
        <p:spPr>
          <a:xfrm>
            <a:off x="715167" y="548191"/>
            <a:ext cx="1503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ytochrome 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611047" y="648113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410561" y="2472645"/>
            <a:ext cx="357790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1277511" y="135395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1206A-231E-0020-D196-92FEE916AAE8}"/>
              </a:ext>
            </a:extLst>
          </p:cNvPr>
          <p:cNvSpPr txBox="1"/>
          <p:nvPr/>
        </p:nvSpPr>
        <p:spPr>
          <a:xfrm>
            <a:off x="6418526" y="134746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644376" y="2145815"/>
            <a:ext cx="35779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4A49646-5AEB-3C94-B330-49C665D9EAC5}"/>
              </a:ext>
            </a:extLst>
          </p:cNvPr>
          <p:cNvCxnSpPr/>
          <p:nvPr/>
        </p:nvCxnSpPr>
        <p:spPr>
          <a:xfrm>
            <a:off x="2531327" y="4739268"/>
            <a:ext cx="152771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FE61159-CFC4-C829-6024-68A8ACFD011A}"/>
              </a:ext>
            </a:extLst>
          </p:cNvPr>
          <p:cNvCxnSpPr/>
          <p:nvPr/>
        </p:nvCxnSpPr>
        <p:spPr>
          <a:xfrm>
            <a:off x="4177990" y="4739268"/>
            <a:ext cx="152771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C261C758-AAB1-EF69-A00E-56FF272F3C57}"/>
              </a:ext>
            </a:extLst>
          </p:cNvPr>
          <p:cNvSpPr txBox="1"/>
          <p:nvPr/>
        </p:nvSpPr>
        <p:spPr>
          <a:xfrm>
            <a:off x="2971955" y="4930444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795073-D149-A961-A859-74CE8F1E8897}"/>
              </a:ext>
            </a:extLst>
          </p:cNvPr>
          <p:cNvSpPr txBox="1"/>
          <p:nvPr/>
        </p:nvSpPr>
        <p:spPr>
          <a:xfrm>
            <a:off x="4439787" y="4916895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3B6BBA58-A299-2A37-5CEC-978EB9B70228}"/>
              </a:ext>
            </a:extLst>
          </p:cNvPr>
          <p:cNvCxnSpPr/>
          <p:nvPr/>
        </p:nvCxnSpPr>
        <p:spPr>
          <a:xfrm flipH="1">
            <a:off x="6017540" y="4326673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A8A22D10-C564-EA86-568A-81788AE878D1}"/>
              </a:ext>
            </a:extLst>
          </p:cNvPr>
          <p:cNvCxnSpPr/>
          <p:nvPr/>
        </p:nvCxnSpPr>
        <p:spPr>
          <a:xfrm flipH="1">
            <a:off x="10142290" y="3289213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29434CD-0AE8-3366-307C-AFBDF1DE142E}"/>
              </a:ext>
            </a:extLst>
          </p:cNvPr>
          <p:cNvSpPr txBox="1"/>
          <p:nvPr/>
        </p:nvSpPr>
        <p:spPr>
          <a:xfrm>
            <a:off x="5935790" y="4357248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15 K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8FE7233-27CA-C363-B032-A7A08378566D}"/>
              </a:ext>
            </a:extLst>
          </p:cNvPr>
          <p:cNvSpPr txBox="1"/>
          <p:nvPr/>
        </p:nvSpPr>
        <p:spPr>
          <a:xfrm>
            <a:off x="10122101" y="339537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AB42F7E-5822-5CDB-934F-95E06CB22D28}"/>
              </a:ext>
            </a:extLst>
          </p:cNvPr>
          <p:cNvSpPr txBox="1"/>
          <p:nvPr/>
        </p:nvSpPr>
        <p:spPr>
          <a:xfrm>
            <a:off x="636330" y="5501586"/>
            <a:ext cx="609414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pic>
        <p:nvPicPr>
          <p:cNvPr id="4" name="Picture 3" descr="A picture containing text, white, black&#10;&#10;Description automatically generated">
            <a:extLst>
              <a:ext uri="{FF2B5EF4-FFF2-40B4-BE49-F238E27FC236}">
                <a16:creationId xmlns:a16="http://schemas.microsoft.com/office/drawing/2014/main" id="{9D092A4F-57C3-5FFE-C05E-2E71691DC4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2166" y="1991426"/>
            <a:ext cx="2996633" cy="2875148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D8F648D-FE8D-6396-DB7A-EC383330835D}"/>
              </a:ext>
            </a:extLst>
          </p:cNvPr>
          <p:cNvCxnSpPr>
            <a:cxnSpLocks/>
          </p:cNvCxnSpPr>
          <p:nvPr/>
        </p:nvCxnSpPr>
        <p:spPr>
          <a:xfrm>
            <a:off x="8783444" y="3533869"/>
            <a:ext cx="112242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1F6EB24D-0CF5-B5CC-6EFA-065D60F7DBD2}"/>
              </a:ext>
            </a:extLst>
          </p:cNvPr>
          <p:cNvCxnSpPr>
            <a:cxnSpLocks/>
          </p:cNvCxnSpPr>
          <p:nvPr/>
        </p:nvCxnSpPr>
        <p:spPr>
          <a:xfrm>
            <a:off x="7412163" y="3506782"/>
            <a:ext cx="112242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F5C4E1DF-0D94-BBD4-D931-B5E010483901}"/>
              </a:ext>
            </a:extLst>
          </p:cNvPr>
          <p:cNvSpPr txBox="1"/>
          <p:nvPr/>
        </p:nvSpPr>
        <p:spPr>
          <a:xfrm>
            <a:off x="8901751" y="3672369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6D2B03B-B09F-2E64-0C4D-EA3EBEAD5E27}"/>
              </a:ext>
            </a:extLst>
          </p:cNvPr>
          <p:cNvSpPr txBox="1"/>
          <p:nvPr/>
        </p:nvSpPr>
        <p:spPr>
          <a:xfrm>
            <a:off x="7672705" y="3672763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</p:spTree>
    <p:extLst>
      <p:ext uri="{BB962C8B-B14F-4D97-AF65-F5344CB8AC3E}">
        <p14:creationId xmlns:p14="http://schemas.microsoft.com/office/powerpoint/2010/main" val="14164817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266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igure.8B </a:t>
            </a:r>
            <a:r>
              <a:rPr lang="en-US" dirty="0"/>
              <a:t>–Total caspase-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316399" y="1147395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054495" y="2127838"/>
            <a:ext cx="46901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1092874" y="778236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527127" y="2769486"/>
            <a:ext cx="35779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230C47-C344-7B52-BAB6-095DD2A66DC7}"/>
              </a:ext>
            </a:extLst>
          </p:cNvPr>
          <p:cNvSpPr txBox="1"/>
          <p:nvPr/>
        </p:nvSpPr>
        <p:spPr>
          <a:xfrm>
            <a:off x="865030" y="5619583"/>
            <a:ext cx="307134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4C1CE13D-228E-93F0-FAE1-4570D87B6D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4442" y="1126670"/>
            <a:ext cx="4332689" cy="3203591"/>
          </a:xfrm>
          <a:prstGeom prst="rect">
            <a:avLst/>
          </a:prstGeom>
        </p:spPr>
      </p:pic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A2CF221-E61B-773A-8D37-1E728A7C8930}"/>
              </a:ext>
            </a:extLst>
          </p:cNvPr>
          <p:cNvCxnSpPr>
            <a:cxnSpLocks/>
          </p:cNvCxnSpPr>
          <p:nvPr/>
        </p:nvCxnSpPr>
        <p:spPr>
          <a:xfrm flipH="1">
            <a:off x="11329362" y="3923648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4333F05-0680-18CF-504F-B8BD54E2D9E8}"/>
              </a:ext>
            </a:extLst>
          </p:cNvPr>
          <p:cNvSpPr txBox="1"/>
          <p:nvPr/>
        </p:nvSpPr>
        <p:spPr>
          <a:xfrm>
            <a:off x="11230584" y="405326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3 KD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79FEEF68-1AB4-B520-7238-60C22415BADC}"/>
              </a:ext>
            </a:extLst>
          </p:cNvPr>
          <p:cNvCxnSpPr>
            <a:cxnSpLocks/>
          </p:cNvCxnSpPr>
          <p:nvPr/>
        </p:nvCxnSpPr>
        <p:spPr>
          <a:xfrm flipH="1">
            <a:off x="5695231" y="3307245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E0D9DCDA-E2A3-72CC-0C0D-7A0B56C7EC3E}"/>
              </a:ext>
            </a:extLst>
          </p:cNvPr>
          <p:cNvSpPr txBox="1"/>
          <p:nvPr/>
        </p:nvSpPr>
        <p:spPr>
          <a:xfrm>
            <a:off x="5645196" y="3400526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5 KD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E1696F08-D28F-4C4F-8DE9-9DEA631F1FF4}"/>
              </a:ext>
            </a:extLst>
          </p:cNvPr>
          <p:cNvCxnSpPr>
            <a:cxnSpLocks/>
          </p:cNvCxnSpPr>
          <p:nvPr/>
        </p:nvCxnSpPr>
        <p:spPr>
          <a:xfrm>
            <a:off x="1896751" y="3925166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B991FBC7-AB2D-B716-47E9-262CD123945F}"/>
              </a:ext>
            </a:extLst>
          </p:cNvPr>
          <p:cNvCxnSpPr>
            <a:cxnSpLocks/>
          </p:cNvCxnSpPr>
          <p:nvPr/>
        </p:nvCxnSpPr>
        <p:spPr>
          <a:xfrm>
            <a:off x="2757732" y="3925166"/>
            <a:ext cx="74606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1316D5BC-DEE3-DE3E-1C67-11D6FED8EE3D}"/>
              </a:ext>
            </a:extLst>
          </p:cNvPr>
          <p:cNvSpPr txBox="1"/>
          <p:nvPr/>
        </p:nvSpPr>
        <p:spPr>
          <a:xfrm>
            <a:off x="2575099" y="4085662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82CC377-906A-8A90-2CE1-01D1AD4FB476}"/>
              </a:ext>
            </a:extLst>
          </p:cNvPr>
          <p:cNvSpPr txBox="1"/>
          <p:nvPr/>
        </p:nvSpPr>
        <p:spPr>
          <a:xfrm>
            <a:off x="1919766" y="4083504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4D231CCC-6E4D-754F-F8F0-2FC3DA17CC0F}"/>
              </a:ext>
            </a:extLst>
          </p:cNvPr>
          <p:cNvCxnSpPr>
            <a:cxnSpLocks/>
          </p:cNvCxnSpPr>
          <p:nvPr/>
        </p:nvCxnSpPr>
        <p:spPr>
          <a:xfrm>
            <a:off x="4758897" y="3925166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9FB7DBE2-1E8E-D885-4C8F-0965D423A32B}"/>
              </a:ext>
            </a:extLst>
          </p:cNvPr>
          <p:cNvCxnSpPr>
            <a:cxnSpLocks/>
          </p:cNvCxnSpPr>
          <p:nvPr/>
        </p:nvCxnSpPr>
        <p:spPr>
          <a:xfrm>
            <a:off x="3807326" y="3925166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5BD1C53F-7A37-F7CE-41A6-28923215BB87}"/>
              </a:ext>
            </a:extLst>
          </p:cNvPr>
          <p:cNvSpPr txBox="1"/>
          <p:nvPr/>
        </p:nvSpPr>
        <p:spPr>
          <a:xfrm>
            <a:off x="3879125" y="4117309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C1BFEA-0C0B-E4B5-A272-DB5E95F334ED}"/>
              </a:ext>
            </a:extLst>
          </p:cNvPr>
          <p:cNvSpPr txBox="1"/>
          <p:nvPr/>
        </p:nvSpPr>
        <p:spPr>
          <a:xfrm>
            <a:off x="4604948" y="4106212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C1422E7B-F8CE-7E27-5882-B144E8BD26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7754" y="2229945"/>
            <a:ext cx="4332688" cy="2834130"/>
          </a:xfrm>
          <a:prstGeom prst="rect">
            <a:avLst/>
          </a:prstGeom>
        </p:spPr>
      </p:pic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2FCA63FF-EB17-85FF-5A01-C5FF9F076278}"/>
              </a:ext>
            </a:extLst>
          </p:cNvPr>
          <p:cNvCxnSpPr>
            <a:cxnSpLocks/>
          </p:cNvCxnSpPr>
          <p:nvPr/>
        </p:nvCxnSpPr>
        <p:spPr>
          <a:xfrm>
            <a:off x="7426376" y="4394308"/>
            <a:ext cx="74606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F228EDD-E5B0-0ABF-2FBD-882EB26F83A8}"/>
              </a:ext>
            </a:extLst>
          </p:cNvPr>
          <p:cNvCxnSpPr>
            <a:cxnSpLocks/>
          </p:cNvCxnSpPr>
          <p:nvPr/>
        </p:nvCxnSpPr>
        <p:spPr>
          <a:xfrm>
            <a:off x="10359147" y="4383211"/>
            <a:ext cx="74606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7295D9E-8122-12ED-FCBA-F5CD608C8247}"/>
              </a:ext>
            </a:extLst>
          </p:cNvPr>
          <p:cNvCxnSpPr>
            <a:cxnSpLocks/>
          </p:cNvCxnSpPr>
          <p:nvPr/>
        </p:nvCxnSpPr>
        <p:spPr>
          <a:xfrm>
            <a:off x="9418728" y="4398671"/>
            <a:ext cx="74606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4D224DBE-9287-9C05-B58C-D63207B8F69B}"/>
              </a:ext>
            </a:extLst>
          </p:cNvPr>
          <p:cNvCxnSpPr>
            <a:cxnSpLocks/>
          </p:cNvCxnSpPr>
          <p:nvPr/>
        </p:nvCxnSpPr>
        <p:spPr>
          <a:xfrm>
            <a:off x="8400249" y="4394299"/>
            <a:ext cx="74606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976BBF24-E62E-8681-5596-195580A58BF5}"/>
              </a:ext>
            </a:extLst>
          </p:cNvPr>
          <p:cNvSpPr txBox="1"/>
          <p:nvPr/>
        </p:nvSpPr>
        <p:spPr>
          <a:xfrm>
            <a:off x="10266321" y="4519218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A074713-63FF-3858-0CB3-ECE061C56A17}"/>
              </a:ext>
            </a:extLst>
          </p:cNvPr>
          <p:cNvSpPr txBox="1"/>
          <p:nvPr/>
        </p:nvSpPr>
        <p:spPr>
          <a:xfrm>
            <a:off x="8271222" y="4519217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6C84921-D4E6-5DB0-D020-1E38CD558C4A}"/>
              </a:ext>
            </a:extLst>
          </p:cNvPr>
          <p:cNvSpPr txBox="1"/>
          <p:nvPr/>
        </p:nvSpPr>
        <p:spPr>
          <a:xfrm>
            <a:off x="9453440" y="4504107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874CE69-37C8-E5B6-93B5-B14A8941E6DA}"/>
              </a:ext>
            </a:extLst>
          </p:cNvPr>
          <p:cNvSpPr txBox="1"/>
          <p:nvPr/>
        </p:nvSpPr>
        <p:spPr>
          <a:xfrm>
            <a:off x="7489081" y="4519216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3E4F16-ECCF-5812-4EBE-CFF0D9E2C421}"/>
              </a:ext>
            </a:extLst>
          </p:cNvPr>
          <p:cNvSpPr txBox="1"/>
          <p:nvPr/>
        </p:nvSpPr>
        <p:spPr>
          <a:xfrm>
            <a:off x="6411107" y="1850839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</p:spTree>
    <p:extLst>
      <p:ext uri="{BB962C8B-B14F-4D97-AF65-F5344CB8AC3E}">
        <p14:creationId xmlns:p14="http://schemas.microsoft.com/office/powerpoint/2010/main" val="286503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1610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6B –BA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610258" y="987311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087837" y="2205588"/>
            <a:ext cx="417822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759585" y="1347469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1206A-231E-0020-D196-92FEE916AAE8}"/>
              </a:ext>
            </a:extLst>
          </p:cNvPr>
          <p:cNvSpPr txBox="1"/>
          <p:nvPr/>
        </p:nvSpPr>
        <p:spPr>
          <a:xfrm>
            <a:off x="6561430" y="178813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744583" y="2366150"/>
            <a:ext cx="35779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662A7EC4-4997-BF7B-A30E-28B6B78ABC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3474" y="1806837"/>
            <a:ext cx="4164151" cy="3031830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D514497C-A6DE-45A8-E40B-F3A3FEB0958E}"/>
              </a:ext>
            </a:extLst>
          </p:cNvPr>
          <p:cNvCxnSpPr/>
          <p:nvPr/>
        </p:nvCxnSpPr>
        <p:spPr>
          <a:xfrm flipH="1">
            <a:off x="5580810" y="4047893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776D6728-CC56-DB82-2A93-611FBE4B20B0}"/>
              </a:ext>
            </a:extLst>
          </p:cNvPr>
          <p:cNvSpPr txBox="1"/>
          <p:nvPr/>
        </p:nvSpPr>
        <p:spPr>
          <a:xfrm>
            <a:off x="5499060" y="4078468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23 KD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8961475-1B20-B0E4-0817-43E822759D12}"/>
              </a:ext>
            </a:extLst>
          </p:cNvPr>
          <p:cNvCxnSpPr/>
          <p:nvPr/>
        </p:nvCxnSpPr>
        <p:spPr>
          <a:xfrm>
            <a:off x="2039676" y="4460487"/>
            <a:ext cx="536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1953B895-B4A5-F2F8-6DA5-036C9605B645}"/>
              </a:ext>
            </a:extLst>
          </p:cNvPr>
          <p:cNvCxnSpPr/>
          <p:nvPr/>
        </p:nvCxnSpPr>
        <p:spPr>
          <a:xfrm>
            <a:off x="2939207" y="4460487"/>
            <a:ext cx="536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1351BB8D-ED44-7D74-342E-6EA02A12657D}"/>
              </a:ext>
            </a:extLst>
          </p:cNvPr>
          <p:cNvCxnSpPr/>
          <p:nvPr/>
        </p:nvCxnSpPr>
        <p:spPr>
          <a:xfrm>
            <a:off x="3749529" y="4460487"/>
            <a:ext cx="536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59C4073-1BF5-1998-0A71-9A4F333CC82A}"/>
              </a:ext>
            </a:extLst>
          </p:cNvPr>
          <p:cNvCxnSpPr/>
          <p:nvPr/>
        </p:nvCxnSpPr>
        <p:spPr>
          <a:xfrm>
            <a:off x="4571003" y="4444676"/>
            <a:ext cx="536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C747683A-689F-0F96-9700-5FABFD48B3CF}"/>
              </a:ext>
            </a:extLst>
          </p:cNvPr>
          <p:cNvSpPr txBox="1"/>
          <p:nvPr/>
        </p:nvSpPr>
        <p:spPr>
          <a:xfrm>
            <a:off x="2016161" y="4535974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19AA7D2-2BA4-520B-AFB9-5E6F3911F823}"/>
              </a:ext>
            </a:extLst>
          </p:cNvPr>
          <p:cNvSpPr txBox="1"/>
          <p:nvPr/>
        </p:nvSpPr>
        <p:spPr>
          <a:xfrm>
            <a:off x="2705274" y="4550112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41CDDB2-3358-AD71-F39C-E2E1E4203F9A}"/>
              </a:ext>
            </a:extLst>
          </p:cNvPr>
          <p:cNvSpPr txBox="1"/>
          <p:nvPr/>
        </p:nvSpPr>
        <p:spPr>
          <a:xfrm>
            <a:off x="3681802" y="4550243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71CF9DD-36D3-8917-495C-EADB749F8F67}"/>
              </a:ext>
            </a:extLst>
          </p:cNvPr>
          <p:cNvSpPr txBox="1"/>
          <p:nvPr/>
        </p:nvSpPr>
        <p:spPr>
          <a:xfrm>
            <a:off x="4347400" y="4564381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BC978A5-E982-59D9-800A-A97A14FCE6B3}"/>
              </a:ext>
            </a:extLst>
          </p:cNvPr>
          <p:cNvSpPr txBox="1"/>
          <p:nvPr/>
        </p:nvSpPr>
        <p:spPr>
          <a:xfrm>
            <a:off x="516118" y="5179328"/>
            <a:ext cx="609414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pic>
        <p:nvPicPr>
          <p:cNvPr id="7" name="Picture 6" descr="A picture containing text, document&#10;&#10;Description automatically generated">
            <a:extLst>
              <a:ext uri="{FF2B5EF4-FFF2-40B4-BE49-F238E27FC236}">
                <a16:creationId xmlns:a16="http://schemas.microsoft.com/office/drawing/2014/main" id="{31DE233C-4F0C-22B9-ADBF-F1EECFC34B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6285" y="1788139"/>
            <a:ext cx="3335168" cy="3852430"/>
          </a:xfrm>
          <a:prstGeom prst="rect">
            <a:avLst/>
          </a:prstGeom>
        </p:spPr>
      </p:pic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6E01ABE6-15AB-FE5F-DEC2-3992D9AC97D9}"/>
              </a:ext>
            </a:extLst>
          </p:cNvPr>
          <p:cNvCxnSpPr/>
          <p:nvPr/>
        </p:nvCxnSpPr>
        <p:spPr>
          <a:xfrm flipH="1">
            <a:off x="10605907" y="3476289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C426102-65C7-55A3-0BE7-F595D9A3959C}"/>
              </a:ext>
            </a:extLst>
          </p:cNvPr>
          <p:cNvSpPr txBox="1"/>
          <p:nvPr/>
        </p:nvSpPr>
        <p:spPr>
          <a:xfrm>
            <a:off x="10544393" y="3464902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3 KD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FE503A97-FC09-2ED5-7445-163E158F62C7}"/>
              </a:ext>
            </a:extLst>
          </p:cNvPr>
          <p:cNvCxnSpPr>
            <a:cxnSpLocks/>
          </p:cNvCxnSpPr>
          <p:nvPr/>
        </p:nvCxnSpPr>
        <p:spPr>
          <a:xfrm>
            <a:off x="7472995" y="3819769"/>
            <a:ext cx="57818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4AEB96E-3816-7E34-DBBD-5E899FA11AB5}"/>
              </a:ext>
            </a:extLst>
          </p:cNvPr>
          <p:cNvCxnSpPr>
            <a:cxnSpLocks/>
          </p:cNvCxnSpPr>
          <p:nvPr/>
        </p:nvCxnSpPr>
        <p:spPr>
          <a:xfrm>
            <a:off x="8217613" y="3819769"/>
            <a:ext cx="536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EC899C38-7239-5CAB-45A5-E47DFD057844}"/>
              </a:ext>
            </a:extLst>
          </p:cNvPr>
          <p:cNvCxnSpPr>
            <a:cxnSpLocks/>
          </p:cNvCxnSpPr>
          <p:nvPr/>
        </p:nvCxnSpPr>
        <p:spPr>
          <a:xfrm>
            <a:off x="9051449" y="3819769"/>
            <a:ext cx="536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475CE0B-7B54-C51D-DFB3-2B9618CB7877}"/>
              </a:ext>
            </a:extLst>
          </p:cNvPr>
          <p:cNvCxnSpPr>
            <a:cxnSpLocks/>
          </p:cNvCxnSpPr>
          <p:nvPr/>
        </p:nvCxnSpPr>
        <p:spPr>
          <a:xfrm>
            <a:off x="9716380" y="3814935"/>
            <a:ext cx="53625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3EE0CF30-2E58-E55C-8EB0-ECEE53D0DB0E}"/>
              </a:ext>
            </a:extLst>
          </p:cNvPr>
          <p:cNvSpPr txBox="1"/>
          <p:nvPr/>
        </p:nvSpPr>
        <p:spPr>
          <a:xfrm>
            <a:off x="7438857" y="3848538"/>
            <a:ext cx="646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52638C7-823F-2352-FAA7-82DBF63DF197}"/>
              </a:ext>
            </a:extLst>
          </p:cNvPr>
          <p:cNvSpPr txBox="1"/>
          <p:nvPr/>
        </p:nvSpPr>
        <p:spPr>
          <a:xfrm>
            <a:off x="8047328" y="3848538"/>
            <a:ext cx="10041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6287F4A-18DD-1C0D-E31D-A88428900EE7}"/>
              </a:ext>
            </a:extLst>
          </p:cNvPr>
          <p:cNvSpPr txBox="1"/>
          <p:nvPr/>
        </p:nvSpPr>
        <p:spPr>
          <a:xfrm>
            <a:off x="9069921" y="3909394"/>
            <a:ext cx="646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CDB8A4F-6BFF-702B-7B9F-95BF1376C9F5}"/>
              </a:ext>
            </a:extLst>
          </p:cNvPr>
          <p:cNvSpPr txBox="1"/>
          <p:nvPr/>
        </p:nvSpPr>
        <p:spPr>
          <a:xfrm>
            <a:off x="9696864" y="3909394"/>
            <a:ext cx="10041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</p:spTree>
    <p:extLst>
      <p:ext uri="{BB962C8B-B14F-4D97-AF65-F5344CB8AC3E}">
        <p14:creationId xmlns:p14="http://schemas.microsoft.com/office/powerpoint/2010/main" val="18796929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1627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6B –Bcl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610258" y="987311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037063" y="2429091"/>
            <a:ext cx="469010" cy="2202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940798" y="1589492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1206A-231E-0020-D196-92FEE916AAE8}"/>
              </a:ext>
            </a:extLst>
          </p:cNvPr>
          <p:cNvSpPr txBox="1"/>
          <p:nvPr/>
        </p:nvSpPr>
        <p:spPr>
          <a:xfrm>
            <a:off x="6409297" y="1727992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705800" y="2733180"/>
            <a:ext cx="357790" cy="21698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D514497C-A6DE-45A8-E40B-F3A3FEB0958E}"/>
              </a:ext>
            </a:extLst>
          </p:cNvPr>
          <p:cNvCxnSpPr/>
          <p:nvPr/>
        </p:nvCxnSpPr>
        <p:spPr>
          <a:xfrm flipH="1">
            <a:off x="5489104" y="4192859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776D6728-CC56-DB82-2A93-611FBE4B20B0}"/>
              </a:ext>
            </a:extLst>
          </p:cNvPr>
          <p:cNvSpPr txBox="1"/>
          <p:nvPr/>
        </p:nvSpPr>
        <p:spPr>
          <a:xfrm>
            <a:off x="5407354" y="422343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26 KD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47FC74E-FF67-290C-F018-305D5731FF48}"/>
              </a:ext>
            </a:extLst>
          </p:cNvPr>
          <p:cNvCxnSpPr/>
          <p:nvPr/>
        </p:nvCxnSpPr>
        <p:spPr>
          <a:xfrm flipH="1">
            <a:off x="11392264" y="3918453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6456644C-CED1-066B-4530-032B436F51C6}"/>
              </a:ext>
            </a:extLst>
          </p:cNvPr>
          <p:cNvSpPr txBox="1"/>
          <p:nvPr/>
        </p:nvSpPr>
        <p:spPr>
          <a:xfrm>
            <a:off x="11287809" y="3958776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37 KD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59616DDD-C6B4-5098-7791-9F5AEFD16F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5083" y="2001343"/>
            <a:ext cx="4067735" cy="2855313"/>
          </a:xfrm>
          <a:prstGeom prst="rect">
            <a:avLst/>
          </a:prstGeom>
        </p:spPr>
      </p:pic>
      <p:pic>
        <p:nvPicPr>
          <p:cNvPr id="15" name="Picture 14" descr="A picture containing text&#10;&#10;Description automatically generated">
            <a:extLst>
              <a:ext uri="{FF2B5EF4-FFF2-40B4-BE49-F238E27FC236}">
                <a16:creationId xmlns:a16="http://schemas.microsoft.com/office/drawing/2014/main" id="{EC419AA0-6284-1F2E-4CAC-94F826B54B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1250" y="2200079"/>
            <a:ext cx="4301014" cy="2970847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02D87A4-5949-2591-0670-D71D497D1FAC}"/>
              </a:ext>
            </a:extLst>
          </p:cNvPr>
          <p:cNvCxnSpPr/>
          <p:nvPr/>
        </p:nvCxnSpPr>
        <p:spPr>
          <a:xfrm>
            <a:off x="1742500" y="4454289"/>
            <a:ext cx="152771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16AA884-6DB3-F28D-70A7-4CF29856A87D}"/>
              </a:ext>
            </a:extLst>
          </p:cNvPr>
          <p:cNvCxnSpPr/>
          <p:nvPr/>
        </p:nvCxnSpPr>
        <p:spPr>
          <a:xfrm>
            <a:off x="3389163" y="4454289"/>
            <a:ext cx="152771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384A274-D11C-1E52-42C1-9446BCFDC8B9}"/>
              </a:ext>
            </a:extLst>
          </p:cNvPr>
          <p:cNvSpPr txBox="1"/>
          <p:nvPr/>
        </p:nvSpPr>
        <p:spPr>
          <a:xfrm>
            <a:off x="3836019" y="4605039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A12B22B-8CC3-A315-F848-647408B14F3F}"/>
              </a:ext>
            </a:extLst>
          </p:cNvPr>
          <p:cNvSpPr txBox="1"/>
          <p:nvPr/>
        </p:nvSpPr>
        <p:spPr>
          <a:xfrm>
            <a:off x="2004297" y="4605039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94C1189-9AD8-3585-FB2F-A43B2EBE2E22}"/>
              </a:ext>
            </a:extLst>
          </p:cNvPr>
          <p:cNvCxnSpPr/>
          <p:nvPr/>
        </p:nvCxnSpPr>
        <p:spPr>
          <a:xfrm>
            <a:off x="7718695" y="4321050"/>
            <a:ext cx="152771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3758A1C-BF85-3E37-4683-D3314828F8FB}"/>
              </a:ext>
            </a:extLst>
          </p:cNvPr>
          <p:cNvCxnSpPr/>
          <p:nvPr/>
        </p:nvCxnSpPr>
        <p:spPr>
          <a:xfrm>
            <a:off x="9365358" y="4321050"/>
            <a:ext cx="152771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B1354E-8A9E-4C5E-F10E-D431119189C8}"/>
              </a:ext>
            </a:extLst>
          </p:cNvPr>
          <p:cNvSpPr txBox="1"/>
          <p:nvPr/>
        </p:nvSpPr>
        <p:spPr>
          <a:xfrm>
            <a:off x="9943518" y="4500433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A3D3F93-24C5-34E8-F087-0EE863275F7F}"/>
              </a:ext>
            </a:extLst>
          </p:cNvPr>
          <p:cNvSpPr txBox="1"/>
          <p:nvPr/>
        </p:nvSpPr>
        <p:spPr>
          <a:xfrm>
            <a:off x="8066079" y="4504559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33E9BD7-B487-1674-8409-73F18871FBE5}"/>
              </a:ext>
            </a:extLst>
          </p:cNvPr>
          <p:cNvSpPr txBox="1"/>
          <p:nvPr/>
        </p:nvSpPr>
        <p:spPr>
          <a:xfrm>
            <a:off x="790554" y="5284404"/>
            <a:ext cx="304546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</p:spTree>
    <p:extLst>
      <p:ext uri="{BB962C8B-B14F-4D97-AF65-F5344CB8AC3E}">
        <p14:creationId xmlns:p14="http://schemas.microsoft.com/office/powerpoint/2010/main" val="20296153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2182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6C –Caspase-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649212" y="1147395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646191" y="2494074"/>
            <a:ext cx="469010" cy="2202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1583204" y="1931909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1206A-231E-0020-D196-92FEE916AAE8}"/>
              </a:ext>
            </a:extLst>
          </p:cNvPr>
          <p:cNvSpPr txBox="1"/>
          <p:nvPr/>
        </p:nvSpPr>
        <p:spPr>
          <a:xfrm>
            <a:off x="6647227" y="193190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837683" y="2669941"/>
            <a:ext cx="357790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D514497C-A6DE-45A8-E40B-F3A3FEB0958E}"/>
              </a:ext>
            </a:extLst>
          </p:cNvPr>
          <p:cNvCxnSpPr/>
          <p:nvPr/>
        </p:nvCxnSpPr>
        <p:spPr>
          <a:xfrm flipH="1">
            <a:off x="5787483" y="3958776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776D6728-CC56-DB82-2A93-611FBE4B20B0}"/>
              </a:ext>
            </a:extLst>
          </p:cNvPr>
          <p:cNvSpPr txBox="1"/>
          <p:nvPr/>
        </p:nvSpPr>
        <p:spPr>
          <a:xfrm>
            <a:off x="5686872" y="405492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37 KD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47FC74E-FF67-290C-F018-305D5731FF48}"/>
              </a:ext>
            </a:extLst>
          </p:cNvPr>
          <p:cNvCxnSpPr/>
          <p:nvPr/>
        </p:nvCxnSpPr>
        <p:spPr>
          <a:xfrm flipH="1">
            <a:off x="10958120" y="3851545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6456644C-CED1-066B-4530-032B436F51C6}"/>
              </a:ext>
            </a:extLst>
          </p:cNvPr>
          <p:cNvSpPr txBox="1"/>
          <p:nvPr/>
        </p:nvSpPr>
        <p:spPr>
          <a:xfrm>
            <a:off x="10958120" y="400085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37 KD</a:t>
            </a: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0B03D01C-867A-9746-69ED-3CA2B7C2B3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5616" y="2208908"/>
            <a:ext cx="3721867" cy="2773156"/>
          </a:xfrm>
          <a:prstGeom prst="rect">
            <a:avLst/>
          </a:prstGeom>
        </p:spPr>
      </p:pic>
      <p:pic>
        <p:nvPicPr>
          <p:cNvPr id="7" name="Picture 6" descr="A picture containing text, electronics&#10;&#10;Description automatically generated">
            <a:extLst>
              <a:ext uri="{FF2B5EF4-FFF2-40B4-BE49-F238E27FC236}">
                <a16:creationId xmlns:a16="http://schemas.microsoft.com/office/drawing/2014/main" id="{9107F4CA-3A2D-4614-3B6E-0699656E46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4832" y="2208908"/>
            <a:ext cx="3919352" cy="300314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7230C47-C344-7B52-BAB6-095DD2A66DC7}"/>
              </a:ext>
            </a:extLst>
          </p:cNvPr>
          <p:cNvSpPr txBox="1"/>
          <p:nvPr/>
        </p:nvSpPr>
        <p:spPr>
          <a:xfrm>
            <a:off x="865031" y="5619583"/>
            <a:ext cx="309365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DBE0B8C-7964-82DD-5219-2EBB6828605F}"/>
              </a:ext>
            </a:extLst>
          </p:cNvPr>
          <p:cNvCxnSpPr>
            <a:cxnSpLocks/>
          </p:cNvCxnSpPr>
          <p:nvPr/>
        </p:nvCxnSpPr>
        <p:spPr>
          <a:xfrm>
            <a:off x="2311773" y="4262385"/>
            <a:ext cx="13123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857B8940-E07E-EFA0-3E86-4678157EF9AD}"/>
              </a:ext>
            </a:extLst>
          </p:cNvPr>
          <p:cNvCxnSpPr>
            <a:cxnSpLocks/>
          </p:cNvCxnSpPr>
          <p:nvPr/>
        </p:nvCxnSpPr>
        <p:spPr>
          <a:xfrm>
            <a:off x="3784167" y="4251234"/>
            <a:ext cx="12227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CE60334-3C89-08D8-078A-355CA67C885D}"/>
              </a:ext>
            </a:extLst>
          </p:cNvPr>
          <p:cNvSpPr txBox="1"/>
          <p:nvPr/>
        </p:nvSpPr>
        <p:spPr>
          <a:xfrm>
            <a:off x="3997231" y="4345225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0894B9F-420C-2824-843A-57C194C3D7A2}"/>
              </a:ext>
            </a:extLst>
          </p:cNvPr>
          <p:cNvSpPr txBox="1"/>
          <p:nvPr/>
        </p:nvSpPr>
        <p:spPr>
          <a:xfrm>
            <a:off x="2519726" y="4345225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FEBDD86-9181-D529-FE49-0B2135758886}"/>
              </a:ext>
            </a:extLst>
          </p:cNvPr>
          <p:cNvCxnSpPr>
            <a:cxnSpLocks/>
          </p:cNvCxnSpPr>
          <p:nvPr/>
        </p:nvCxnSpPr>
        <p:spPr>
          <a:xfrm>
            <a:off x="7692135" y="4193421"/>
            <a:ext cx="13123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FC07B4A3-A7EA-B0B5-7A04-0318A8EDEAF7}"/>
              </a:ext>
            </a:extLst>
          </p:cNvPr>
          <p:cNvCxnSpPr>
            <a:cxnSpLocks/>
          </p:cNvCxnSpPr>
          <p:nvPr/>
        </p:nvCxnSpPr>
        <p:spPr>
          <a:xfrm>
            <a:off x="9244547" y="4193421"/>
            <a:ext cx="12227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37CF8AB-4E84-5C4A-5F08-CF94A22842F7}"/>
              </a:ext>
            </a:extLst>
          </p:cNvPr>
          <p:cNvSpPr txBox="1"/>
          <p:nvPr/>
        </p:nvSpPr>
        <p:spPr>
          <a:xfrm>
            <a:off x="9479925" y="4246594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88EEE2E-D60A-64AC-9643-F0AE9BECBC52}"/>
              </a:ext>
            </a:extLst>
          </p:cNvPr>
          <p:cNvSpPr txBox="1"/>
          <p:nvPr/>
        </p:nvSpPr>
        <p:spPr>
          <a:xfrm>
            <a:off x="7789439" y="4194356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</p:spTree>
    <p:extLst>
      <p:ext uri="{BB962C8B-B14F-4D97-AF65-F5344CB8AC3E}">
        <p14:creationId xmlns:p14="http://schemas.microsoft.com/office/powerpoint/2010/main" val="11959607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2945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6C–Cleaved caspase-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649212" y="1147395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646191" y="2494074"/>
            <a:ext cx="469010" cy="2202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1600434" y="1127841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1206A-231E-0020-D196-92FEE916AAE8}"/>
              </a:ext>
            </a:extLst>
          </p:cNvPr>
          <p:cNvSpPr txBox="1"/>
          <p:nvPr/>
        </p:nvSpPr>
        <p:spPr>
          <a:xfrm>
            <a:off x="6647227" y="193190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837683" y="2669941"/>
            <a:ext cx="357790" cy="24468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D514497C-A6DE-45A8-E40B-F3A3FEB0958E}"/>
              </a:ext>
            </a:extLst>
          </p:cNvPr>
          <p:cNvCxnSpPr/>
          <p:nvPr/>
        </p:nvCxnSpPr>
        <p:spPr>
          <a:xfrm flipH="1">
            <a:off x="6226864" y="4431462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776D6728-CC56-DB82-2A93-611FBE4B20B0}"/>
              </a:ext>
            </a:extLst>
          </p:cNvPr>
          <p:cNvSpPr txBox="1"/>
          <p:nvPr/>
        </p:nvSpPr>
        <p:spPr>
          <a:xfrm>
            <a:off x="6157160" y="4589844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17 KD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47FC74E-FF67-290C-F018-305D5731FF48}"/>
              </a:ext>
            </a:extLst>
          </p:cNvPr>
          <p:cNvCxnSpPr/>
          <p:nvPr/>
        </p:nvCxnSpPr>
        <p:spPr>
          <a:xfrm flipH="1">
            <a:off x="11018453" y="3843338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6456644C-CED1-066B-4530-032B436F51C6}"/>
              </a:ext>
            </a:extLst>
          </p:cNvPr>
          <p:cNvSpPr txBox="1"/>
          <p:nvPr/>
        </p:nvSpPr>
        <p:spPr>
          <a:xfrm>
            <a:off x="10892825" y="4154463"/>
            <a:ext cx="559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3 K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230C47-C344-7B52-BAB6-095DD2A66DC7}"/>
              </a:ext>
            </a:extLst>
          </p:cNvPr>
          <p:cNvSpPr txBox="1"/>
          <p:nvPr/>
        </p:nvSpPr>
        <p:spPr>
          <a:xfrm>
            <a:off x="865030" y="5619583"/>
            <a:ext cx="307134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pic>
        <p:nvPicPr>
          <p:cNvPr id="3" name="Picture 2" descr="A close-up of a sign&#10;&#10;Description automatically generated with low confidence">
            <a:extLst>
              <a:ext uri="{FF2B5EF4-FFF2-40B4-BE49-F238E27FC236}">
                <a16:creationId xmlns:a16="http://schemas.microsoft.com/office/drawing/2014/main" id="{49A5DC5C-C829-52AB-2135-3D369899A7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4719" y="1516727"/>
            <a:ext cx="4262145" cy="3211617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90C1534C-6C95-D3BF-E438-19510A2F6847}"/>
              </a:ext>
            </a:extLst>
          </p:cNvPr>
          <p:cNvCxnSpPr>
            <a:cxnSpLocks/>
          </p:cNvCxnSpPr>
          <p:nvPr/>
        </p:nvCxnSpPr>
        <p:spPr>
          <a:xfrm>
            <a:off x="2523707" y="4866843"/>
            <a:ext cx="13123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57397E5-772D-EE5B-DA80-26ACA315F035}"/>
              </a:ext>
            </a:extLst>
          </p:cNvPr>
          <p:cNvCxnSpPr>
            <a:cxnSpLocks/>
          </p:cNvCxnSpPr>
          <p:nvPr/>
        </p:nvCxnSpPr>
        <p:spPr>
          <a:xfrm>
            <a:off x="4230214" y="4866843"/>
            <a:ext cx="12227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C8E21B0C-1F51-0BBF-CB52-C64CEAF7DFC0}"/>
              </a:ext>
            </a:extLst>
          </p:cNvPr>
          <p:cNvSpPr txBox="1"/>
          <p:nvPr/>
        </p:nvSpPr>
        <p:spPr>
          <a:xfrm>
            <a:off x="4554791" y="4949683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0DCF701-70C2-3DD8-6D82-BF521B9062FA}"/>
              </a:ext>
            </a:extLst>
          </p:cNvPr>
          <p:cNvSpPr txBox="1"/>
          <p:nvPr/>
        </p:nvSpPr>
        <p:spPr>
          <a:xfrm>
            <a:off x="2677832" y="4949682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pic>
        <p:nvPicPr>
          <p:cNvPr id="20" name="Picture 19" descr="A picture containing text&#10;&#10;Description automatically generated">
            <a:extLst>
              <a:ext uri="{FF2B5EF4-FFF2-40B4-BE49-F238E27FC236}">
                <a16:creationId xmlns:a16="http://schemas.microsoft.com/office/drawing/2014/main" id="{F31C82C9-627F-48D0-FA2A-682108109A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3786" y="2494074"/>
            <a:ext cx="3745235" cy="3432589"/>
          </a:xfrm>
          <a:prstGeom prst="rect">
            <a:avLst/>
          </a:prstGeom>
        </p:spPr>
      </p:pic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8FFC826-DF1F-9A80-E3CD-F7EA39AC7E43}"/>
              </a:ext>
            </a:extLst>
          </p:cNvPr>
          <p:cNvCxnSpPr>
            <a:cxnSpLocks/>
          </p:cNvCxnSpPr>
          <p:nvPr/>
        </p:nvCxnSpPr>
        <p:spPr>
          <a:xfrm>
            <a:off x="7666618" y="4154463"/>
            <a:ext cx="13123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4058631-9AA2-FF61-3988-51F4900357DE}"/>
              </a:ext>
            </a:extLst>
          </p:cNvPr>
          <p:cNvCxnSpPr>
            <a:cxnSpLocks/>
          </p:cNvCxnSpPr>
          <p:nvPr/>
        </p:nvCxnSpPr>
        <p:spPr>
          <a:xfrm>
            <a:off x="9373125" y="4154463"/>
            <a:ext cx="122273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9EFC4EF1-5785-F627-E842-BB3333FA9B4E}"/>
              </a:ext>
            </a:extLst>
          </p:cNvPr>
          <p:cNvSpPr txBox="1"/>
          <p:nvPr/>
        </p:nvSpPr>
        <p:spPr>
          <a:xfrm>
            <a:off x="9697702" y="4237303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BDE884C-ECA0-996D-56F9-788FB4B4BB10}"/>
              </a:ext>
            </a:extLst>
          </p:cNvPr>
          <p:cNvSpPr txBox="1"/>
          <p:nvPr/>
        </p:nvSpPr>
        <p:spPr>
          <a:xfrm>
            <a:off x="7820743" y="4237302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</p:spTree>
    <p:extLst>
      <p:ext uri="{BB962C8B-B14F-4D97-AF65-F5344CB8AC3E}">
        <p14:creationId xmlns:p14="http://schemas.microsoft.com/office/powerpoint/2010/main" val="945282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15426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8 p-p3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649212" y="1147395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036356" y="2134725"/>
            <a:ext cx="469010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906576" y="1485168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1206A-231E-0020-D196-92FEE916AAE8}"/>
              </a:ext>
            </a:extLst>
          </p:cNvPr>
          <p:cNvSpPr txBox="1"/>
          <p:nvPr/>
        </p:nvSpPr>
        <p:spPr>
          <a:xfrm>
            <a:off x="6411503" y="174754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601959" y="2485581"/>
            <a:ext cx="357790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230C47-C344-7B52-BAB6-095DD2A66DC7}"/>
              </a:ext>
            </a:extLst>
          </p:cNvPr>
          <p:cNvSpPr txBox="1"/>
          <p:nvPr/>
        </p:nvSpPr>
        <p:spPr>
          <a:xfrm>
            <a:off x="865030" y="5619583"/>
            <a:ext cx="307134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pic>
        <p:nvPicPr>
          <p:cNvPr id="36" name="Picture 35" descr="A picture containing text&#10;&#10;Description automatically generated">
            <a:extLst>
              <a:ext uri="{FF2B5EF4-FFF2-40B4-BE49-F238E27FC236}">
                <a16:creationId xmlns:a16="http://schemas.microsoft.com/office/drawing/2014/main" id="{F4C428FB-1F8A-7278-F1A2-AC03384A52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2829" y="1747549"/>
            <a:ext cx="4397670" cy="2972499"/>
          </a:xfrm>
          <a:prstGeom prst="rect">
            <a:avLst/>
          </a:prstGeom>
        </p:spPr>
      </p:pic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C8C9E76F-D854-D91A-855E-50F556CAC3EA}"/>
              </a:ext>
            </a:extLst>
          </p:cNvPr>
          <p:cNvCxnSpPr>
            <a:cxnSpLocks/>
          </p:cNvCxnSpPr>
          <p:nvPr/>
        </p:nvCxnSpPr>
        <p:spPr>
          <a:xfrm>
            <a:off x="2018371" y="3813717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EF86F867-0505-BE64-7472-F472CA553B75}"/>
              </a:ext>
            </a:extLst>
          </p:cNvPr>
          <p:cNvCxnSpPr>
            <a:cxnSpLocks/>
          </p:cNvCxnSpPr>
          <p:nvPr/>
        </p:nvCxnSpPr>
        <p:spPr>
          <a:xfrm>
            <a:off x="2984810" y="3798849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42902CC-B3C2-0495-46B3-BDD050D14151}"/>
              </a:ext>
            </a:extLst>
          </p:cNvPr>
          <p:cNvCxnSpPr>
            <a:cxnSpLocks/>
          </p:cNvCxnSpPr>
          <p:nvPr/>
        </p:nvCxnSpPr>
        <p:spPr>
          <a:xfrm>
            <a:off x="4066479" y="3798849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D201244E-A91D-8A1F-6CAE-F5E506C1C478}"/>
              </a:ext>
            </a:extLst>
          </p:cNvPr>
          <p:cNvCxnSpPr>
            <a:cxnSpLocks/>
          </p:cNvCxnSpPr>
          <p:nvPr/>
        </p:nvCxnSpPr>
        <p:spPr>
          <a:xfrm>
            <a:off x="4947424" y="3813717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CBD35D97-F00D-326D-B0D7-696817961A50}"/>
              </a:ext>
            </a:extLst>
          </p:cNvPr>
          <p:cNvSpPr txBox="1"/>
          <p:nvPr/>
        </p:nvSpPr>
        <p:spPr>
          <a:xfrm>
            <a:off x="1938780" y="3937599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230ABDE-A96E-D6EF-857A-2630182E6298}"/>
              </a:ext>
            </a:extLst>
          </p:cNvPr>
          <p:cNvSpPr txBox="1"/>
          <p:nvPr/>
        </p:nvSpPr>
        <p:spPr>
          <a:xfrm>
            <a:off x="2992873" y="3928788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C4C75CC-2BC0-A01E-301E-4A3D088B11A5}"/>
              </a:ext>
            </a:extLst>
          </p:cNvPr>
          <p:cNvSpPr txBox="1"/>
          <p:nvPr/>
        </p:nvSpPr>
        <p:spPr>
          <a:xfrm>
            <a:off x="4936198" y="3923993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6335ED7-140B-F872-C7BA-886E8C53AF22}"/>
              </a:ext>
            </a:extLst>
          </p:cNvPr>
          <p:cNvSpPr txBox="1"/>
          <p:nvPr/>
        </p:nvSpPr>
        <p:spPr>
          <a:xfrm>
            <a:off x="3890107" y="3947296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367EA7C3-ECB7-82E6-8A21-98DF410AA291}"/>
              </a:ext>
            </a:extLst>
          </p:cNvPr>
          <p:cNvCxnSpPr>
            <a:cxnSpLocks/>
          </p:cNvCxnSpPr>
          <p:nvPr/>
        </p:nvCxnSpPr>
        <p:spPr>
          <a:xfrm flipH="1">
            <a:off x="5884290" y="3347098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4A22D417-1872-3B77-8A68-F2E5B65B7CA7}"/>
              </a:ext>
            </a:extLst>
          </p:cNvPr>
          <p:cNvSpPr txBox="1"/>
          <p:nvPr/>
        </p:nvSpPr>
        <p:spPr>
          <a:xfrm>
            <a:off x="5791415" y="342900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1 KD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9FC8300-005F-D839-A0B2-239EDEACFEDB}"/>
              </a:ext>
            </a:extLst>
          </p:cNvPr>
          <p:cNvSpPr txBox="1"/>
          <p:nvPr/>
        </p:nvSpPr>
        <p:spPr>
          <a:xfrm>
            <a:off x="11530625" y="3705999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3 KD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D0C0DE40-9677-B095-C11E-87AF0AFE32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3624" y="2381568"/>
            <a:ext cx="4646871" cy="3238015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E235063-6411-9569-E80C-F057FB7A104D}"/>
              </a:ext>
            </a:extLst>
          </p:cNvPr>
          <p:cNvCxnSpPr>
            <a:cxnSpLocks/>
          </p:cNvCxnSpPr>
          <p:nvPr/>
        </p:nvCxnSpPr>
        <p:spPr>
          <a:xfrm>
            <a:off x="7622622" y="4076098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4AAD85F2-BC09-6615-5338-AC2CA3D9EEAB}"/>
              </a:ext>
            </a:extLst>
          </p:cNvPr>
          <p:cNvCxnSpPr>
            <a:cxnSpLocks/>
          </p:cNvCxnSpPr>
          <p:nvPr/>
        </p:nvCxnSpPr>
        <p:spPr>
          <a:xfrm>
            <a:off x="8625920" y="4085795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B545ED75-26B9-6F4B-2D54-23B92B12ED18}"/>
              </a:ext>
            </a:extLst>
          </p:cNvPr>
          <p:cNvCxnSpPr>
            <a:cxnSpLocks/>
          </p:cNvCxnSpPr>
          <p:nvPr/>
        </p:nvCxnSpPr>
        <p:spPr>
          <a:xfrm>
            <a:off x="9502249" y="4076098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E30F5E1-0C95-58FC-55BD-5AC55173F66F}"/>
              </a:ext>
            </a:extLst>
          </p:cNvPr>
          <p:cNvCxnSpPr>
            <a:cxnSpLocks/>
          </p:cNvCxnSpPr>
          <p:nvPr/>
        </p:nvCxnSpPr>
        <p:spPr>
          <a:xfrm>
            <a:off x="10545835" y="4062492"/>
            <a:ext cx="7136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5EF1FB7B-90A7-579B-0F24-46DC607DDF26}"/>
              </a:ext>
            </a:extLst>
          </p:cNvPr>
          <p:cNvSpPr txBox="1"/>
          <p:nvPr/>
        </p:nvSpPr>
        <p:spPr>
          <a:xfrm>
            <a:off x="9339598" y="4212580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ADF086-E58F-157D-335D-4FB7846071EB}"/>
              </a:ext>
            </a:extLst>
          </p:cNvPr>
          <p:cNvSpPr txBox="1"/>
          <p:nvPr/>
        </p:nvSpPr>
        <p:spPr>
          <a:xfrm>
            <a:off x="8667744" y="4230821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096ED58-6602-6573-9773-9FD4AC070A01}"/>
              </a:ext>
            </a:extLst>
          </p:cNvPr>
          <p:cNvSpPr txBox="1"/>
          <p:nvPr/>
        </p:nvSpPr>
        <p:spPr>
          <a:xfrm>
            <a:off x="10545835" y="4179514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62E3ACE-3896-197C-B234-12C5435B1EF0}"/>
              </a:ext>
            </a:extLst>
          </p:cNvPr>
          <p:cNvSpPr txBox="1"/>
          <p:nvPr/>
        </p:nvSpPr>
        <p:spPr>
          <a:xfrm>
            <a:off x="7488494" y="4212581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28D4D0AB-07D4-56E2-1AAD-6213B1FB7CD5}"/>
              </a:ext>
            </a:extLst>
          </p:cNvPr>
          <p:cNvCxnSpPr>
            <a:cxnSpLocks/>
          </p:cNvCxnSpPr>
          <p:nvPr/>
        </p:nvCxnSpPr>
        <p:spPr>
          <a:xfrm flipH="1">
            <a:off x="11530625" y="3675478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952249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EDA62E9-F027-526E-6829-27845E0FE7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0007256"/>
              </p:ext>
            </p:extLst>
          </p:nvPr>
        </p:nvGraphicFramePr>
        <p:xfrm>
          <a:off x="2361998" y="1705643"/>
          <a:ext cx="2247900" cy="360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247480" imgH="3609360" progId="">
                  <p:embed/>
                </p:oleObj>
              </mc:Choice>
              <mc:Fallback>
                <p:oleObj r:id="rId2" imgW="2247480" imgH="3609360" progId="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EDA62E9-F027-526E-6829-27845E0FE7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61998" y="1705643"/>
                        <a:ext cx="2247900" cy="360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CF2E221-2326-7523-55DA-B3261E91F1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6187289"/>
              </p:ext>
            </p:extLst>
          </p:nvPr>
        </p:nvGraphicFramePr>
        <p:xfrm>
          <a:off x="5926873" y="1453356"/>
          <a:ext cx="2590800" cy="395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590200" imgH="3952080" progId="">
                  <p:embed/>
                </p:oleObj>
              </mc:Choice>
              <mc:Fallback>
                <p:oleObj r:id="rId4" imgW="2590200" imgH="3952080" progId="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CF2E221-2326-7523-55DA-B3261E91F1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26873" y="1453356"/>
                        <a:ext cx="2590800" cy="395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1ADCAD5-6A83-4F22-E14E-D253749BAB74}"/>
              </a:ext>
            </a:extLst>
          </p:cNvPr>
          <p:cNvSpPr txBox="1"/>
          <p:nvPr/>
        </p:nvSpPr>
        <p:spPr>
          <a:xfrm>
            <a:off x="2029097" y="992776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7</a:t>
            </a:r>
          </a:p>
        </p:txBody>
      </p:sp>
    </p:spTree>
    <p:extLst>
      <p:ext uri="{BB962C8B-B14F-4D97-AF65-F5344CB8AC3E}">
        <p14:creationId xmlns:p14="http://schemas.microsoft.com/office/powerpoint/2010/main" val="1768187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2102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8A –Total p3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316399" y="1147395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054495" y="2127838"/>
            <a:ext cx="46901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542292" y="1747549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1206A-231E-0020-D196-92FEE916AAE8}"/>
              </a:ext>
            </a:extLst>
          </p:cNvPr>
          <p:cNvSpPr txBox="1"/>
          <p:nvPr/>
        </p:nvSpPr>
        <p:spPr>
          <a:xfrm>
            <a:off x="6371820" y="1614174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504870" y="2669941"/>
            <a:ext cx="35779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230C47-C344-7B52-BAB6-095DD2A66DC7}"/>
              </a:ext>
            </a:extLst>
          </p:cNvPr>
          <p:cNvSpPr txBox="1"/>
          <p:nvPr/>
        </p:nvSpPr>
        <p:spPr>
          <a:xfrm>
            <a:off x="865030" y="5619583"/>
            <a:ext cx="307134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5D4F6C32-EEF4-1BEB-E085-3E17DFB0CC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641" y="1945437"/>
            <a:ext cx="4268016" cy="3092597"/>
          </a:xfrm>
          <a:prstGeom prst="rect">
            <a:avLst/>
          </a:prstGeom>
        </p:spPr>
      </p:pic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E7F3116B-13FF-551E-9E13-C0D84D559CD1}"/>
              </a:ext>
            </a:extLst>
          </p:cNvPr>
          <p:cNvCxnSpPr>
            <a:cxnSpLocks/>
          </p:cNvCxnSpPr>
          <p:nvPr/>
        </p:nvCxnSpPr>
        <p:spPr>
          <a:xfrm flipH="1">
            <a:off x="5470137" y="3420499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002C2EC-482A-780E-B8D9-308FDBDB6FB1}"/>
              </a:ext>
            </a:extLst>
          </p:cNvPr>
          <p:cNvSpPr txBox="1"/>
          <p:nvPr/>
        </p:nvSpPr>
        <p:spPr>
          <a:xfrm>
            <a:off x="5420102" y="351378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1 KD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9EDB4DC-5FB1-5AC5-00B8-B690047DB7DE}"/>
              </a:ext>
            </a:extLst>
          </p:cNvPr>
          <p:cNvCxnSpPr>
            <a:cxnSpLocks/>
          </p:cNvCxnSpPr>
          <p:nvPr/>
        </p:nvCxnSpPr>
        <p:spPr>
          <a:xfrm>
            <a:off x="1836353" y="3884974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77153A0D-642C-7A44-3F5D-E15497D5ADA4}"/>
              </a:ext>
            </a:extLst>
          </p:cNvPr>
          <p:cNvCxnSpPr>
            <a:cxnSpLocks/>
          </p:cNvCxnSpPr>
          <p:nvPr/>
        </p:nvCxnSpPr>
        <p:spPr>
          <a:xfrm>
            <a:off x="2652551" y="3884974"/>
            <a:ext cx="74606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79B4805-9995-8860-B8DA-F6F80A7B2FB5}"/>
              </a:ext>
            </a:extLst>
          </p:cNvPr>
          <p:cNvSpPr txBox="1"/>
          <p:nvPr/>
        </p:nvSpPr>
        <p:spPr>
          <a:xfrm>
            <a:off x="1677878" y="4046006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9943CC7-CA42-E49F-F37E-B3C2FB71F96C}"/>
              </a:ext>
            </a:extLst>
          </p:cNvPr>
          <p:cNvSpPr txBox="1"/>
          <p:nvPr/>
        </p:nvSpPr>
        <p:spPr>
          <a:xfrm>
            <a:off x="2700415" y="4016998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2786D0E1-0D36-F321-F07C-231F9E3B638F}"/>
              </a:ext>
            </a:extLst>
          </p:cNvPr>
          <p:cNvCxnSpPr>
            <a:cxnSpLocks/>
          </p:cNvCxnSpPr>
          <p:nvPr/>
        </p:nvCxnSpPr>
        <p:spPr>
          <a:xfrm>
            <a:off x="4553533" y="3893353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D1373202-63A2-848B-86E3-FA769E647111}"/>
              </a:ext>
            </a:extLst>
          </p:cNvPr>
          <p:cNvCxnSpPr>
            <a:cxnSpLocks/>
          </p:cNvCxnSpPr>
          <p:nvPr/>
        </p:nvCxnSpPr>
        <p:spPr>
          <a:xfrm>
            <a:off x="3702323" y="3884974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F2FB6215-4856-2448-B034-09C5150B1E59}"/>
              </a:ext>
            </a:extLst>
          </p:cNvPr>
          <p:cNvSpPr txBox="1"/>
          <p:nvPr/>
        </p:nvSpPr>
        <p:spPr>
          <a:xfrm>
            <a:off x="4626172" y="4043312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61304DA-4953-F177-3055-97E9592D3F62}"/>
              </a:ext>
            </a:extLst>
          </p:cNvPr>
          <p:cNvSpPr txBox="1"/>
          <p:nvPr/>
        </p:nvSpPr>
        <p:spPr>
          <a:xfrm>
            <a:off x="3648998" y="4016998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pic>
        <p:nvPicPr>
          <p:cNvPr id="18" name="Picture 17" descr="A close-up of a document&#10;&#10;Description automatically generated with medium confidence">
            <a:extLst>
              <a:ext uri="{FF2B5EF4-FFF2-40B4-BE49-F238E27FC236}">
                <a16:creationId xmlns:a16="http://schemas.microsoft.com/office/drawing/2014/main" id="{884B54F1-F525-A495-076A-F09A882AE2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5567" y="1931909"/>
            <a:ext cx="4649164" cy="3464083"/>
          </a:xfrm>
          <a:prstGeom prst="rect">
            <a:avLst/>
          </a:prstGeom>
        </p:spPr>
      </p:pic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4192CC4-BBF1-C1AE-E420-DAF804798671}"/>
              </a:ext>
            </a:extLst>
          </p:cNvPr>
          <p:cNvCxnSpPr>
            <a:cxnSpLocks/>
          </p:cNvCxnSpPr>
          <p:nvPr/>
        </p:nvCxnSpPr>
        <p:spPr>
          <a:xfrm flipH="1">
            <a:off x="11479535" y="3498742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14A7666F-4100-84B8-EB6A-9B88853C5579}"/>
              </a:ext>
            </a:extLst>
          </p:cNvPr>
          <p:cNvSpPr txBox="1"/>
          <p:nvPr/>
        </p:nvSpPr>
        <p:spPr>
          <a:xfrm>
            <a:off x="11429500" y="3592023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3 KD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A7D1AA8-09E2-343A-9519-2110CAE2B846}"/>
              </a:ext>
            </a:extLst>
          </p:cNvPr>
          <p:cNvCxnSpPr>
            <a:cxnSpLocks/>
          </p:cNvCxnSpPr>
          <p:nvPr/>
        </p:nvCxnSpPr>
        <p:spPr>
          <a:xfrm>
            <a:off x="9887533" y="4004557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67FE205-4320-5033-458E-89D333BC8B87}"/>
              </a:ext>
            </a:extLst>
          </p:cNvPr>
          <p:cNvCxnSpPr>
            <a:cxnSpLocks/>
          </p:cNvCxnSpPr>
          <p:nvPr/>
        </p:nvCxnSpPr>
        <p:spPr>
          <a:xfrm>
            <a:off x="9100149" y="4016998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7ECCAF5-C30E-E13C-48E7-E3458C76E77F}"/>
              </a:ext>
            </a:extLst>
          </p:cNvPr>
          <p:cNvCxnSpPr>
            <a:cxnSpLocks/>
          </p:cNvCxnSpPr>
          <p:nvPr/>
        </p:nvCxnSpPr>
        <p:spPr>
          <a:xfrm>
            <a:off x="8171944" y="4016998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B8C1E75-4400-15D0-E41C-AE6826255203}"/>
              </a:ext>
            </a:extLst>
          </p:cNvPr>
          <p:cNvCxnSpPr>
            <a:cxnSpLocks/>
          </p:cNvCxnSpPr>
          <p:nvPr/>
        </p:nvCxnSpPr>
        <p:spPr>
          <a:xfrm>
            <a:off x="7261898" y="4016998"/>
            <a:ext cx="68717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9E7A55D-D447-0CE7-44E7-F3F2247D936C}"/>
              </a:ext>
            </a:extLst>
          </p:cNvPr>
          <p:cNvSpPr txBox="1"/>
          <p:nvPr/>
        </p:nvSpPr>
        <p:spPr>
          <a:xfrm>
            <a:off x="9992669" y="4135729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D3E31B1-56CF-D812-FF62-AB26EDA5F1E3}"/>
              </a:ext>
            </a:extLst>
          </p:cNvPr>
          <p:cNvSpPr txBox="1"/>
          <p:nvPr/>
        </p:nvSpPr>
        <p:spPr>
          <a:xfrm>
            <a:off x="8255571" y="4155181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BA0CA19-01BD-0069-9431-670DE79A6631}"/>
              </a:ext>
            </a:extLst>
          </p:cNvPr>
          <p:cNvSpPr txBox="1"/>
          <p:nvPr/>
        </p:nvSpPr>
        <p:spPr>
          <a:xfrm>
            <a:off x="8914881" y="4155181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31BE9E1-9BC2-0A0C-6B50-83084222E19A}"/>
              </a:ext>
            </a:extLst>
          </p:cNvPr>
          <p:cNvSpPr txBox="1"/>
          <p:nvPr/>
        </p:nvSpPr>
        <p:spPr>
          <a:xfrm>
            <a:off x="7181878" y="4135728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</p:spTree>
    <p:extLst>
      <p:ext uri="{BB962C8B-B14F-4D97-AF65-F5344CB8AC3E}">
        <p14:creationId xmlns:p14="http://schemas.microsoft.com/office/powerpoint/2010/main" val="34652961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F43ACBE-7784-620B-7DE9-28F3500AA41B}"/>
              </a:ext>
            </a:extLst>
          </p:cNvPr>
          <p:cNvSpPr txBox="1"/>
          <p:nvPr/>
        </p:nvSpPr>
        <p:spPr>
          <a:xfrm>
            <a:off x="553820" y="173514"/>
            <a:ext cx="29468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.8B –Cleaved caspase-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7C46D-26B3-8966-23B4-73F80ABBF7EE}"/>
              </a:ext>
            </a:extLst>
          </p:cNvPr>
          <p:cNvSpPr txBox="1"/>
          <p:nvPr/>
        </p:nvSpPr>
        <p:spPr>
          <a:xfrm>
            <a:off x="6316399" y="1147395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5D03C4-8917-71CF-8B44-80EA7D788907}"/>
              </a:ext>
            </a:extLst>
          </p:cNvPr>
          <p:cNvSpPr txBox="1"/>
          <p:nvPr/>
        </p:nvSpPr>
        <p:spPr>
          <a:xfrm>
            <a:off x="1054495" y="2127838"/>
            <a:ext cx="469010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5338E7-FFA2-7C90-12F2-82E06A82E6FB}"/>
              </a:ext>
            </a:extLst>
          </p:cNvPr>
          <p:cNvSpPr txBox="1"/>
          <p:nvPr/>
        </p:nvSpPr>
        <p:spPr>
          <a:xfrm>
            <a:off x="542292" y="1747549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9078DA-C4F6-5441-4EE1-B814696B77EC}"/>
              </a:ext>
            </a:extLst>
          </p:cNvPr>
          <p:cNvSpPr txBox="1"/>
          <p:nvPr/>
        </p:nvSpPr>
        <p:spPr>
          <a:xfrm>
            <a:off x="6752959" y="2329229"/>
            <a:ext cx="357790" cy="27238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230C47-C344-7B52-BAB6-095DD2A66DC7}"/>
              </a:ext>
            </a:extLst>
          </p:cNvPr>
          <p:cNvSpPr txBox="1"/>
          <p:nvPr/>
        </p:nvSpPr>
        <p:spPr>
          <a:xfrm>
            <a:off x="865030" y="5619583"/>
            <a:ext cx="307134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: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ny:  Fisher Scientific</a:t>
            </a:r>
          </a:p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. #: BP3603500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A2CF221-E61B-773A-8D37-1E728A7C8930}"/>
              </a:ext>
            </a:extLst>
          </p:cNvPr>
          <p:cNvCxnSpPr>
            <a:cxnSpLocks/>
          </p:cNvCxnSpPr>
          <p:nvPr/>
        </p:nvCxnSpPr>
        <p:spPr>
          <a:xfrm flipH="1">
            <a:off x="10703363" y="3557720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4333F05-0680-18CF-504F-B8BD54E2D9E8}"/>
              </a:ext>
            </a:extLst>
          </p:cNvPr>
          <p:cNvSpPr txBox="1"/>
          <p:nvPr/>
        </p:nvSpPr>
        <p:spPr>
          <a:xfrm>
            <a:off x="10577736" y="3702291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43 KD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79FEEF68-1AB4-B520-7238-60C22415BADC}"/>
              </a:ext>
            </a:extLst>
          </p:cNvPr>
          <p:cNvCxnSpPr>
            <a:cxnSpLocks/>
          </p:cNvCxnSpPr>
          <p:nvPr/>
        </p:nvCxnSpPr>
        <p:spPr>
          <a:xfrm flipH="1">
            <a:off x="4685553" y="4344309"/>
            <a:ext cx="3085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E0D9DCDA-E2A3-72CC-0C0D-7A0B56C7EC3E}"/>
              </a:ext>
            </a:extLst>
          </p:cNvPr>
          <p:cNvSpPr txBox="1"/>
          <p:nvPr/>
        </p:nvSpPr>
        <p:spPr>
          <a:xfrm>
            <a:off x="4635518" y="443759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20 KD</a:t>
            </a:r>
          </a:p>
        </p:txBody>
      </p:sp>
      <p:pic>
        <p:nvPicPr>
          <p:cNvPr id="46" name="Picture 45" descr="A picture containing text&#10;&#10;Description automatically generated">
            <a:extLst>
              <a:ext uri="{FF2B5EF4-FFF2-40B4-BE49-F238E27FC236}">
                <a16:creationId xmlns:a16="http://schemas.microsoft.com/office/drawing/2014/main" id="{9A0AD859-7DFF-4D53-0E7A-091CC762BE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3396" y="2024548"/>
            <a:ext cx="3070706" cy="3305682"/>
          </a:xfrm>
          <a:prstGeom prst="rect">
            <a:avLst/>
          </a:prstGeom>
        </p:spPr>
      </p:pic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6AAF21C2-DB84-E79A-5FBF-B2944B235F75}"/>
              </a:ext>
            </a:extLst>
          </p:cNvPr>
          <p:cNvCxnSpPr>
            <a:cxnSpLocks/>
          </p:cNvCxnSpPr>
          <p:nvPr/>
        </p:nvCxnSpPr>
        <p:spPr>
          <a:xfrm>
            <a:off x="1800958" y="4714589"/>
            <a:ext cx="12383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55502BE4-D4E9-9692-53F7-4B178EFA8810}"/>
              </a:ext>
            </a:extLst>
          </p:cNvPr>
          <p:cNvCxnSpPr>
            <a:cxnSpLocks/>
          </p:cNvCxnSpPr>
          <p:nvPr/>
        </p:nvCxnSpPr>
        <p:spPr>
          <a:xfrm>
            <a:off x="3216101" y="4713487"/>
            <a:ext cx="12383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C5474BBB-B642-974F-7098-C074D7A907C7}"/>
              </a:ext>
            </a:extLst>
          </p:cNvPr>
          <p:cNvSpPr txBox="1"/>
          <p:nvPr/>
        </p:nvSpPr>
        <p:spPr>
          <a:xfrm>
            <a:off x="3527032" y="4851660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9B1E2B1-97DE-1885-D127-999173D6E15D}"/>
              </a:ext>
            </a:extLst>
          </p:cNvPr>
          <p:cNvSpPr txBox="1"/>
          <p:nvPr/>
        </p:nvSpPr>
        <p:spPr>
          <a:xfrm>
            <a:off x="1964719" y="4883910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4BC7D9BD-9850-3C52-756D-ED4F3ABBE7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76257" y="1971261"/>
            <a:ext cx="3394738" cy="3509377"/>
          </a:xfrm>
          <a:prstGeom prst="rect">
            <a:avLst/>
          </a:prstGeom>
        </p:spPr>
      </p:pic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605B3DF5-453F-0585-B6E4-6068A665F42E}"/>
              </a:ext>
            </a:extLst>
          </p:cNvPr>
          <p:cNvCxnSpPr>
            <a:cxnSpLocks/>
          </p:cNvCxnSpPr>
          <p:nvPr/>
        </p:nvCxnSpPr>
        <p:spPr>
          <a:xfrm>
            <a:off x="7607026" y="3841077"/>
            <a:ext cx="12383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66CE3EC-8932-5EC3-56BD-7EF2190FCE23}"/>
              </a:ext>
            </a:extLst>
          </p:cNvPr>
          <p:cNvCxnSpPr>
            <a:cxnSpLocks/>
          </p:cNvCxnSpPr>
          <p:nvPr/>
        </p:nvCxnSpPr>
        <p:spPr>
          <a:xfrm>
            <a:off x="9101290" y="3841077"/>
            <a:ext cx="12383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BDDD0A9A-47FB-C705-055D-AAFEE3BCD0D6}"/>
              </a:ext>
            </a:extLst>
          </p:cNvPr>
          <p:cNvSpPr txBox="1"/>
          <p:nvPr/>
        </p:nvSpPr>
        <p:spPr>
          <a:xfrm>
            <a:off x="9397227" y="4063253"/>
            <a:ext cx="646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Vehicl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9898F49-F580-9F11-4B78-AD7EB8D2BF7B}"/>
              </a:ext>
            </a:extLst>
          </p:cNvPr>
          <p:cNvSpPr txBox="1"/>
          <p:nvPr/>
        </p:nvSpPr>
        <p:spPr>
          <a:xfrm>
            <a:off x="7769505" y="4075954"/>
            <a:ext cx="100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lantam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16D9B20-C76F-7B6C-C145-390A68337CC3}"/>
              </a:ext>
            </a:extLst>
          </p:cNvPr>
          <p:cNvSpPr txBox="1"/>
          <p:nvPr/>
        </p:nvSpPr>
        <p:spPr>
          <a:xfrm>
            <a:off x="6539811" y="1963463"/>
            <a:ext cx="728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Ladder</a:t>
            </a:r>
          </a:p>
        </p:txBody>
      </p:sp>
    </p:spTree>
    <p:extLst>
      <p:ext uri="{BB962C8B-B14F-4D97-AF65-F5344CB8AC3E}">
        <p14:creationId xmlns:p14="http://schemas.microsoft.com/office/powerpoint/2010/main" val="3109864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4</TotalTime>
  <Words>429</Words>
  <Application>Microsoft Office PowerPoint</Application>
  <PresentationFormat>Widescreen</PresentationFormat>
  <Paragraphs>413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UNY Upstate Medical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he Meng</dc:creator>
  <cp:lastModifiedBy>Qinghe Meng</cp:lastModifiedBy>
  <cp:revision>1</cp:revision>
  <dcterms:created xsi:type="dcterms:W3CDTF">2023-03-07T21:03:07Z</dcterms:created>
  <dcterms:modified xsi:type="dcterms:W3CDTF">2023-08-17T20:47:06Z</dcterms:modified>
</cp:coreProperties>
</file>